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</p:sldIdLst>
  <p:sldSz cx="6858000" cy="9906000" type="A4"/>
  <p:notesSz cx="6797675" cy="9928225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boray Katalin" initials="ZK" lastIdx="1" clrIdx="0">
    <p:extLst>
      <p:ext uri="{19B8F6BF-5375-455C-9EA6-DF929625EA0E}">
        <p15:presenceInfo xmlns:p15="http://schemas.microsoft.com/office/powerpoint/2012/main" userId="Zboray Katal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65" autoAdjust="0"/>
    <p:restoredTop sz="94660"/>
  </p:normalViewPr>
  <p:slideViewPr>
    <p:cSldViewPr snapToGrid="0">
      <p:cViewPr varScale="1">
        <p:scale>
          <a:sx n="77" d="100"/>
          <a:sy n="77" d="100"/>
        </p:scale>
        <p:origin x="3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Cikk\&#193;br&#225;k\w_Dox_wo_Do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0.xml"/><Relationship Id="rId1" Type="http://schemas.microsoft.com/office/2011/relationships/chartStyle" Target="style10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1.xlsx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Cikk\&#193;br&#225;k\w_Dox_wo_Dox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boray%20Katalin\Documents\eORR\Platereader\expresszio%20stabilitas.xlsm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baseline="0">
                <a:effectLst/>
              </a:rPr>
              <a:t>MIO</a:t>
            </a:r>
            <a:r>
              <a:rPr lang="hu-HU" sz="1400" b="0" i="0" baseline="0">
                <a:effectLst/>
              </a:rPr>
              <a:t>p+</a:t>
            </a:r>
            <a:r>
              <a:rPr lang="en-US" sz="1400" b="0" i="0" baseline="0">
                <a:effectLst/>
              </a:rPr>
              <a:t>DOGGB</a:t>
            </a:r>
            <a:endParaRPr lang="hu-HU" sz="1400">
              <a:effectLst/>
            </a:endParaRPr>
          </a:p>
        </c:rich>
      </c:tx>
      <c:layout>
        <c:manualLayout>
          <c:xMode val="edge"/>
          <c:yMode val="edge"/>
          <c:x val="0.1203662636537660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001511698382254E-2"/>
          <c:y val="3.2293981481481479E-2"/>
          <c:w val="0.83890396107216669"/>
          <c:h val="0.83367546296296291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accent6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C$108:$C$143</c:f>
              <c:numCache>
                <c:formatCode>General</c:formatCode>
                <c:ptCount val="36"/>
                <c:pt idx="0">
                  <c:v>67731</c:v>
                </c:pt>
                <c:pt idx="1">
                  <c:v>63967</c:v>
                </c:pt>
                <c:pt idx="2">
                  <c:v>65564</c:v>
                </c:pt>
                <c:pt idx="3">
                  <c:v>65191</c:v>
                </c:pt>
                <c:pt idx="4">
                  <c:v>66209</c:v>
                </c:pt>
                <c:pt idx="5">
                  <c:v>70145</c:v>
                </c:pt>
                <c:pt idx="6">
                  <c:v>100220</c:v>
                </c:pt>
                <c:pt idx="7">
                  <c:v>147539</c:v>
                </c:pt>
                <c:pt idx="8">
                  <c:v>183855</c:v>
                </c:pt>
                <c:pt idx="9">
                  <c:v>216939</c:v>
                </c:pt>
                <c:pt idx="10">
                  <c:v>240947</c:v>
                </c:pt>
                <c:pt idx="11">
                  <c:v>253380</c:v>
                </c:pt>
                <c:pt idx="12">
                  <c:v>286660</c:v>
                </c:pt>
                <c:pt idx="13">
                  <c:v>293008</c:v>
                </c:pt>
                <c:pt idx="14">
                  <c:v>299000</c:v>
                </c:pt>
                <c:pt idx="15">
                  <c:v>305840</c:v>
                </c:pt>
                <c:pt idx="16">
                  <c:v>317035</c:v>
                </c:pt>
                <c:pt idx="17">
                  <c:v>318182</c:v>
                </c:pt>
                <c:pt idx="18">
                  <c:v>317102</c:v>
                </c:pt>
                <c:pt idx="19">
                  <c:v>324943</c:v>
                </c:pt>
                <c:pt idx="20">
                  <c:v>333631</c:v>
                </c:pt>
                <c:pt idx="21">
                  <c:v>338363</c:v>
                </c:pt>
                <c:pt idx="22">
                  <c:v>329250</c:v>
                </c:pt>
                <c:pt idx="23">
                  <c:v>329316</c:v>
                </c:pt>
                <c:pt idx="24">
                  <c:v>331613</c:v>
                </c:pt>
                <c:pt idx="25">
                  <c:v>325319</c:v>
                </c:pt>
                <c:pt idx="26">
                  <c:v>325753</c:v>
                </c:pt>
                <c:pt idx="27">
                  <c:v>330402</c:v>
                </c:pt>
                <c:pt idx="28">
                  <c:v>329991</c:v>
                </c:pt>
                <c:pt idx="29">
                  <c:v>330332</c:v>
                </c:pt>
                <c:pt idx="30">
                  <c:v>333712</c:v>
                </c:pt>
                <c:pt idx="31">
                  <c:v>329771</c:v>
                </c:pt>
                <c:pt idx="32">
                  <c:v>332684</c:v>
                </c:pt>
                <c:pt idx="33">
                  <c:v>333804</c:v>
                </c:pt>
                <c:pt idx="34">
                  <c:v>326230</c:v>
                </c:pt>
                <c:pt idx="35">
                  <c:v>3353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7F0-40C3-86E6-77DA90A3B896}"/>
            </c:ext>
          </c:extLst>
        </c:ser>
        <c:ser>
          <c:idx val="1"/>
          <c:order val="1"/>
          <c:spPr>
            <a:ln w="19050" cap="rnd">
              <a:solidFill>
                <a:schemeClr val="accent6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D$108:$D$143</c:f>
              <c:numCache>
                <c:formatCode>General</c:formatCode>
                <c:ptCount val="36"/>
                <c:pt idx="0">
                  <c:v>80547</c:v>
                </c:pt>
                <c:pt idx="1">
                  <c:v>80636</c:v>
                </c:pt>
                <c:pt idx="2">
                  <c:v>77514</c:v>
                </c:pt>
                <c:pt idx="3">
                  <c:v>80902</c:v>
                </c:pt>
                <c:pt idx="4">
                  <c:v>79291</c:v>
                </c:pt>
                <c:pt idx="5">
                  <c:v>84041</c:v>
                </c:pt>
                <c:pt idx="6">
                  <c:v>111273</c:v>
                </c:pt>
                <c:pt idx="7">
                  <c:v>149931</c:v>
                </c:pt>
                <c:pt idx="8">
                  <c:v>193036</c:v>
                </c:pt>
                <c:pt idx="9">
                  <c:v>217644</c:v>
                </c:pt>
                <c:pt idx="10">
                  <c:v>244302</c:v>
                </c:pt>
                <c:pt idx="11">
                  <c:v>267473</c:v>
                </c:pt>
                <c:pt idx="12">
                  <c:v>287473</c:v>
                </c:pt>
                <c:pt idx="13">
                  <c:v>303364</c:v>
                </c:pt>
                <c:pt idx="14">
                  <c:v>315093</c:v>
                </c:pt>
                <c:pt idx="15">
                  <c:v>324981</c:v>
                </c:pt>
                <c:pt idx="16">
                  <c:v>326632</c:v>
                </c:pt>
                <c:pt idx="17">
                  <c:v>329260</c:v>
                </c:pt>
                <c:pt idx="18">
                  <c:v>335651</c:v>
                </c:pt>
                <c:pt idx="19">
                  <c:v>340278</c:v>
                </c:pt>
                <c:pt idx="20">
                  <c:v>335983</c:v>
                </c:pt>
                <c:pt idx="21">
                  <c:v>345483</c:v>
                </c:pt>
                <c:pt idx="22">
                  <c:v>345167</c:v>
                </c:pt>
                <c:pt idx="23">
                  <c:v>351052</c:v>
                </c:pt>
                <c:pt idx="24">
                  <c:v>344723</c:v>
                </c:pt>
                <c:pt idx="25">
                  <c:v>347558</c:v>
                </c:pt>
                <c:pt idx="26">
                  <c:v>343975</c:v>
                </c:pt>
                <c:pt idx="27">
                  <c:v>347861</c:v>
                </c:pt>
                <c:pt idx="28">
                  <c:v>348205</c:v>
                </c:pt>
                <c:pt idx="29">
                  <c:v>354570</c:v>
                </c:pt>
                <c:pt idx="30">
                  <c:v>354091</c:v>
                </c:pt>
                <c:pt idx="31">
                  <c:v>351471</c:v>
                </c:pt>
                <c:pt idx="32">
                  <c:v>354000</c:v>
                </c:pt>
                <c:pt idx="33">
                  <c:v>350307</c:v>
                </c:pt>
                <c:pt idx="34">
                  <c:v>349395</c:v>
                </c:pt>
                <c:pt idx="35">
                  <c:v>33993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7F0-40C3-86E6-77DA90A3B896}"/>
            </c:ext>
          </c:extLst>
        </c:ser>
        <c:ser>
          <c:idx val="2"/>
          <c:order val="2"/>
          <c:spPr>
            <a:ln w="19050" cap="rnd">
              <a:solidFill>
                <a:schemeClr val="accent6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E$108:$E$143</c:f>
              <c:numCache>
                <c:formatCode>General</c:formatCode>
                <c:ptCount val="36"/>
                <c:pt idx="0">
                  <c:v>61653</c:v>
                </c:pt>
                <c:pt idx="1">
                  <c:v>64720</c:v>
                </c:pt>
                <c:pt idx="2">
                  <c:v>65865</c:v>
                </c:pt>
                <c:pt idx="3">
                  <c:v>66383</c:v>
                </c:pt>
                <c:pt idx="4">
                  <c:v>65465</c:v>
                </c:pt>
                <c:pt idx="5">
                  <c:v>68712</c:v>
                </c:pt>
                <c:pt idx="6">
                  <c:v>97654</c:v>
                </c:pt>
                <c:pt idx="7">
                  <c:v>131326</c:v>
                </c:pt>
                <c:pt idx="8">
                  <c:v>167799</c:v>
                </c:pt>
                <c:pt idx="9">
                  <c:v>197360</c:v>
                </c:pt>
                <c:pt idx="10">
                  <c:v>223843</c:v>
                </c:pt>
                <c:pt idx="11">
                  <c:v>246158</c:v>
                </c:pt>
                <c:pt idx="12">
                  <c:v>260473</c:v>
                </c:pt>
                <c:pt idx="13">
                  <c:v>268820</c:v>
                </c:pt>
                <c:pt idx="14">
                  <c:v>284163</c:v>
                </c:pt>
                <c:pt idx="15">
                  <c:v>285549</c:v>
                </c:pt>
                <c:pt idx="16">
                  <c:v>295467</c:v>
                </c:pt>
                <c:pt idx="17">
                  <c:v>301921</c:v>
                </c:pt>
                <c:pt idx="18">
                  <c:v>301706</c:v>
                </c:pt>
                <c:pt idx="19">
                  <c:v>308969</c:v>
                </c:pt>
                <c:pt idx="20">
                  <c:v>310209</c:v>
                </c:pt>
                <c:pt idx="21">
                  <c:v>315433</c:v>
                </c:pt>
                <c:pt idx="22">
                  <c:v>317680</c:v>
                </c:pt>
                <c:pt idx="23">
                  <c:v>310943</c:v>
                </c:pt>
                <c:pt idx="24">
                  <c:v>314243</c:v>
                </c:pt>
                <c:pt idx="25">
                  <c:v>316373</c:v>
                </c:pt>
                <c:pt idx="26">
                  <c:v>318662</c:v>
                </c:pt>
                <c:pt idx="27">
                  <c:v>320029</c:v>
                </c:pt>
                <c:pt idx="28">
                  <c:v>315908</c:v>
                </c:pt>
                <c:pt idx="29">
                  <c:v>314351</c:v>
                </c:pt>
                <c:pt idx="30">
                  <c:v>311652</c:v>
                </c:pt>
                <c:pt idx="31">
                  <c:v>314089</c:v>
                </c:pt>
                <c:pt idx="32">
                  <c:v>323814</c:v>
                </c:pt>
                <c:pt idx="33">
                  <c:v>320953</c:v>
                </c:pt>
                <c:pt idx="34">
                  <c:v>321424</c:v>
                </c:pt>
                <c:pt idx="35">
                  <c:v>32304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7F0-40C3-86E6-77DA90A3B896}"/>
            </c:ext>
          </c:extLst>
        </c:ser>
        <c:ser>
          <c:idx val="3"/>
          <c:order val="3"/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F$108:$F$143</c:f>
              <c:numCache>
                <c:formatCode>General</c:formatCode>
                <c:ptCount val="36"/>
                <c:pt idx="0">
                  <c:v>53035</c:v>
                </c:pt>
                <c:pt idx="1">
                  <c:v>50755</c:v>
                </c:pt>
                <c:pt idx="2">
                  <c:v>51371</c:v>
                </c:pt>
                <c:pt idx="3">
                  <c:v>52111</c:v>
                </c:pt>
                <c:pt idx="4">
                  <c:v>53455</c:v>
                </c:pt>
                <c:pt idx="5">
                  <c:v>65260</c:v>
                </c:pt>
                <c:pt idx="6">
                  <c:v>88646</c:v>
                </c:pt>
                <c:pt idx="7">
                  <c:v>95778</c:v>
                </c:pt>
                <c:pt idx="8">
                  <c:v>114687</c:v>
                </c:pt>
                <c:pt idx="9">
                  <c:v>130382</c:v>
                </c:pt>
                <c:pt idx="10">
                  <c:v>135599</c:v>
                </c:pt>
                <c:pt idx="11">
                  <c:v>144502</c:v>
                </c:pt>
                <c:pt idx="12">
                  <c:v>157454</c:v>
                </c:pt>
                <c:pt idx="13">
                  <c:v>163372</c:v>
                </c:pt>
                <c:pt idx="14">
                  <c:v>169229</c:v>
                </c:pt>
                <c:pt idx="15">
                  <c:v>174231</c:v>
                </c:pt>
                <c:pt idx="16">
                  <c:v>178095</c:v>
                </c:pt>
                <c:pt idx="17">
                  <c:v>180484</c:v>
                </c:pt>
                <c:pt idx="18">
                  <c:v>185946</c:v>
                </c:pt>
                <c:pt idx="19">
                  <c:v>184344</c:v>
                </c:pt>
                <c:pt idx="20">
                  <c:v>190323</c:v>
                </c:pt>
                <c:pt idx="21">
                  <c:v>187215</c:v>
                </c:pt>
                <c:pt idx="22">
                  <c:v>187703</c:v>
                </c:pt>
                <c:pt idx="23">
                  <c:v>185494</c:v>
                </c:pt>
                <c:pt idx="24">
                  <c:v>186638</c:v>
                </c:pt>
                <c:pt idx="25">
                  <c:v>182246</c:v>
                </c:pt>
                <c:pt idx="26">
                  <c:v>181760</c:v>
                </c:pt>
                <c:pt idx="27">
                  <c:v>184576</c:v>
                </c:pt>
                <c:pt idx="28">
                  <c:v>186235</c:v>
                </c:pt>
                <c:pt idx="29">
                  <c:v>184797</c:v>
                </c:pt>
                <c:pt idx="30">
                  <c:v>183618</c:v>
                </c:pt>
                <c:pt idx="31">
                  <c:v>182085</c:v>
                </c:pt>
                <c:pt idx="32">
                  <c:v>181229</c:v>
                </c:pt>
                <c:pt idx="33">
                  <c:v>179668</c:v>
                </c:pt>
                <c:pt idx="34">
                  <c:v>179331</c:v>
                </c:pt>
                <c:pt idx="35">
                  <c:v>18109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7F0-40C3-86E6-77DA90A3B896}"/>
            </c:ext>
          </c:extLst>
        </c:ser>
        <c:ser>
          <c:idx val="4"/>
          <c:order val="4"/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G$108:$G$143</c:f>
              <c:numCache>
                <c:formatCode>General</c:formatCode>
                <c:ptCount val="36"/>
                <c:pt idx="0">
                  <c:v>69007</c:v>
                </c:pt>
                <c:pt idx="1">
                  <c:v>65585</c:v>
                </c:pt>
                <c:pt idx="2">
                  <c:v>65491</c:v>
                </c:pt>
                <c:pt idx="3">
                  <c:v>64342</c:v>
                </c:pt>
                <c:pt idx="4">
                  <c:v>65994</c:v>
                </c:pt>
                <c:pt idx="5">
                  <c:v>57442</c:v>
                </c:pt>
                <c:pt idx="6">
                  <c:v>64077</c:v>
                </c:pt>
                <c:pt idx="7">
                  <c:v>82172</c:v>
                </c:pt>
                <c:pt idx="8">
                  <c:v>100271</c:v>
                </c:pt>
                <c:pt idx="9">
                  <c:v>115971</c:v>
                </c:pt>
                <c:pt idx="10">
                  <c:v>133249</c:v>
                </c:pt>
                <c:pt idx="11">
                  <c:v>141978</c:v>
                </c:pt>
                <c:pt idx="12">
                  <c:v>151025</c:v>
                </c:pt>
                <c:pt idx="13">
                  <c:v>149540</c:v>
                </c:pt>
                <c:pt idx="14">
                  <c:v>154025</c:v>
                </c:pt>
                <c:pt idx="15">
                  <c:v>158834</c:v>
                </c:pt>
                <c:pt idx="16">
                  <c:v>160411</c:v>
                </c:pt>
                <c:pt idx="17">
                  <c:v>156193</c:v>
                </c:pt>
                <c:pt idx="18">
                  <c:v>161492</c:v>
                </c:pt>
                <c:pt idx="19">
                  <c:v>161383</c:v>
                </c:pt>
                <c:pt idx="20">
                  <c:v>157759</c:v>
                </c:pt>
                <c:pt idx="21">
                  <c:v>159727</c:v>
                </c:pt>
                <c:pt idx="22">
                  <c:v>160079</c:v>
                </c:pt>
                <c:pt idx="23">
                  <c:v>161238</c:v>
                </c:pt>
                <c:pt idx="24">
                  <c:v>164171</c:v>
                </c:pt>
                <c:pt idx="25">
                  <c:v>159470</c:v>
                </c:pt>
                <c:pt idx="26">
                  <c:v>157249</c:v>
                </c:pt>
                <c:pt idx="27">
                  <c:v>158165</c:v>
                </c:pt>
                <c:pt idx="28">
                  <c:v>157605</c:v>
                </c:pt>
                <c:pt idx="29">
                  <c:v>156255</c:v>
                </c:pt>
                <c:pt idx="30">
                  <c:v>157741</c:v>
                </c:pt>
                <c:pt idx="31">
                  <c:v>161518</c:v>
                </c:pt>
                <c:pt idx="32">
                  <c:v>156123</c:v>
                </c:pt>
                <c:pt idx="33">
                  <c:v>155694</c:v>
                </c:pt>
                <c:pt idx="34">
                  <c:v>151909</c:v>
                </c:pt>
                <c:pt idx="35">
                  <c:v>15507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7F0-40C3-86E6-77DA90A3B896}"/>
            </c:ext>
          </c:extLst>
        </c:ser>
        <c:ser>
          <c:idx val="5"/>
          <c:order val="5"/>
          <c:spPr>
            <a:ln w="19050" cap="rnd">
              <a:solidFill>
                <a:schemeClr val="accent6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H$108:$H$143</c:f>
              <c:numCache>
                <c:formatCode>General</c:formatCode>
                <c:ptCount val="36"/>
                <c:pt idx="0">
                  <c:v>49383</c:v>
                </c:pt>
                <c:pt idx="1">
                  <c:v>45904</c:v>
                </c:pt>
                <c:pt idx="2">
                  <c:v>49562</c:v>
                </c:pt>
                <c:pt idx="3">
                  <c:v>47318</c:v>
                </c:pt>
                <c:pt idx="4">
                  <c:v>47230</c:v>
                </c:pt>
                <c:pt idx="5">
                  <c:v>45965</c:v>
                </c:pt>
                <c:pt idx="6">
                  <c:v>63786</c:v>
                </c:pt>
                <c:pt idx="7">
                  <c:v>74595</c:v>
                </c:pt>
                <c:pt idx="8">
                  <c:v>94162</c:v>
                </c:pt>
                <c:pt idx="9">
                  <c:v>113307</c:v>
                </c:pt>
                <c:pt idx="10">
                  <c:v>125665</c:v>
                </c:pt>
                <c:pt idx="11">
                  <c:v>134057</c:v>
                </c:pt>
                <c:pt idx="12">
                  <c:v>136539</c:v>
                </c:pt>
                <c:pt idx="13">
                  <c:v>137240</c:v>
                </c:pt>
                <c:pt idx="14">
                  <c:v>149359</c:v>
                </c:pt>
                <c:pt idx="15">
                  <c:v>152784</c:v>
                </c:pt>
                <c:pt idx="16">
                  <c:v>150067</c:v>
                </c:pt>
                <c:pt idx="17">
                  <c:v>152030</c:v>
                </c:pt>
                <c:pt idx="18">
                  <c:v>153768</c:v>
                </c:pt>
                <c:pt idx="19">
                  <c:v>154649</c:v>
                </c:pt>
                <c:pt idx="20">
                  <c:v>167522</c:v>
                </c:pt>
                <c:pt idx="21">
                  <c:v>161600</c:v>
                </c:pt>
                <c:pt idx="22">
                  <c:v>160363</c:v>
                </c:pt>
                <c:pt idx="23">
                  <c:v>161353</c:v>
                </c:pt>
                <c:pt idx="24">
                  <c:v>161058</c:v>
                </c:pt>
                <c:pt idx="25">
                  <c:v>165370</c:v>
                </c:pt>
                <c:pt idx="26">
                  <c:v>162108</c:v>
                </c:pt>
                <c:pt idx="27">
                  <c:v>165437</c:v>
                </c:pt>
                <c:pt idx="28">
                  <c:v>159801</c:v>
                </c:pt>
                <c:pt idx="29">
                  <c:v>161036</c:v>
                </c:pt>
                <c:pt idx="30">
                  <c:v>159181</c:v>
                </c:pt>
                <c:pt idx="31">
                  <c:v>160556</c:v>
                </c:pt>
                <c:pt idx="32">
                  <c:v>156314</c:v>
                </c:pt>
                <c:pt idx="33">
                  <c:v>155949</c:v>
                </c:pt>
                <c:pt idx="34">
                  <c:v>152002</c:v>
                </c:pt>
                <c:pt idx="35">
                  <c:v>1557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7F0-40C3-86E6-77DA90A3B896}"/>
            </c:ext>
          </c:extLst>
        </c:ser>
        <c:ser>
          <c:idx val="6"/>
          <c:order val="6"/>
          <c:spPr>
            <a:ln w="19050" cap="rnd">
              <a:solidFill>
                <a:srgbClr val="C0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I$108:$I$143</c:f>
              <c:numCache>
                <c:formatCode>General</c:formatCode>
                <c:ptCount val="36"/>
                <c:pt idx="0">
                  <c:v>56183</c:v>
                </c:pt>
                <c:pt idx="1">
                  <c:v>57710</c:v>
                </c:pt>
                <c:pt idx="2">
                  <c:v>57089</c:v>
                </c:pt>
                <c:pt idx="3">
                  <c:v>55348</c:v>
                </c:pt>
                <c:pt idx="4">
                  <c:v>56912</c:v>
                </c:pt>
                <c:pt idx="5">
                  <c:v>57107</c:v>
                </c:pt>
                <c:pt idx="6">
                  <c:v>64279</c:v>
                </c:pt>
                <c:pt idx="7">
                  <c:v>91142</c:v>
                </c:pt>
                <c:pt idx="8">
                  <c:v>114443</c:v>
                </c:pt>
                <c:pt idx="9">
                  <c:v>141730</c:v>
                </c:pt>
                <c:pt idx="10">
                  <c:v>161071</c:v>
                </c:pt>
                <c:pt idx="11">
                  <c:v>181878</c:v>
                </c:pt>
                <c:pt idx="12">
                  <c:v>193322</c:v>
                </c:pt>
                <c:pt idx="13">
                  <c:v>203096</c:v>
                </c:pt>
                <c:pt idx="14">
                  <c:v>215521</c:v>
                </c:pt>
                <c:pt idx="15">
                  <c:v>224882</c:v>
                </c:pt>
                <c:pt idx="16">
                  <c:v>223458</c:v>
                </c:pt>
                <c:pt idx="17">
                  <c:v>227523</c:v>
                </c:pt>
                <c:pt idx="18">
                  <c:v>240434</c:v>
                </c:pt>
                <c:pt idx="19">
                  <c:v>235923</c:v>
                </c:pt>
                <c:pt idx="20">
                  <c:v>233233</c:v>
                </c:pt>
                <c:pt idx="21">
                  <c:v>237474</c:v>
                </c:pt>
                <c:pt idx="22">
                  <c:v>239939</c:v>
                </c:pt>
                <c:pt idx="23">
                  <c:v>249456</c:v>
                </c:pt>
                <c:pt idx="24">
                  <c:v>242212</c:v>
                </c:pt>
                <c:pt idx="25">
                  <c:v>243581</c:v>
                </c:pt>
                <c:pt idx="26">
                  <c:v>245114</c:v>
                </c:pt>
                <c:pt idx="27">
                  <c:v>246645</c:v>
                </c:pt>
                <c:pt idx="28">
                  <c:v>248034</c:v>
                </c:pt>
                <c:pt idx="29">
                  <c:v>254051</c:v>
                </c:pt>
                <c:pt idx="30">
                  <c:v>247596</c:v>
                </c:pt>
                <c:pt idx="31">
                  <c:v>249258</c:v>
                </c:pt>
                <c:pt idx="32">
                  <c:v>251748</c:v>
                </c:pt>
                <c:pt idx="33">
                  <c:v>252972</c:v>
                </c:pt>
                <c:pt idx="34">
                  <c:v>252133</c:v>
                </c:pt>
                <c:pt idx="35">
                  <c:v>25128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7F0-40C3-86E6-77DA90A3B896}"/>
            </c:ext>
          </c:extLst>
        </c:ser>
        <c:ser>
          <c:idx val="7"/>
          <c:order val="7"/>
          <c:spPr>
            <a:ln w="19050" cap="rnd">
              <a:solidFill>
                <a:srgbClr val="C0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J$108:$J$143</c:f>
              <c:numCache>
                <c:formatCode>General</c:formatCode>
                <c:ptCount val="36"/>
                <c:pt idx="0">
                  <c:v>60529</c:v>
                </c:pt>
                <c:pt idx="1">
                  <c:v>60445</c:v>
                </c:pt>
                <c:pt idx="2">
                  <c:v>61313</c:v>
                </c:pt>
                <c:pt idx="3">
                  <c:v>57960</c:v>
                </c:pt>
                <c:pt idx="4">
                  <c:v>61488</c:v>
                </c:pt>
                <c:pt idx="5">
                  <c:v>60535</c:v>
                </c:pt>
                <c:pt idx="6">
                  <c:v>75222</c:v>
                </c:pt>
                <c:pt idx="7">
                  <c:v>103754</c:v>
                </c:pt>
                <c:pt idx="8">
                  <c:v>134196</c:v>
                </c:pt>
                <c:pt idx="9">
                  <c:v>161445</c:v>
                </c:pt>
                <c:pt idx="10">
                  <c:v>176821</c:v>
                </c:pt>
                <c:pt idx="11">
                  <c:v>192164</c:v>
                </c:pt>
                <c:pt idx="12">
                  <c:v>208832</c:v>
                </c:pt>
                <c:pt idx="13">
                  <c:v>212595</c:v>
                </c:pt>
                <c:pt idx="14">
                  <c:v>219770</c:v>
                </c:pt>
                <c:pt idx="15">
                  <c:v>233314</c:v>
                </c:pt>
                <c:pt idx="16">
                  <c:v>231706</c:v>
                </c:pt>
                <c:pt idx="17">
                  <c:v>238347</c:v>
                </c:pt>
                <c:pt idx="18">
                  <c:v>247941</c:v>
                </c:pt>
                <c:pt idx="19">
                  <c:v>253671</c:v>
                </c:pt>
                <c:pt idx="20">
                  <c:v>251494</c:v>
                </c:pt>
                <c:pt idx="21">
                  <c:v>247644</c:v>
                </c:pt>
                <c:pt idx="22">
                  <c:v>250712</c:v>
                </c:pt>
                <c:pt idx="23">
                  <c:v>259139</c:v>
                </c:pt>
                <c:pt idx="24">
                  <c:v>261135</c:v>
                </c:pt>
                <c:pt idx="25">
                  <c:v>249358</c:v>
                </c:pt>
                <c:pt idx="26">
                  <c:v>256913</c:v>
                </c:pt>
                <c:pt idx="27">
                  <c:v>258095</c:v>
                </c:pt>
                <c:pt idx="28">
                  <c:v>259787</c:v>
                </c:pt>
                <c:pt idx="29">
                  <c:v>256009</c:v>
                </c:pt>
                <c:pt idx="30">
                  <c:v>259063</c:v>
                </c:pt>
                <c:pt idx="31">
                  <c:v>253356</c:v>
                </c:pt>
                <c:pt idx="32">
                  <c:v>257310</c:v>
                </c:pt>
                <c:pt idx="33">
                  <c:v>255962</c:v>
                </c:pt>
                <c:pt idx="34">
                  <c:v>257626</c:v>
                </c:pt>
                <c:pt idx="35">
                  <c:v>2593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7F0-40C3-86E6-77DA90A3B896}"/>
            </c:ext>
          </c:extLst>
        </c:ser>
        <c:ser>
          <c:idx val="8"/>
          <c:order val="8"/>
          <c:spPr>
            <a:ln w="19050" cap="rnd">
              <a:solidFill>
                <a:srgbClr val="C0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K$108:$K$143</c:f>
              <c:numCache>
                <c:formatCode>General</c:formatCode>
                <c:ptCount val="36"/>
                <c:pt idx="0">
                  <c:v>57011</c:v>
                </c:pt>
                <c:pt idx="1">
                  <c:v>55937</c:v>
                </c:pt>
                <c:pt idx="2">
                  <c:v>56248</c:v>
                </c:pt>
                <c:pt idx="3">
                  <c:v>55989</c:v>
                </c:pt>
                <c:pt idx="4">
                  <c:v>57731</c:v>
                </c:pt>
                <c:pt idx="5">
                  <c:v>60265</c:v>
                </c:pt>
                <c:pt idx="6">
                  <c:v>77778</c:v>
                </c:pt>
                <c:pt idx="7">
                  <c:v>106324</c:v>
                </c:pt>
                <c:pt idx="8">
                  <c:v>131148</c:v>
                </c:pt>
                <c:pt idx="9">
                  <c:v>155055</c:v>
                </c:pt>
                <c:pt idx="10">
                  <c:v>187527</c:v>
                </c:pt>
                <c:pt idx="11">
                  <c:v>204796</c:v>
                </c:pt>
                <c:pt idx="12">
                  <c:v>217628</c:v>
                </c:pt>
                <c:pt idx="13">
                  <c:v>230045</c:v>
                </c:pt>
                <c:pt idx="14">
                  <c:v>233930</c:v>
                </c:pt>
                <c:pt idx="15">
                  <c:v>248127</c:v>
                </c:pt>
                <c:pt idx="16">
                  <c:v>248411</c:v>
                </c:pt>
                <c:pt idx="17">
                  <c:v>245109</c:v>
                </c:pt>
                <c:pt idx="18">
                  <c:v>256244</c:v>
                </c:pt>
                <c:pt idx="19">
                  <c:v>252530</c:v>
                </c:pt>
                <c:pt idx="20">
                  <c:v>265861</c:v>
                </c:pt>
                <c:pt idx="21">
                  <c:v>259174</c:v>
                </c:pt>
                <c:pt idx="22">
                  <c:v>261778</c:v>
                </c:pt>
                <c:pt idx="23">
                  <c:v>258351</c:v>
                </c:pt>
                <c:pt idx="24">
                  <c:v>261545</c:v>
                </c:pt>
                <c:pt idx="25">
                  <c:v>266057</c:v>
                </c:pt>
                <c:pt idx="26">
                  <c:v>261465</c:v>
                </c:pt>
                <c:pt idx="27">
                  <c:v>264974</c:v>
                </c:pt>
                <c:pt idx="28">
                  <c:v>263412</c:v>
                </c:pt>
                <c:pt idx="29">
                  <c:v>263710</c:v>
                </c:pt>
                <c:pt idx="30">
                  <c:v>262141</c:v>
                </c:pt>
                <c:pt idx="31">
                  <c:v>258376</c:v>
                </c:pt>
                <c:pt idx="32">
                  <c:v>263159</c:v>
                </c:pt>
                <c:pt idx="33">
                  <c:v>252457</c:v>
                </c:pt>
                <c:pt idx="34">
                  <c:v>258337</c:v>
                </c:pt>
                <c:pt idx="35">
                  <c:v>2606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77F0-40C3-86E6-77DA90A3B896}"/>
            </c:ext>
          </c:extLst>
        </c:ser>
        <c:ser>
          <c:idx val="9"/>
          <c:order val="9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L$108:$L$143</c:f>
              <c:numCache>
                <c:formatCode>General</c:formatCode>
                <c:ptCount val="36"/>
                <c:pt idx="0">
                  <c:v>39214</c:v>
                </c:pt>
                <c:pt idx="1">
                  <c:v>38328</c:v>
                </c:pt>
                <c:pt idx="2">
                  <c:v>36655</c:v>
                </c:pt>
                <c:pt idx="3">
                  <c:v>37881</c:v>
                </c:pt>
                <c:pt idx="4">
                  <c:v>40145</c:v>
                </c:pt>
                <c:pt idx="5">
                  <c:v>42407</c:v>
                </c:pt>
                <c:pt idx="6">
                  <c:v>50573</c:v>
                </c:pt>
                <c:pt idx="7">
                  <c:v>70759</c:v>
                </c:pt>
                <c:pt idx="8">
                  <c:v>88723</c:v>
                </c:pt>
                <c:pt idx="9">
                  <c:v>107865</c:v>
                </c:pt>
                <c:pt idx="10">
                  <c:v>110425</c:v>
                </c:pt>
                <c:pt idx="11">
                  <c:v>112433</c:v>
                </c:pt>
                <c:pt idx="12">
                  <c:v>119480</c:v>
                </c:pt>
                <c:pt idx="13">
                  <c:v>116379</c:v>
                </c:pt>
                <c:pt idx="14">
                  <c:v>117121</c:v>
                </c:pt>
                <c:pt idx="15">
                  <c:v>119962</c:v>
                </c:pt>
                <c:pt idx="16">
                  <c:v>119119</c:v>
                </c:pt>
                <c:pt idx="17">
                  <c:v>124073</c:v>
                </c:pt>
                <c:pt idx="18">
                  <c:v>128164</c:v>
                </c:pt>
                <c:pt idx="19">
                  <c:v>125976</c:v>
                </c:pt>
                <c:pt idx="20">
                  <c:v>129445</c:v>
                </c:pt>
                <c:pt idx="21">
                  <c:v>127071</c:v>
                </c:pt>
                <c:pt idx="22">
                  <c:v>128216</c:v>
                </c:pt>
                <c:pt idx="23">
                  <c:v>124188</c:v>
                </c:pt>
                <c:pt idx="24">
                  <c:v>123877</c:v>
                </c:pt>
                <c:pt idx="25">
                  <c:v>126050</c:v>
                </c:pt>
                <c:pt idx="26">
                  <c:v>126997</c:v>
                </c:pt>
                <c:pt idx="27">
                  <c:v>122243</c:v>
                </c:pt>
                <c:pt idx="28">
                  <c:v>121078</c:v>
                </c:pt>
                <c:pt idx="29">
                  <c:v>118444</c:v>
                </c:pt>
                <c:pt idx="30">
                  <c:v>125039</c:v>
                </c:pt>
                <c:pt idx="31">
                  <c:v>123228</c:v>
                </c:pt>
                <c:pt idx="32">
                  <c:v>123147</c:v>
                </c:pt>
                <c:pt idx="33">
                  <c:v>121993</c:v>
                </c:pt>
                <c:pt idx="34">
                  <c:v>122799</c:v>
                </c:pt>
                <c:pt idx="35">
                  <c:v>11867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77F0-40C3-86E6-77DA90A3B896}"/>
            </c:ext>
          </c:extLst>
        </c:ser>
        <c:ser>
          <c:idx val="10"/>
          <c:order val="10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M$108:$M$143</c:f>
              <c:numCache>
                <c:formatCode>General</c:formatCode>
                <c:ptCount val="36"/>
                <c:pt idx="0">
                  <c:v>40080</c:v>
                </c:pt>
                <c:pt idx="1">
                  <c:v>38228</c:v>
                </c:pt>
                <c:pt idx="2">
                  <c:v>41413</c:v>
                </c:pt>
                <c:pt idx="3">
                  <c:v>38756</c:v>
                </c:pt>
                <c:pt idx="4">
                  <c:v>37755</c:v>
                </c:pt>
                <c:pt idx="5">
                  <c:v>42041</c:v>
                </c:pt>
                <c:pt idx="6">
                  <c:v>51164</c:v>
                </c:pt>
                <c:pt idx="7">
                  <c:v>71816</c:v>
                </c:pt>
                <c:pt idx="8">
                  <c:v>86710</c:v>
                </c:pt>
                <c:pt idx="9">
                  <c:v>92683</c:v>
                </c:pt>
                <c:pt idx="10">
                  <c:v>94248</c:v>
                </c:pt>
                <c:pt idx="11">
                  <c:v>100955</c:v>
                </c:pt>
                <c:pt idx="12">
                  <c:v>101208</c:v>
                </c:pt>
                <c:pt idx="13">
                  <c:v>105180</c:v>
                </c:pt>
                <c:pt idx="14">
                  <c:v>97753</c:v>
                </c:pt>
                <c:pt idx="15">
                  <c:v>100269</c:v>
                </c:pt>
                <c:pt idx="16">
                  <c:v>101309</c:v>
                </c:pt>
                <c:pt idx="17">
                  <c:v>100816</c:v>
                </c:pt>
                <c:pt idx="18">
                  <c:v>102730</c:v>
                </c:pt>
                <c:pt idx="19">
                  <c:v>98205</c:v>
                </c:pt>
                <c:pt idx="20">
                  <c:v>101967</c:v>
                </c:pt>
                <c:pt idx="21">
                  <c:v>100713</c:v>
                </c:pt>
                <c:pt idx="22">
                  <c:v>96481</c:v>
                </c:pt>
                <c:pt idx="23">
                  <c:v>95879</c:v>
                </c:pt>
                <c:pt idx="24">
                  <c:v>106041</c:v>
                </c:pt>
                <c:pt idx="25">
                  <c:v>102008</c:v>
                </c:pt>
                <c:pt idx="26">
                  <c:v>102544</c:v>
                </c:pt>
                <c:pt idx="27">
                  <c:v>98091</c:v>
                </c:pt>
                <c:pt idx="28">
                  <c:v>101659</c:v>
                </c:pt>
                <c:pt idx="29">
                  <c:v>99237</c:v>
                </c:pt>
                <c:pt idx="30">
                  <c:v>98824</c:v>
                </c:pt>
                <c:pt idx="31">
                  <c:v>96771</c:v>
                </c:pt>
                <c:pt idx="32">
                  <c:v>98302</c:v>
                </c:pt>
                <c:pt idx="33">
                  <c:v>101245</c:v>
                </c:pt>
                <c:pt idx="34">
                  <c:v>99511</c:v>
                </c:pt>
                <c:pt idx="35">
                  <c:v>9900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77F0-40C3-86E6-77DA90A3B896}"/>
            </c:ext>
          </c:extLst>
        </c:ser>
        <c:ser>
          <c:idx val="11"/>
          <c:order val="11"/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N$108:$N$143</c:f>
              <c:numCache>
                <c:formatCode>General</c:formatCode>
                <c:ptCount val="36"/>
                <c:pt idx="0">
                  <c:v>36798</c:v>
                </c:pt>
                <c:pt idx="1">
                  <c:v>38264</c:v>
                </c:pt>
                <c:pt idx="2">
                  <c:v>38210</c:v>
                </c:pt>
                <c:pt idx="3">
                  <c:v>35629</c:v>
                </c:pt>
                <c:pt idx="4">
                  <c:v>38003</c:v>
                </c:pt>
                <c:pt idx="5">
                  <c:v>35895</c:v>
                </c:pt>
                <c:pt idx="6">
                  <c:v>45088</c:v>
                </c:pt>
                <c:pt idx="7">
                  <c:v>65538</c:v>
                </c:pt>
                <c:pt idx="8">
                  <c:v>80564</c:v>
                </c:pt>
                <c:pt idx="9">
                  <c:v>89931</c:v>
                </c:pt>
                <c:pt idx="10">
                  <c:v>94629</c:v>
                </c:pt>
                <c:pt idx="11">
                  <c:v>98819</c:v>
                </c:pt>
                <c:pt idx="12">
                  <c:v>106211</c:v>
                </c:pt>
                <c:pt idx="13">
                  <c:v>106634</c:v>
                </c:pt>
                <c:pt idx="14">
                  <c:v>106111</c:v>
                </c:pt>
                <c:pt idx="15">
                  <c:v>103676</c:v>
                </c:pt>
                <c:pt idx="16">
                  <c:v>106296</c:v>
                </c:pt>
                <c:pt idx="17">
                  <c:v>102933</c:v>
                </c:pt>
                <c:pt idx="18">
                  <c:v>106821</c:v>
                </c:pt>
                <c:pt idx="19">
                  <c:v>107982</c:v>
                </c:pt>
                <c:pt idx="20">
                  <c:v>105018</c:v>
                </c:pt>
                <c:pt idx="21">
                  <c:v>110006</c:v>
                </c:pt>
                <c:pt idx="22">
                  <c:v>104981</c:v>
                </c:pt>
                <c:pt idx="23">
                  <c:v>108141</c:v>
                </c:pt>
                <c:pt idx="24">
                  <c:v>104934</c:v>
                </c:pt>
                <c:pt idx="25">
                  <c:v>103386</c:v>
                </c:pt>
                <c:pt idx="26">
                  <c:v>109584</c:v>
                </c:pt>
                <c:pt idx="27">
                  <c:v>105836</c:v>
                </c:pt>
                <c:pt idx="28">
                  <c:v>107252</c:v>
                </c:pt>
                <c:pt idx="29">
                  <c:v>105425</c:v>
                </c:pt>
                <c:pt idx="30">
                  <c:v>106491</c:v>
                </c:pt>
                <c:pt idx="31">
                  <c:v>107040</c:v>
                </c:pt>
                <c:pt idx="32">
                  <c:v>105691</c:v>
                </c:pt>
                <c:pt idx="33">
                  <c:v>103862</c:v>
                </c:pt>
                <c:pt idx="34">
                  <c:v>104055</c:v>
                </c:pt>
                <c:pt idx="35">
                  <c:v>10402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77F0-40C3-86E6-77DA90A3B896}"/>
            </c:ext>
          </c:extLst>
        </c:ser>
        <c:ser>
          <c:idx val="12"/>
          <c:order val="12"/>
          <c:spPr>
            <a:ln w="19050" cap="rnd">
              <a:solidFill>
                <a:srgbClr val="00206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O$108:$O$143</c:f>
              <c:numCache>
                <c:formatCode>General</c:formatCode>
                <c:ptCount val="36"/>
                <c:pt idx="0">
                  <c:v>60264</c:v>
                </c:pt>
                <c:pt idx="1">
                  <c:v>60077</c:v>
                </c:pt>
                <c:pt idx="2">
                  <c:v>63131</c:v>
                </c:pt>
                <c:pt idx="3">
                  <c:v>61223</c:v>
                </c:pt>
                <c:pt idx="4">
                  <c:v>59757</c:v>
                </c:pt>
                <c:pt idx="5">
                  <c:v>64336</c:v>
                </c:pt>
                <c:pt idx="6">
                  <c:v>77195</c:v>
                </c:pt>
                <c:pt idx="7">
                  <c:v>90045</c:v>
                </c:pt>
                <c:pt idx="8">
                  <c:v>111859</c:v>
                </c:pt>
                <c:pt idx="9">
                  <c:v>123118</c:v>
                </c:pt>
                <c:pt idx="10">
                  <c:v>124967</c:v>
                </c:pt>
                <c:pt idx="11">
                  <c:v>125784</c:v>
                </c:pt>
                <c:pt idx="12">
                  <c:v>131677</c:v>
                </c:pt>
                <c:pt idx="13">
                  <c:v>130104</c:v>
                </c:pt>
                <c:pt idx="14">
                  <c:v>130628</c:v>
                </c:pt>
                <c:pt idx="15">
                  <c:v>136295</c:v>
                </c:pt>
                <c:pt idx="16">
                  <c:v>135931</c:v>
                </c:pt>
                <c:pt idx="17">
                  <c:v>140982</c:v>
                </c:pt>
                <c:pt idx="18">
                  <c:v>142521</c:v>
                </c:pt>
                <c:pt idx="19">
                  <c:v>137280</c:v>
                </c:pt>
                <c:pt idx="20">
                  <c:v>132736</c:v>
                </c:pt>
                <c:pt idx="21">
                  <c:v>139581</c:v>
                </c:pt>
                <c:pt idx="22">
                  <c:v>141686</c:v>
                </c:pt>
                <c:pt idx="23">
                  <c:v>140494</c:v>
                </c:pt>
                <c:pt idx="24">
                  <c:v>140773</c:v>
                </c:pt>
                <c:pt idx="25">
                  <c:v>136333</c:v>
                </c:pt>
                <c:pt idx="26">
                  <c:v>140757</c:v>
                </c:pt>
                <c:pt idx="27">
                  <c:v>133569</c:v>
                </c:pt>
                <c:pt idx="28">
                  <c:v>140412</c:v>
                </c:pt>
                <c:pt idx="29">
                  <c:v>141432</c:v>
                </c:pt>
                <c:pt idx="30">
                  <c:v>141819</c:v>
                </c:pt>
                <c:pt idx="31">
                  <c:v>140393</c:v>
                </c:pt>
                <c:pt idx="32">
                  <c:v>139926</c:v>
                </c:pt>
                <c:pt idx="33">
                  <c:v>144897</c:v>
                </c:pt>
                <c:pt idx="34">
                  <c:v>134931</c:v>
                </c:pt>
                <c:pt idx="35">
                  <c:v>13998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77F0-40C3-86E6-77DA90A3B896}"/>
            </c:ext>
          </c:extLst>
        </c:ser>
        <c:ser>
          <c:idx val="13"/>
          <c:order val="13"/>
          <c:spPr>
            <a:ln w="19050" cap="rnd">
              <a:solidFill>
                <a:srgbClr val="00206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P$108:$P$143</c:f>
              <c:numCache>
                <c:formatCode>General</c:formatCode>
                <c:ptCount val="36"/>
                <c:pt idx="0">
                  <c:v>57711</c:v>
                </c:pt>
                <c:pt idx="1">
                  <c:v>61470</c:v>
                </c:pt>
                <c:pt idx="2">
                  <c:v>60854</c:v>
                </c:pt>
                <c:pt idx="3">
                  <c:v>59164</c:v>
                </c:pt>
                <c:pt idx="4">
                  <c:v>63820</c:v>
                </c:pt>
                <c:pt idx="5">
                  <c:v>72657</c:v>
                </c:pt>
                <c:pt idx="6">
                  <c:v>91754</c:v>
                </c:pt>
                <c:pt idx="7">
                  <c:v>114914</c:v>
                </c:pt>
                <c:pt idx="8">
                  <c:v>129381</c:v>
                </c:pt>
                <c:pt idx="9">
                  <c:v>130823</c:v>
                </c:pt>
                <c:pt idx="10">
                  <c:v>136381</c:v>
                </c:pt>
                <c:pt idx="11">
                  <c:v>135315</c:v>
                </c:pt>
                <c:pt idx="12">
                  <c:v>149614</c:v>
                </c:pt>
                <c:pt idx="13">
                  <c:v>148254</c:v>
                </c:pt>
                <c:pt idx="14">
                  <c:v>150517</c:v>
                </c:pt>
                <c:pt idx="15">
                  <c:v>150538</c:v>
                </c:pt>
                <c:pt idx="16">
                  <c:v>152956</c:v>
                </c:pt>
                <c:pt idx="17">
                  <c:v>153525</c:v>
                </c:pt>
                <c:pt idx="18">
                  <c:v>160251</c:v>
                </c:pt>
                <c:pt idx="19">
                  <c:v>157386</c:v>
                </c:pt>
                <c:pt idx="20">
                  <c:v>158535</c:v>
                </c:pt>
                <c:pt idx="21">
                  <c:v>158600</c:v>
                </c:pt>
                <c:pt idx="22">
                  <c:v>155316</c:v>
                </c:pt>
                <c:pt idx="23">
                  <c:v>152210</c:v>
                </c:pt>
                <c:pt idx="24">
                  <c:v>154212</c:v>
                </c:pt>
                <c:pt idx="25">
                  <c:v>154224</c:v>
                </c:pt>
                <c:pt idx="26">
                  <c:v>156627</c:v>
                </c:pt>
                <c:pt idx="27">
                  <c:v>159397</c:v>
                </c:pt>
                <c:pt idx="28">
                  <c:v>156993</c:v>
                </c:pt>
                <c:pt idx="29">
                  <c:v>158144</c:v>
                </c:pt>
                <c:pt idx="30">
                  <c:v>154196</c:v>
                </c:pt>
                <c:pt idx="31">
                  <c:v>154855</c:v>
                </c:pt>
                <c:pt idx="32">
                  <c:v>156440</c:v>
                </c:pt>
                <c:pt idx="33">
                  <c:v>160242</c:v>
                </c:pt>
                <c:pt idx="34">
                  <c:v>155308</c:v>
                </c:pt>
                <c:pt idx="35">
                  <c:v>15637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77F0-40C3-86E6-77DA90A3B896}"/>
            </c:ext>
          </c:extLst>
        </c:ser>
        <c:ser>
          <c:idx val="14"/>
          <c:order val="14"/>
          <c:spPr>
            <a:ln w="19050" cap="rnd">
              <a:solidFill>
                <a:srgbClr val="00206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Q$108:$Q$143</c:f>
              <c:numCache>
                <c:formatCode>General</c:formatCode>
                <c:ptCount val="36"/>
                <c:pt idx="0">
                  <c:v>76930</c:v>
                </c:pt>
                <c:pt idx="1">
                  <c:v>80411</c:v>
                </c:pt>
                <c:pt idx="2">
                  <c:v>77804</c:v>
                </c:pt>
                <c:pt idx="3">
                  <c:v>71982</c:v>
                </c:pt>
                <c:pt idx="4">
                  <c:v>76946</c:v>
                </c:pt>
                <c:pt idx="5">
                  <c:v>92162</c:v>
                </c:pt>
                <c:pt idx="6">
                  <c:v>100930</c:v>
                </c:pt>
                <c:pt idx="7">
                  <c:v>123346</c:v>
                </c:pt>
                <c:pt idx="8">
                  <c:v>139479</c:v>
                </c:pt>
                <c:pt idx="9">
                  <c:v>144118</c:v>
                </c:pt>
                <c:pt idx="10">
                  <c:v>147701</c:v>
                </c:pt>
                <c:pt idx="11">
                  <c:v>149934</c:v>
                </c:pt>
                <c:pt idx="12">
                  <c:v>158902</c:v>
                </c:pt>
                <c:pt idx="13">
                  <c:v>156134</c:v>
                </c:pt>
                <c:pt idx="14">
                  <c:v>158971</c:v>
                </c:pt>
                <c:pt idx="15">
                  <c:v>161055</c:v>
                </c:pt>
                <c:pt idx="16">
                  <c:v>158660</c:v>
                </c:pt>
                <c:pt idx="17">
                  <c:v>164653</c:v>
                </c:pt>
                <c:pt idx="18">
                  <c:v>161898</c:v>
                </c:pt>
                <c:pt idx="19">
                  <c:v>157292</c:v>
                </c:pt>
                <c:pt idx="20">
                  <c:v>163759</c:v>
                </c:pt>
                <c:pt idx="21">
                  <c:v>160971</c:v>
                </c:pt>
                <c:pt idx="22">
                  <c:v>167243</c:v>
                </c:pt>
                <c:pt idx="23">
                  <c:v>166084</c:v>
                </c:pt>
                <c:pt idx="24">
                  <c:v>163551</c:v>
                </c:pt>
                <c:pt idx="25">
                  <c:v>165072</c:v>
                </c:pt>
                <c:pt idx="26">
                  <c:v>169627</c:v>
                </c:pt>
                <c:pt idx="27">
                  <c:v>159570</c:v>
                </c:pt>
                <c:pt idx="28">
                  <c:v>163790</c:v>
                </c:pt>
                <c:pt idx="29">
                  <c:v>167024</c:v>
                </c:pt>
                <c:pt idx="30">
                  <c:v>161201</c:v>
                </c:pt>
                <c:pt idx="31">
                  <c:v>165359</c:v>
                </c:pt>
                <c:pt idx="32">
                  <c:v>165178</c:v>
                </c:pt>
                <c:pt idx="33">
                  <c:v>161877</c:v>
                </c:pt>
                <c:pt idx="34">
                  <c:v>167886</c:v>
                </c:pt>
                <c:pt idx="35">
                  <c:v>16298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77F0-40C3-86E6-77DA90A3B896}"/>
            </c:ext>
          </c:extLst>
        </c:ser>
        <c:ser>
          <c:idx val="15"/>
          <c:order val="15"/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R$108:$R$143</c:f>
              <c:numCache>
                <c:formatCode>General</c:formatCode>
                <c:ptCount val="36"/>
                <c:pt idx="0">
                  <c:v>38598</c:v>
                </c:pt>
                <c:pt idx="1">
                  <c:v>36988</c:v>
                </c:pt>
                <c:pt idx="2">
                  <c:v>38237</c:v>
                </c:pt>
                <c:pt idx="3">
                  <c:v>37462</c:v>
                </c:pt>
                <c:pt idx="4">
                  <c:v>37897</c:v>
                </c:pt>
                <c:pt idx="5">
                  <c:v>43564</c:v>
                </c:pt>
                <c:pt idx="6">
                  <c:v>40563</c:v>
                </c:pt>
                <c:pt idx="7">
                  <c:v>41005</c:v>
                </c:pt>
                <c:pt idx="8">
                  <c:v>46512</c:v>
                </c:pt>
                <c:pt idx="9">
                  <c:v>43502</c:v>
                </c:pt>
                <c:pt idx="10">
                  <c:v>43161</c:v>
                </c:pt>
                <c:pt idx="11">
                  <c:v>41202</c:v>
                </c:pt>
                <c:pt idx="12">
                  <c:v>44482</c:v>
                </c:pt>
                <c:pt idx="13">
                  <c:v>44159</c:v>
                </c:pt>
                <c:pt idx="14">
                  <c:v>42936</c:v>
                </c:pt>
                <c:pt idx="15">
                  <c:v>43429</c:v>
                </c:pt>
                <c:pt idx="16">
                  <c:v>44899</c:v>
                </c:pt>
                <c:pt idx="17">
                  <c:v>43002</c:v>
                </c:pt>
                <c:pt idx="18">
                  <c:v>42798</c:v>
                </c:pt>
                <c:pt idx="19">
                  <c:v>44625</c:v>
                </c:pt>
                <c:pt idx="20">
                  <c:v>43806</c:v>
                </c:pt>
                <c:pt idx="21">
                  <c:v>42219</c:v>
                </c:pt>
                <c:pt idx="22">
                  <c:v>41536</c:v>
                </c:pt>
                <c:pt idx="23">
                  <c:v>43150</c:v>
                </c:pt>
                <c:pt idx="24">
                  <c:v>43206</c:v>
                </c:pt>
                <c:pt idx="25">
                  <c:v>43831</c:v>
                </c:pt>
                <c:pt idx="26">
                  <c:v>42112</c:v>
                </c:pt>
                <c:pt idx="27">
                  <c:v>46378</c:v>
                </c:pt>
                <c:pt idx="28">
                  <c:v>43137</c:v>
                </c:pt>
                <c:pt idx="29">
                  <c:v>42706</c:v>
                </c:pt>
                <c:pt idx="30">
                  <c:v>45075</c:v>
                </c:pt>
                <c:pt idx="31">
                  <c:v>44302</c:v>
                </c:pt>
                <c:pt idx="32">
                  <c:v>42316</c:v>
                </c:pt>
                <c:pt idx="33">
                  <c:v>46651</c:v>
                </c:pt>
                <c:pt idx="34">
                  <c:v>45863</c:v>
                </c:pt>
                <c:pt idx="35">
                  <c:v>4330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77F0-40C3-86E6-77DA90A3B896}"/>
            </c:ext>
          </c:extLst>
        </c:ser>
        <c:ser>
          <c:idx val="16"/>
          <c:order val="16"/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S$108:$S$143</c:f>
              <c:numCache>
                <c:formatCode>General</c:formatCode>
                <c:ptCount val="36"/>
                <c:pt idx="0">
                  <c:v>50145</c:v>
                </c:pt>
                <c:pt idx="1">
                  <c:v>47600</c:v>
                </c:pt>
                <c:pt idx="2">
                  <c:v>47636</c:v>
                </c:pt>
                <c:pt idx="3">
                  <c:v>49993</c:v>
                </c:pt>
                <c:pt idx="4">
                  <c:v>48318</c:v>
                </c:pt>
                <c:pt idx="5">
                  <c:v>52709</c:v>
                </c:pt>
                <c:pt idx="6">
                  <c:v>58506</c:v>
                </c:pt>
                <c:pt idx="7">
                  <c:v>69520</c:v>
                </c:pt>
                <c:pt idx="8">
                  <c:v>76299</c:v>
                </c:pt>
                <c:pt idx="9">
                  <c:v>83577</c:v>
                </c:pt>
                <c:pt idx="10">
                  <c:v>87783</c:v>
                </c:pt>
                <c:pt idx="11">
                  <c:v>85629</c:v>
                </c:pt>
                <c:pt idx="12">
                  <c:v>86731</c:v>
                </c:pt>
                <c:pt idx="13">
                  <c:v>86896</c:v>
                </c:pt>
                <c:pt idx="14">
                  <c:v>93079</c:v>
                </c:pt>
                <c:pt idx="15">
                  <c:v>90046</c:v>
                </c:pt>
                <c:pt idx="16">
                  <c:v>94495</c:v>
                </c:pt>
                <c:pt idx="17">
                  <c:v>88670</c:v>
                </c:pt>
                <c:pt idx="18">
                  <c:v>90471</c:v>
                </c:pt>
                <c:pt idx="19">
                  <c:v>88036</c:v>
                </c:pt>
                <c:pt idx="20">
                  <c:v>91951</c:v>
                </c:pt>
                <c:pt idx="21">
                  <c:v>88395</c:v>
                </c:pt>
                <c:pt idx="22">
                  <c:v>89960</c:v>
                </c:pt>
                <c:pt idx="23">
                  <c:v>91999</c:v>
                </c:pt>
                <c:pt idx="24">
                  <c:v>88846</c:v>
                </c:pt>
                <c:pt idx="25">
                  <c:v>89748</c:v>
                </c:pt>
                <c:pt idx="26">
                  <c:v>88999</c:v>
                </c:pt>
                <c:pt idx="27">
                  <c:v>87104</c:v>
                </c:pt>
                <c:pt idx="28">
                  <c:v>91034</c:v>
                </c:pt>
                <c:pt idx="29">
                  <c:v>85515</c:v>
                </c:pt>
                <c:pt idx="30">
                  <c:v>91802</c:v>
                </c:pt>
                <c:pt idx="31">
                  <c:v>88385</c:v>
                </c:pt>
                <c:pt idx="32">
                  <c:v>89260</c:v>
                </c:pt>
                <c:pt idx="33">
                  <c:v>85277</c:v>
                </c:pt>
                <c:pt idx="34">
                  <c:v>90270</c:v>
                </c:pt>
                <c:pt idx="35">
                  <c:v>9193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77F0-40C3-86E6-77DA90A3B896}"/>
            </c:ext>
          </c:extLst>
        </c:ser>
        <c:ser>
          <c:idx val="17"/>
          <c:order val="17"/>
          <c:spPr>
            <a:ln w="19050" cap="rnd">
              <a:solidFill>
                <a:srgbClr val="002060"/>
              </a:solidFill>
              <a:round/>
            </a:ln>
            <a:effectLst/>
          </c:spPr>
          <c:marker>
            <c:symbol val="none"/>
          </c:marker>
          <c:cat>
            <c:numRef>
              <c:f>'cikk SUM'!$B$108:$B$143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T$108:$T$143</c:f>
              <c:numCache>
                <c:formatCode>General</c:formatCode>
                <c:ptCount val="36"/>
                <c:pt idx="0">
                  <c:v>57470</c:v>
                </c:pt>
                <c:pt idx="1">
                  <c:v>58556</c:v>
                </c:pt>
                <c:pt idx="2">
                  <c:v>57922</c:v>
                </c:pt>
                <c:pt idx="3">
                  <c:v>57644</c:v>
                </c:pt>
                <c:pt idx="4">
                  <c:v>56692</c:v>
                </c:pt>
                <c:pt idx="5">
                  <c:v>57211</c:v>
                </c:pt>
                <c:pt idx="6">
                  <c:v>64760</c:v>
                </c:pt>
                <c:pt idx="7">
                  <c:v>75750</c:v>
                </c:pt>
                <c:pt idx="8">
                  <c:v>80874</c:v>
                </c:pt>
                <c:pt idx="9">
                  <c:v>82239</c:v>
                </c:pt>
                <c:pt idx="10">
                  <c:v>90202</c:v>
                </c:pt>
                <c:pt idx="11">
                  <c:v>90936</c:v>
                </c:pt>
                <c:pt idx="12">
                  <c:v>88017</c:v>
                </c:pt>
                <c:pt idx="13">
                  <c:v>89881</c:v>
                </c:pt>
                <c:pt idx="14">
                  <c:v>93046</c:v>
                </c:pt>
                <c:pt idx="15">
                  <c:v>93440</c:v>
                </c:pt>
                <c:pt idx="16">
                  <c:v>93841</c:v>
                </c:pt>
                <c:pt idx="17">
                  <c:v>91347</c:v>
                </c:pt>
                <c:pt idx="18">
                  <c:v>91555</c:v>
                </c:pt>
                <c:pt idx="19">
                  <c:v>92583</c:v>
                </c:pt>
                <c:pt idx="20">
                  <c:v>95853</c:v>
                </c:pt>
                <c:pt idx="21">
                  <c:v>91726</c:v>
                </c:pt>
                <c:pt idx="22">
                  <c:v>93438</c:v>
                </c:pt>
                <c:pt idx="23">
                  <c:v>93623</c:v>
                </c:pt>
                <c:pt idx="24">
                  <c:v>89080</c:v>
                </c:pt>
                <c:pt idx="25">
                  <c:v>93786</c:v>
                </c:pt>
                <c:pt idx="26">
                  <c:v>97452</c:v>
                </c:pt>
                <c:pt idx="27">
                  <c:v>94889</c:v>
                </c:pt>
                <c:pt idx="28">
                  <c:v>94089</c:v>
                </c:pt>
                <c:pt idx="29">
                  <c:v>94414</c:v>
                </c:pt>
                <c:pt idx="30">
                  <c:v>92523</c:v>
                </c:pt>
                <c:pt idx="31">
                  <c:v>93074</c:v>
                </c:pt>
                <c:pt idx="32">
                  <c:v>88755</c:v>
                </c:pt>
                <c:pt idx="33">
                  <c:v>93778</c:v>
                </c:pt>
                <c:pt idx="34">
                  <c:v>95432</c:v>
                </c:pt>
                <c:pt idx="35">
                  <c:v>9137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77F0-40C3-86E6-77DA90A3B8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690672"/>
        <c:axId val="190701008"/>
      </c:lineChart>
      <c:dateAx>
        <c:axId val="19069067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701008"/>
        <c:crosses val="autoZero"/>
        <c:auto val="0"/>
        <c:lblOffset val="100"/>
        <c:baseTimeUnit val="days"/>
        <c:majorUnit val="10"/>
        <c:majorTimeUnit val="days"/>
        <c:minorUnit val="5"/>
        <c:minorTimeUnit val="days"/>
      </c:dateAx>
      <c:valAx>
        <c:axId val="1907010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alpha val="94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690672"/>
        <c:crosses val="autoZero"/>
        <c:crossBetween val="midCat"/>
        <c:dispUnits>
          <c:builtInUnit val="tenThousands"/>
        </c:dispUnits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 dirty="0">
                <a:latin typeface="+mn-lt"/>
              </a:rPr>
              <a:t>Fluorescence</a:t>
            </a:r>
            <a:r>
              <a:rPr lang="hu-HU" baseline="0" dirty="0">
                <a:latin typeface="+mn-lt"/>
              </a:rPr>
              <a:t> cell response to 50</a:t>
            </a:r>
            <a:r>
              <a:rPr lang="el-GR" baseline="0" dirty="0">
                <a:latin typeface="+mn-lt"/>
                <a:cs typeface="Arial" panose="020B0604020202020204" pitchFamily="34" charset="0"/>
              </a:rPr>
              <a:t>μ</a:t>
            </a:r>
            <a:r>
              <a:rPr lang="hu-HU" baseline="0" dirty="0">
                <a:latin typeface="+mn-lt"/>
                <a:cs typeface="Arial" panose="020B0604020202020204" pitchFamily="34" charset="0"/>
              </a:rPr>
              <a:t>M VUAA1</a:t>
            </a:r>
            <a:endParaRPr lang="hu-HU" dirty="0">
              <a:latin typeface="+mn-lt"/>
            </a:endParaRPr>
          </a:p>
        </c:rich>
      </c:tx>
      <c:layout>
        <c:manualLayout>
          <c:xMode val="edge"/>
          <c:yMode val="edge"/>
          <c:x val="0.33128973830321484"/>
          <c:y val="6.0360468336067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001229288095169"/>
          <c:y val="0.14960737798754356"/>
          <c:w val="0.80130297084036295"/>
          <c:h val="0.63295755754579897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D$42:$D$77</c:f>
              <c:numCache>
                <c:formatCode>General</c:formatCode>
                <c:ptCount val="36"/>
                <c:pt idx="0">
                  <c:v>134834</c:v>
                </c:pt>
                <c:pt idx="1">
                  <c:v>133882</c:v>
                </c:pt>
                <c:pt idx="2">
                  <c:v>134267</c:v>
                </c:pt>
                <c:pt idx="3">
                  <c:v>137678</c:v>
                </c:pt>
                <c:pt idx="4">
                  <c:v>131234</c:v>
                </c:pt>
                <c:pt idx="5">
                  <c:v>174369</c:v>
                </c:pt>
                <c:pt idx="6">
                  <c:v>298978</c:v>
                </c:pt>
                <c:pt idx="7">
                  <c:v>359635</c:v>
                </c:pt>
                <c:pt idx="8">
                  <c:v>405516</c:v>
                </c:pt>
                <c:pt idx="9">
                  <c:v>420738</c:v>
                </c:pt>
                <c:pt idx="10">
                  <c:v>418457</c:v>
                </c:pt>
                <c:pt idx="11">
                  <c:v>409706</c:v>
                </c:pt>
                <c:pt idx="12">
                  <c:v>420066</c:v>
                </c:pt>
                <c:pt idx="13">
                  <c:v>413102</c:v>
                </c:pt>
                <c:pt idx="14">
                  <c:v>412856</c:v>
                </c:pt>
                <c:pt idx="15">
                  <c:v>413369</c:v>
                </c:pt>
                <c:pt idx="16">
                  <c:v>417280</c:v>
                </c:pt>
                <c:pt idx="17">
                  <c:v>422787</c:v>
                </c:pt>
                <c:pt idx="18">
                  <c:v>423908</c:v>
                </c:pt>
                <c:pt idx="19">
                  <c:v>432478</c:v>
                </c:pt>
                <c:pt idx="20">
                  <c:v>434920</c:v>
                </c:pt>
                <c:pt idx="21">
                  <c:v>440450</c:v>
                </c:pt>
                <c:pt idx="22">
                  <c:v>431132</c:v>
                </c:pt>
                <c:pt idx="23">
                  <c:v>428219</c:v>
                </c:pt>
                <c:pt idx="24">
                  <c:v>436045</c:v>
                </c:pt>
                <c:pt idx="25">
                  <c:v>432040</c:v>
                </c:pt>
                <c:pt idx="26">
                  <c:v>431868</c:v>
                </c:pt>
                <c:pt idx="27">
                  <c:v>419576</c:v>
                </c:pt>
                <c:pt idx="28">
                  <c:v>431988</c:v>
                </c:pt>
                <c:pt idx="29">
                  <c:v>432901</c:v>
                </c:pt>
                <c:pt idx="30">
                  <c:v>433592</c:v>
                </c:pt>
                <c:pt idx="31">
                  <c:v>431233</c:v>
                </c:pt>
                <c:pt idx="32">
                  <c:v>428314</c:v>
                </c:pt>
                <c:pt idx="33">
                  <c:v>429994</c:v>
                </c:pt>
                <c:pt idx="34">
                  <c:v>427371</c:v>
                </c:pt>
                <c:pt idx="35">
                  <c:v>4174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859C-4CDA-B307-A2E7EE1D40F8}"/>
            </c:ext>
          </c:extLst>
        </c:ser>
        <c:ser>
          <c:idx val="1"/>
          <c:order val="1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E$42:$E$77</c:f>
              <c:numCache>
                <c:formatCode>General</c:formatCode>
                <c:ptCount val="36"/>
                <c:pt idx="0">
                  <c:v>155766</c:v>
                </c:pt>
                <c:pt idx="1">
                  <c:v>148868</c:v>
                </c:pt>
                <c:pt idx="2">
                  <c:v>156894</c:v>
                </c:pt>
                <c:pt idx="3">
                  <c:v>158381</c:v>
                </c:pt>
                <c:pt idx="4">
                  <c:v>154200</c:v>
                </c:pt>
                <c:pt idx="5">
                  <c:v>163641</c:v>
                </c:pt>
                <c:pt idx="6">
                  <c:v>236610</c:v>
                </c:pt>
                <c:pt idx="7">
                  <c:v>287735</c:v>
                </c:pt>
                <c:pt idx="8">
                  <c:v>316944</c:v>
                </c:pt>
                <c:pt idx="9">
                  <c:v>342482</c:v>
                </c:pt>
                <c:pt idx="10">
                  <c:v>362370</c:v>
                </c:pt>
                <c:pt idx="11">
                  <c:v>360699</c:v>
                </c:pt>
                <c:pt idx="12">
                  <c:v>365432</c:v>
                </c:pt>
                <c:pt idx="13">
                  <c:v>368252</c:v>
                </c:pt>
                <c:pt idx="14">
                  <c:v>374497</c:v>
                </c:pt>
                <c:pt idx="15">
                  <c:v>382870</c:v>
                </c:pt>
                <c:pt idx="16">
                  <c:v>373677</c:v>
                </c:pt>
                <c:pt idx="17">
                  <c:v>381421</c:v>
                </c:pt>
                <c:pt idx="18">
                  <c:v>382815</c:v>
                </c:pt>
                <c:pt idx="19">
                  <c:v>382562</c:v>
                </c:pt>
                <c:pt idx="20">
                  <c:v>382030</c:v>
                </c:pt>
                <c:pt idx="21">
                  <c:v>392952</c:v>
                </c:pt>
                <c:pt idx="22">
                  <c:v>378336</c:v>
                </c:pt>
                <c:pt idx="23">
                  <c:v>395683</c:v>
                </c:pt>
                <c:pt idx="24">
                  <c:v>399966</c:v>
                </c:pt>
                <c:pt idx="25">
                  <c:v>385639</c:v>
                </c:pt>
                <c:pt idx="26">
                  <c:v>388270</c:v>
                </c:pt>
                <c:pt idx="27">
                  <c:v>389246</c:v>
                </c:pt>
                <c:pt idx="28">
                  <c:v>377183</c:v>
                </c:pt>
                <c:pt idx="29">
                  <c:v>394199</c:v>
                </c:pt>
                <c:pt idx="30">
                  <c:v>392430</c:v>
                </c:pt>
                <c:pt idx="31">
                  <c:v>392197</c:v>
                </c:pt>
                <c:pt idx="32">
                  <c:v>385703</c:v>
                </c:pt>
                <c:pt idx="33">
                  <c:v>396196</c:v>
                </c:pt>
                <c:pt idx="34">
                  <c:v>386388</c:v>
                </c:pt>
                <c:pt idx="35">
                  <c:v>39616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859C-4CDA-B307-A2E7EE1D40F8}"/>
            </c:ext>
          </c:extLst>
        </c:ser>
        <c:ser>
          <c:idx val="2"/>
          <c:order val="2"/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F$42:$F$77</c:f>
              <c:numCache>
                <c:formatCode>General</c:formatCode>
                <c:ptCount val="36"/>
                <c:pt idx="0">
                  <c:v>138124</c:v>
                </c:pt>
                <c:pt idx="1">
                  <c:v>138714</c:v>
                </c:pt>
                <c:pt idx="2">
                  <c:v>138925</c:v>
                </c:pt>
                <c:pt idx="3">
                  <c:v>139533</c:v>
                </c:pt>
                <c:pt idx="4">
                  <c:v>133986</c:v>
                </c:pt>
                <c:pt idx="5">
                  <c:v>147506</c:v>
                </c:pt>
                <c:pt idx="6">
                  <c:v>209922</c:v>
                </c:pt>
                <c:pt idx="7">
                  <c:v>262751</c:v>
                </c:pt>
                <c:pt idx="8">
                  <c:v>296926</c:v>
                </c:pt>
                <c:pt idx="9">
                  <c:v>314354</c:v>
                </c:pt>
                <c:pt idx="10">
                  <c:v>330756</c:v>
                </c:pt>
                <c:pt idx="11">
                  <c:v>330857</c:v>
                </c:pt>
                <c:pt idx="12">
                  <c:v>345051</c:v>
                </c:pt>
                <c:pt idx="13">
                  <c:v>344983</c:v>
                </c:pt>
                <c:pt idx="14">
                  <c:v>348324</c:v>
                </c:pt>
                <c:pt idx="15">
                  <c:v>344148</c:v>
                </c:pt>
                <c:pt idx="16">
                  <c:v>353463</c:v>
                </c:pt>
                <c:pt idx="17">
                  <c:v>348739</c:v>
                </c:pt>
                <c:pt idx="18">
                  <c:v>351955</c:v>
                </c:pt>
                <c:pt idx="19">
                  <c:v>355756</c:v>
                </c:pt>
                <c:pt idx="20">
                  <c:v>359010</c:v>
                </c:pt>
                <c:pt idx="21">
                  <c:v>354860</c:v>
                </c:pt>
                <c:pt idx="22">
                  <c:v>361059</c:v>
                </c:pt>
                <c:pt idx="23">
                  <c:v>356404</c:v>
                </c:pt>
                <c:pt idx="24">
                  <c:v>366065</c:v>
                </c:pt>
                <c:pt idx="25">
                  <c:v>358838</c:v>
                </c:pt>
                <c:pt idx="26">
                  <c:v>351909</c:v>
                </c:pt>
                <c:pt idx="27">
                  <c:v>356099</c:v>
                </c:pt>
                <c:pt idx="28">
                  <c:v>356451</c:v>
                </c:pt>
                <c:pt idx="29">
                  <c:v>356683</c:v>
                </c:pt>
                <c:pt idx="30">
                  <c:v>367241</c:v>
                </c:pt>
                <c:pt idx="31">
                  <c:v>360631</c:v>
                </c:pt>
                <c:pt idx="32">
                  <c:v>365559</c:v>
                </c:pt>
                <c:pt idx="33">
                  <c:v>359571</c:v>
                </c:pt>
                <c:pt idx="34">
                  <c:v>362530</c:v>
                </c:pt>
                <c:pt idx="35">
                  <c:v>3598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859C-4CDA-B307-A2E7EE1D40F8}"/>
            </c:ext>
          </c:extLst>
        </c:ser>
        <c:ser>
          <c:idx val="3"/>
          <c:order val="3"/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G$42:$G$77</c:f>
              <c:numCache>
                <c:formatCode>General</c:formatCode>
                <c:ptCount val="36"/>
                <c:pt idx="0">
                  <c:v>88297</c:v>
                </c:pt>
                <c:pt idx="1">
                  <c:v>88877</c:v>
                </c:pt>
                <c:pt idx="2">
                  <c:v>86731</c:v>
                </c:pt>
                <c:pt idx="3">
                  <c:v>89685</c:v>
                </c:pt>
                <c:pt idx="4">
                  <c:v>86303</c:v>
                </c:pt>
                <c:pt idx="5">
                  <c:v>103726</c:v>
                </c:pt>
                <c:pt idx="6">
                  <c:v>106654</c:v>
                </c:pt>
                <c:pt idx="7">
                  <c:v>122030</c:v>
                </c:pt>
                <c:pt idx="8">
                  <c:v>142413</c:v>
                </c:pt>
                <c:pt idx="9">
                  <c:v>154527</c:v>
                </c:pt>
                <c:pt idx="10">
                  <c:v>184920</c:v>
                </c:pt>
                <c:pt idx="11">
                  <c:v>188738</c:v>
                </c:pt>
                <c:pt idx="12">
                  <c:v>203109</c:v>
                </c:pt>
                <c:pt idx="13">
                  <c:v>215047</c:v>
                </c:pt>
                <c:pt idx="14">
                  <c:v>224578</c:v>
                </c:pt>
                <c:pt idx="15">
                  <c:v>223606</c:v>
                </c:pt>
                <c:pt idx="16">
                  <c:v>233880</c:v>
                </c:pt>
                <c:pt idx="17">
                  <c:v>232336</c:v>
                </c:pt>
                <c:pt idx="18">
                  <c:v>248387</c:v>
                </c:pt>
                <c:pt idx="19">
                  <c:v>238358</c:v>
                </c:pt>
                <c:pt idx="20">
                  <c:v>241119</c:v>
                </c:pt>
                <c:pt idx="21">
                  <c:v>240578</c:v>
                </c:pt>
                <c:pt idx="22">
                  <c:v>249202</c:v>
                </c:pt>
                <c:pt idx="23">
                  <c:v>247326</c:v>
                </c:pt>
                <c:pt idx="24">
                  <c:v>254251</c:v>
                </c:pt>
                <c:pt idx="25">
                  <c:v>259310</c:v>
                </c:pt>
                <c:pt idx="26">
                  <c:v>250455</c:v>
                </c:pt>
                <c:pt idx="27">
                  <c:v>262704</c:v>
                </c:pt>
                <c:pt idx="28">
                  <c:v>256382</c:v>
                </c:pt>
                <c:pt idx="29">
                  <c:v>254512</c:v>
                </c:pt>
                <c:pt idx="30">
                  <c:v>256235</c:v>
                </c:pt>
                <c:pt idx="31">
                  <c:v>257218</c:v>
                </c:pt>
                <c:pt idx="32">
                  <c:v>258384</c:v>
                </c:pt>
                <c:pt idx="33">
                  <c:v>252346</c:v>
                </c:pt>
                <c:pt idx="34">
                  <c:v>258632</c:v>
                </c:pt>
                <c:pt idx="35">
                  <c:v>25774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859C-4CDA-B307-A2E7EE1D40F8}"/>
            </c:ext>
          </c:extLst>
        </c:ser>
        <c:ser>
          <c:idx val="4"/>
          <c:order val="4"/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H$42:$H$77</c:f>
              <c:numCache>
                <c:formatCode>General</c:formatCode>
                <c:ptCount val="36"/>
                <c:pt idx="0">
                  <c:v>79195</c:v>
                </c:pt>
                <c:pt idx="1">
                  <c:v>77715</c:v>
                </c:pt>
                <c:pt idx="2">
                  <c:v>77198</c:v>
                </c:pt>
                <c:pt idx="3">
                  <c:v>78422</c:v>
                </c:pt>
                <c:pt idx="4">
                  <c:v>81911</c:v>
                </c:pt>
                <c:pt idx="5">
                  <c:v>74786</c:v>
                </c:pt>
                <c:pt idx="6">
                  <c:v>85041</c:v>
                </c:pt>
                <c:pt idx="7">
                  <c:v>110132</c:v>
                </c:pt>
                <c:pt idx="8">
                  <c:v>136429</c:v>
                </c:pt>
                <c:pt idx="9">
                  <c:v>153311</c:v>
                </c:pt>
                <c:pt idx="10">
                  <c:v>171863</c:v>
                </c:pt>
                <c:pt idx="11">
                  <c:v>181536</c:v>
                </c:pt>
                <c:pt idx="12">
                  <c:v>192951</c:v>
                </c:pt>
                <c:pt idx="13">
                  <c:v>200081</c:v>
                </c:pt>
                <c:pt idx="14">
                  <c:v>199521</c:v>
                </c:pt>
                <c:pt idx="15">
                  <c:v>209277</c:v>
                </c:pt>
                <c:pt idx="16">
                  <c:v>209038</c:v>
                </c:pt>
                <c:pt idx="17">
                  <c:v>210520</c:v>
                </c:pt>
                <c:pt idx="18">
                  <c:v>224655</c:v>
                </c:pt>
                <c:pt idx="19">
                  <c:v>218444</c:v>
                </c:pt>
                <c:pt idx="20">
                  <c:v>216522</c:v>
                </c:pt>
                <c:pt idx="21">
                  <c:v>229930</c:v>
                </c:pt>
                <c:pt idx="22">
                  <c:v>220624</c:v>
                </c:pt>
                <c:pt idx="23">
                  <c:v>229843</c:v>
                </c:pt>
                <c:pt idx="24">
                  <c:v>228815</c:v>
                </c:pt>
                <c:pt idx="25">
                  <c:v>230178</c:v>
                </c:pt>
                <c:pt idx="26">
                  <c:v>225028</c:v>
                </c:pt>
                <c:pt idx="27">
                  <c:v>229396</c:v>
                </c:pt>
                <c:pt idx="28">
                  <c:v>225621</c:v>
                </c:pt>
                <c:pt idx="29">
                  <c:v>229817</c:v>
                </c:pt>
                <c:pt idx="30">
                  <c:v>226503</c:v>
                </c:pt>
                <c:pt idx="31">
                  <c:v>228579</c:v>
                </c:pt>
                <c:pt idx="32">
                  <c:v>224497</c:v>
                </c:pt>
                <c:pt idx="33">
                  <c:v>224776</c:v>
                </c:pt>
                <c:pt idx="34">
                  <c:v>231181</c:v>
                </c:pt>
                <c:pt idx="35">
                  <c:v>22813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859C-4CDA-B307-A2E7EE1D40F8}"/>
            </c:ext>
          </c:extLst>
        </c:ser>
        <c:ser>
          <c:idx val="5"/>
          <c:order val="5"/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I$42:$I$77</c:f>
              <c:numCache>
                <c:formatCode>General</c:formatCode>
                <c:ptCount val="36"/>
                <c:pt idx="0">
                  <c:v>78506</c:v>
                </c:pt>
                <c:pt idx="1">
                  <c:v>73967</c:v>
                </c:pt>
                <c:pt idx="2">
                  <c:v>77690</c:v>
                </c:pt>
                <c:pt idx="3">
                  <c:v>76488</c:v>
                </c:pt>
                <c:pt idx="4">
                  <c:v>75366</c:v>
                </c:pt>
                <c:pt idx="5">
                  <c:v>75747</c:v>
                </c:pt>
                <c:pt idx="6">
                  <c:v>86706</c:v>
                </c:pt>
                <c:pt idx="7">
                  <c:v>118786</c:v>
                </c:pt>
                <c:pt idx="8">
                  <c:v>149959</c:v>
                </c:pt>
                <c:pt idx="9">
                  <c:v>173310</c:v>
                </c:pt>
                <c:pt idx="10">
                  <c:v>182521</c:v>
                </c:pt>
                <c:pt idx="11">
                  <c:v>197879</c:v>
                </c:pt>
                <c:pt idx="12">
                  <c:v>201996</c:v>
                </c:pt>
                <c:pt idx="13">
                  <c:v>209755</c:v>
                </c:pt>
                <c:pt idx="14">
                  <c:v>216609</c:v>
                </c:pt>
                <c:pt idx="15">
                  <c:v>220169</c:v>
                </c:pt>
                <c:pt idx="16">
                  <c:v>217001</c:v>
                </c:pt>
                <c:pt idx="17">
                  <c:v>219263</c:v>
                </c:pt>
                <c:pt idx="18">
                  <c:v>222946</c:v>
                </c:pt>
                <c:pt idx="19">
                  <c:v>229724</c:v>
                </c:pt>
                <c:pt idx="20">
                  <c:v>222851</c:v>
                </c:pt>
                <c:pt idx="21">
                  <c:v>229521</c:v>
                </c:pt>
                <c:pt idx="22">
                  <c:v>233181</c:v>
                </c:pt>
                <c:pt idx="23">
                  <c:v>231613</c:v>
                </c:pt>
                <c:pt idx="24">
                  <c:v>229154</c:v>
                </c:pt>
                <c:pt idx="25">
                  <c:v>231612</c:v>
                </c:pt>
                <c:pt idx="26">
                  <c:v>231348</c:v>
                </c:pt>
                <c:pt idx="27">
                  <c:v>234115</c:v>
                </c:pt>
                <c:pt idx="28">
                  <c:v>234461</c:v>
                </c:pt>
                <c:pt idx="29">
                  <c:v>230581</c:v>
                </c:pt>
                <c:pt idx="30">
                  <c:v>230860</c:v>
                </c:pt>
                <c:pt idx="31">
                  <c:v>235171</c:v>
                </c:pt>
                <c:pt idx="32">
                  <c:v>237920</c:v>
                </c:pt>
                <c:pt idx="33">
                  <c:v>231287</c:v>
                </c:pt>
                <c:pt idx="34">
                  <c:v>234070</c:v>
                </c:pt>
                <c:pt idx="35">
                  <c:v>23564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859C-4CDA-B307-A2E7EE1D40F8}"/>
            </c:ext>
          </c:extLst>
        </c:ser>
        <c:ser>
          <c:idx val="6"/>
          <c:order val="6"/>
          <c:spPr>
            <a:ln w="19050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J$42:$J$77</c:f>
              <c:numCache>
                <c:formatCode>General</c:formatCode>
                <c:ptCount val="36"/>
                <c:pt idx="0">
                  <c:v>106638</c:v>
                </c:pt>
                <c:pt idx="1">
                  <c:v>111640</c:v>
                </c:pt>
                <c:pt idx="2">
                  <c:v>109803</c:v>
                </c:pt>
                <c:pt idx="3">
                  <c:v>107622</c:v>
                </c:pt>
                <c:pt idx="4">
                  <c:v>108755</c:v>
                </c:pt>
                <c:pt idx="5">
                  <c:v>112553</c:v>
                </c:pt>
                <c:pt idx="6">
                  <c:v>109729</c:v>
                </c:pt>
                <c:pt idx="7">
                  <c:v>108469</c:v>
                </c:pt>
                <c:pt idx="8">
                  <c:v>109167</c:v>
                </c:pt>
                <c:pt idx="9">
                  <c:v>111920</c:v>
                </c:pt>
                <c:pt idx="10">
                  <c:v>107623</c:v>
                </c:pt>
                <c:pt idx="11">
                  <c:v>108713</c:v>
                </c:pt>
                <c:pt idx="12">
                  <c:v>105430</c:v>
                </c:pt>
                <c:pt idx="13">
                  <c:v>108809</c:v>
                </c:pt>
                <c:pt idx="14">
                  <c:v>111356</c:v>
                </c:pt>
                <c:pt idx="15">
                  <c:v>109168</c:v>
                </c:pt>
                <c:pt idx="16">
                  <c:v>110468</c:v>
                </c:pt>
                <c:pt idx="17">
                  <c:v>111186</c:v>
                </c:pt>
                <c:pt idx="18">
                  <c:v>108827</c:v>
                </c:pt>
                <c:pt idx="19">
                  <c:v>107912</c:v>
                </c:pt>
                <c:pt idx="20">
                  <c:v>107889</c:v>
                </c:pt>
                <c:pt idx="21">
                  <c:v>107474</c:v>
                </c:pt>
                <c:pt idx="22">
                  <c:v>108744</c:v>
                </c:pt>
                <c:pt idx="23">
                  <c:v>112344</c:v>
                </c:pt>
                <c:pt idx="24">
                  <c:v>114073</c:v>
                </c:pt>
                <c:pt idx="25">
                  <c:v>108188</c:v>
                </c:pt>
                <c:pt idx="26">
                  <c:v>111368</c:v>
                </c:pt>
                <c:pt idx="27">
                  <c:v>104310</c:v>
                </c:pt>
                <c:pt idx="28">
                  <c:v>105308</c:v>
                </c:pt>
                <c:pt idx="29">
                  <c:v>105093</c:v>
                </c:pt>
                <c:pt idx="30">
                  <c:v>105683</c:v>
                </c:pt>
                <c:pt idx="31">
                  <c:v>106130</c:v>
                </c:pt>
                <c:pt idx="32">
                  <c:v>107187</c:v>
                </c:pt>
                <c:pt idx="33">
                  <c:v>110273</c:v>
                </c:pt>
                <c:pt idx="34">
                  <c:v>114212</c:v>
                </c:pt>
                <c:pt idx="35">
                  <c:v>10964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859C-4CDA-B307-A2E7EE1D40F8}"/>
            </c:ext>
          </c:extLst>
        </c:ser>
        <c:ser>
          <c:idx val="7"/>
          <c:order val="7"/>
          <c:spPr>
            <a:ln w="19050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K$42:$K$77</c:f>
              <c:numCache>
                <c:formatCode>General</c:formatCode>
                <c:ptCount val="36"/>
                <c:pt idx="0">
                  <c:v>84123</c:v>
                </c:pt>
                <c:pt idx="1">
                  <c:v>88633</c:v>
                </c:pt>
                <c:pt idx="2">
                  <c:v>86940</c:v>
                </c:pt>
                <c:pt idx="3">
                  <c:v>89284</c:v>
                </c:pt>
                <c:pt idx="4">
                  <c:v>88722</c:v>
                </c:pt>
                <c:pt idx="5">
                  <c:v>84964</c:v>
                </c:pt>
                <c:pt idx="6">
                  <c:v>94821</c:v>
                </c:pt>
                <c:pt idx="7">
                  <c:v>89211</c:v>
                </c:pt>
                <c:pt idx="8">
                  <c:v>90729</c:v>
                </c:pt>
                <c:pt idx="9">
                  <c:v>93116</c:v>
                </c:pt>
                <c:pt idx="10">
                  <c:v>86797</c:v>
                </c:pt>
                <c:pt idx="11">
                  <c:v>88430</c:v>
                </c:pt>
                <c:pt idx="12">
                  <c:v>88588</c:v>
                </c:pt>
                <c:pt idx="13">
                  <c:v>88416</c:v>
                </c:pt>
                <c:pt idx="14">
                  <c:v>88514</c:v>
                </c:pt>
                <c:pt idx="15">
                  <c:v>89812</c:v>
                </c:pt>
                <c:pt idx="16">
                  <c:v>90490</c:v>
                </c:pt>
                <c:pt idx="17">
                  <c:v>91591</c:v>
                </c:pt>
                <c:pt idx="18">
                  <c:v>91558</c:v>
                </c:pt>
                <c:pt idx="19">
                  <c:v>89874</c:v>
                </c:pt>
                <c:pt idx="20">
                  <c:v>90406</c:v>
                </c:pt>
                <c:pt idx="21">
                  <c:v>88681</c:v>
                </c:pt>
                <c:pt idx="22">
                  <c:v>88857</c:v>
                </c:pt>
                <c:pt idx="23">
                  <c:v>89849</c:v>
                </c:pt>
                <c:pt idx="24">
                  <c:v>88957</c:v>
                </c:pt>
                <c:pt idx="25">
                  <c:v>87137</c:v>
                </c:pt>
                <c:pt idx="26">
                  <c:v>88973</c:v>
                </c:pt>
                <c:pt idx="27">
                  <c:v>92643</c:v>
                </c:pt>
                <c:pt idx="28">
                  <c:v>93995</c:v>
                </c:pt>
                <c:pt idx="29">
                  <c:v>95016</c:v>
                </c:pt>
                <c:pt idx="30">
                  <c:v>89869</c:v>
                </c:pt>
                <c:pt idx="31">
                  <c:v>91569</c:v>
                </c:pt>
                <c:pt idx="32">
                  <c:v>90528</c:v>
                </c:pt>
                <c:pt idx="33">
                  <c:v>89338</c:v>
                </c:pt>
                <c:pt idx="34">
                  <c:v>87632</c:v>
                </c:pt>
                <c:pt idx="35">
                  <c:v>9133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7-859C-4CDA-B307-A2E7EE1D40F8}"/>
            </c:ext>
          </c:extLst>
        </c:ser>
        <c:ser>
          <c:idx val="8"/>
          <c:order val="8"/>
          <c:spPr>
            <a:ln w="19050" cap="rnd">
              <a:solidFill>
                <a:schemeClr val="accent2">
                  <a:lumMod val="60000"/>
                  <a:lumOff val="4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  <a:lumOff val="4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L$42:$L$77</c:f>
              <c:numCache>
                <c:formatCode>General</c:formatCode>
                <c:ptCount val="36"/>
                <c:pt idx="0">
                  <c:v>81428</c:v>
                </c:pt>
                <c:pt idx="1">
                  <c:v>82499</c:v>
                </c:pt>
                <c:pt idx="2">
                  <c:v>80508</c:v>
                </c:pt>
                <c:pt idx="3">
                  <c:v>78662</c:v>
                </c:pt>
                <c:pt idx="4">
                  <c:v>84558</c:v>
                </c:pt>
                <c:pt idx="5">
                  <c:v>84858</c:v>
                </c:pt>
                <c:pt idx="6">
                  <c:v>83483</c:v>
                </c:pt>
                <c:pt idx="7">
                  <c:v>83293</c:v>
                </c:pt>
                <c:pt idx="8">
                  <c:v>81831</c:v>
                </c:pt>
                <c:pt idx="9">
                  <c:v>81707</c:v>
                </c:pt>
                <c:pt idx="10">
                  <c:v>82054</c:v>
                </c:pt>
                <c:pt idx="11">
                  <c:v>80653</c:v>
                </c:pt>
                <c:pt idx="12">
                  <c:v>80690</c:v>
                </c:pt>
                <c:pt idx="13">
                  <c:v>81657</c:v>
                </c:pt>
                <c:pt idx="14">
                  <c:v>79645</c:v>
                </c:pt>
                <c:pt idx="15">
                  <c:v>80634</c:v>
                </c:pt>
                <c:pt idx="16">
                  <c:v>84817</c:v>
                </c:pt>
                <c:pt idx="17">
                  <c:v>80672</c:v>
                </c:pt>
                <c:pt idx="18">
                  <c:v>82693</c:v>
                </c:pt>
                <c:pt idx="19">
                  <c:v>81130</c:v>
                </c:pt>
                <c:pt idx="20">
                  <c:v>86148</c:v>
                </c:pt>
                <c:pt idx="21">
                  <c:v>81258</c:v>
                </c:pt>
                <c:pt idx="22">
                  <c:v>83342</c:v>
                </c:pt>
                <c:pt idx="23">
                  <c:v>80729</c:v>
                </c:pt>
                <c:pt idx="24">
                  <c:v>84777</c:v>
                </c:pt>
                <c:pt idx="25">
                  <c:v>85665</c:v>
                </c:pt>
                <c:pt idx="26">
                  <c:v>83285</c:v>
                </c:pt>
                <c:pt idx="27">
                  <c:v>81269</c:v>
                </c:pt>
                <c:pt idx="28">
                  <c:v>85718</c:v>
                </c:pt>
                <c:pt idx="29">
                  <c:v>78397</c:v>
                </c:pt>
                <c:pt idx="30">
                  <c:v>79621</c:v>
                </c:pt>
                <c:pt idx="31">
                  <c:v>80060</c:v>
                </c:pt>
                <c:pt idx="32">
                  <c:v>83185</c:v>
                </c:pt>
                <c:pt idx="33">
                  <c:v>82199</c:v>
                </c:pt>
                <c:pt idx="34">
                  <c:v>83232</c:v>
                </c:pt>
                <c:pt idx="35">
                  <c:v>8381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8-859C-4CDA-B307-A2E7EE1D40F8}"/>
            </c:ext>
          </c:extLst>
        </c:ser>
        <c:ser>
          <c:idx val="9"/>
          <c:order val="9"/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M$42:$M$77</c:f>
              <c:numCache>
                <c:formatCode>General</c:formatCode>
                <c:ptCount val="36"/>
                <c:pt idx="0">
                  <c:v>69695</c:v>
                </c:pt>
                <c:pt idx="1">
                  <c:v>68778</c:v>
                </c:pt>
                <c:pt idx="2">
                  <c:v>68050</c:v>
                </c:pt>
                <c:pt idx="3">
                  <c:v>66830</c:v>
                </c:pt>
                <c:pt idx="4">
                  <c:v>67804</c:v>
                </c:pt>
                <c:pt idx="5">
                  <c:v>69182</c:v>
                </c:pt>
                <c:pt idx="6">
                  <c:v>67738</c:v>
                </c:pt>
                <c:pt idx="7">
                  <c:v>68357</c:v>
                </c:pt>
                <c:pt idx="8">
                  <c:v>67703</c:v>
                </c:pt>
                <c:pt idx="9">
                  <c:v>62285</c:v>
                </c:pt>
                <c:pt idx="10">
                  <c:v>67351</c:v>
                </c:pt>
                <c:pt idx="11">
                  <c:v>67591</c:v>
                </c:pt>
                <c:pt idx="12">
                  <c:v>64075</c:v>
                </c:pt>
                <c:pt idx="13">
                  <c:v>63709</c:v>
                </c:pt>
                <c:pt idx="14">
                  <c:v>66843</c:v>
                </c:pt>
                <c:pt idx="15">
                  <c:v>71624</c:v>
                </c:pt>
                <c:pt idx="16">
                  <c:v>65616</c:v>
                </c:pt>
                <c:pt idx="17">
                  <c:v>63330</c:v>
                </c:pt>
                <c:pt idx="18">
                  <c:v>64260</c:v>
                </c:pt>
                <c:pt idx="19">
                  <c:v>68234</c:v>
                </c:pt>
                <c:pt idx="20">
                  <c:v>67746</c:v>
                </c:pt>
                <c:pt idx="21">
                  <c:v>65831</c:v>
                </c:pt>
                <c:pt idx="22">
                  <c:v>63171</c:v>
                </c:pt>
                <c:pt idx="23">
                  <c:v>66509</c:v>
                </c:pt>
                <c:pt idx="24">
                  <c:v>68399</c:v>
                </c:pt>
                <c:pt idx="25">
                  <c:v>64290</c:v>
                </c:pt>
                <c:pt idx="26">
                  <c:v>67250</c:v>
                </c:pt>
                <c:pt idx="27">
                  <c:v>66307</c:v>
                </c:pt>
                <c:pt idx="28">
                  <c:v>65414</c:v>
                </c:pt>
                <c:pt idx="29">
                  <c:v>65087</c:v>
                </c:pt>
                <c:pt idx="30">
                  <c:v>66736</c:v>
                </c:pt>
                <c:pt idx="31">
                  <c:v>67024</c:v>
                </c:pt>
                <c:pt idx="32">
                  <c:v>68221</c:v>
                </c:pt>
                <c:pt idx="33">
                  <c:v>65780</c:v>
                </c:pt>
                <c:pt idx="34">
                  <c:v>69482</c:v>
                </c:pt>
                <c:pt idx="35">
                  <c:v>6146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9-859C-4CDA-B307-A2E7EE1D40F8}"/>
            </c:ext>
          </c:extLst>
        </c:ser>
        <c:ser>
          <c:idx val="10"/>
          <c:order val="10"/>
          <c:spPr>
            <a:ln w="19050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N$42:$N$77</c:f>
              <c:numCache>
                <c:formatCode>General</c:formatCode>
                <c:ptCount val="36"/>
                <c:pt idx="0">
                  <c:v>65710</c:v>
                </c:pt>
                <c:pt idx="1">
                  <c:v>70516</c:v>
                </c:pt>
                <c:pt idx="2">
                  <c:v>69173</c:v>
                </c:pt>
                <c:pt idx="3">
                  <c:v>65976</c:v>
                </c:pt>
                <c:pt idx="4">
                  <c:v>67179</c:v>
                </c:pt>
                <c:pt idx="5">
                  <c:v>68672</c:v>
                </c:pt>
                <c:pt idx="6">
                  <c:v>69390</c:v>
                </c:pt>
                <c:pt idx="7">
                  <c:v>65553</c:v>
                </c:pt>
                <c:pt idx="8">
                  <c:v>69247</c:v>
                </c:pt>
                <c:pt idx="9">
                  <c:v>68445</c:v>
                </c:pt>
                <c:pt idx="10">
                  <c:v>69860</c:v>
                </c:pt>
                <c:pt idx="11">
                  <c:v>72622</c:v>
                </c:pt>
                <c:pt idx="12">
                  <c:v>67468</c:v>
                </c:pt>
                <c:pt idx="13">
                  <c:v>70102</c:v>
                </c:pt>
                <c:pt idx="14">
                  <c:v>70251</c:v>
                </c:pt>
                <c:pt idx="15">
                  <c:v>65868</c:v>
                </c:pt>
                <c:pt idx="16">
                  <c:v>69670</c:v>
                </c:pt>
                <c:pt idx="17">
                  <c:v>68193</c:v>
                </c:pt>
                <c:pt idx="18">
                  <c:v>67430</c:v>
                </c:pt>
                <c:pt idx="19">
                  <c:v>65738</c:v>
                </c:pt>
                <c:pt idx="20">
                  <c:v>68867</c:v>
                </c:pt>
                <c:pt idx="21">
                  <c:v>71279</c:v>
                </c:pt>
                <c:pt idx="22">
                  <c:v>67263</c:v>
                </c:pt>
                <c:pt idx="23">
                  <c:v>70779</c:v>
                </c:pt>
                <c:pt idx="24">
                  <c:v>68121</c:v>
                </c:pt>
                <c:pt idx="25">
                  <c:v>67806</c:v>
                </c:pt>
                <c:pt idx="26">
                  <c:v>66861</c:v>
                </c:pt>
                <c:pt idx="27">
                  <c:v>72010</c:v>
                </c:pt>
                <c:pt idx="28">
                  <c:v>71456</c:v>
                </c:pt>
                <c:pt idx="29">
                  <c:v>70521</c:v>
                </c:pt>
                <c:pt idx="30">
                  <c:v>70091</c:v>
                </c:pt>
                <c:pt idx="31">
                  <c:v>70107</c:v>
                </c:pt>
                <c:pt idx="32">
                  <c:v>66909</c:v>
                </c:pt>
                <c:pt idx="33">
                  <c:v>68793</c:v>
                </c:pt>
                <c:pt idx="34">
                  <c:v>67899</c:v>
                </c:pt>
                <c:pt idx="35">
                  <c:v>7049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A-859C-4CDA-B307-A2E7EE1D40F8}"/>
            </c:ext>
          </c:extLst>
        </c:ser>
        <c:ser>
          <c:idx val="11"/>
          <c:order val="11"/>
          <c:spPr>
            <a:ln w="19050" cap="rnd">
              <a:solidFill>
                <a:schemeClr val="accent4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O$42:$O$77</c:f>
              <c:numCache>
                <c:formatCode>General</c:formatCode>
                <c:ptCount val="36"/>
                <c:pt idx="0">
                  <c:v>71131</c:v>
                </c:pt>
                <c:pt idx="1">
                  <c:v>69660</c:v>
                </c:pt>
                <c:pt idx="2">
                  <c:v>67181</c:v>
                </c:pt>
                <c:pt idx="3">
                  <c:v>70588</c:v>
                </c:pt>
                <c:pt idx="4">
                  <c:v>68593</c:v>
                </c:pt>
                <c:pt idx="5">
                  <c:v>69661</c:v>
                </c:pt>
                <c:pt idx="6">
                  <c:v>66047</c:v>
                </c:pt>
                <c:pt idx="7">
                  <c:v>70504</c:v>
                </c:pt>
                <c:pt idx="8">
                  <c:v>69443</c:v>
                </c:pt>
                <c:pt idx="9">
                  <c:v>67488</c:v>
                </c:pt>
                <c:pt idx="10">
                  <c:v>71596</c:v>
                </c:pt>
                <c:pt idx="11">
                  <c:v>71494</c:v>
                </c:pt>
                <c:pt idx="12">
                  <c:v>68782</c:v>
                </c:pt>
                <c:pt idx="13">
                  <c:v>68393</c:v>
                </c:pt>
                <c:pt idx="14">
                  <c:v>69172</c:v>
                </c:pt>
                <c:pt idx="15">
                  <c:v>68298</c:v>
                </c:pt>
                <c:pt idx="16">
                  <c:v>69183</c:v>
                </c:pt>
                <c:pt idx="17">
                  <c:v>70984</c:v>
                </c:pt>
                <c:pt idx="18">
                  <c:v>69323</c:v>
                </c:pt>
                <c:pt idx="19">
                  <c:v>72112</c:v>
                </c:pt>
                <c:pt idx="20">
                  <c:v>65882</c:v>
                </c:pt>
                <c:pt idx="21">
                  <c:v>65855</c:v>
                </c:pt>
                <c:pt idx="22">
                  <c:v>66050</c:v>
                </c:pt>
                <c:pt idx="23">
                  <c:v>64894</c:v>
                </c:pt>
                <c:pt idx="24">
                  <c:v>72276</c:v>
                </c:pt>
                <c:pt idx="25">
                  <c:v>67275</c:v>
                </c:pt>
                <c:pt idx="26">
                  <c:v>66928</c:v>
                </c:pt>
                <c:pt idx="27">
                  <c:v>65814</c:v>
                </c:pt>
                <c:pt idx="28">
                  <c:v>68481</c:v>
                </c:pt>
                <c:pt idx="29">
                  <c:v>66561</c:v>
                </c:pt>
                <c:pt idx="30">
                  <c:v>68503</c:v>
                </c:pt>
                <c:pt idx="31">
                  <c:v>66204</c:v>
                </c:pt>
                <c:pt idx="32">
                  <c:v>67765</c:v>
                </c:pt>
                <c:pt idx="33">
                  <c:v>69229</c:v>
                </c:pt>
                <c:pt idx="34">
                  <c:v>67481</c:v>
                </c:pt>
                <c:pt idx="35">
                  <c:v>6844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B-859C-4CDA-B307-A2E7EE1D40F8}"/>
            </c:ext>
          </c:extLst>
        </c:ser>
        <c:ser>
          <c:idx val="12"/>
          <c:order val="12"/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P$42:$P$77</c:f>
              <c:numCache>
                <c:formatCode>General</c:formatCode>
                <c:ptCount val="36"/>
                <c:pt idx="0">
                  <c:v>59359</c:v>
                </c:pt>
                <c:pt idx="1">
                  <c:v>63782</c:v>
                </c:pt>
                <c:pt idx="2">
                  <c:v>59432</c:v>
                </c:pt>
                <c:pt idx="3">
                  <c:v>59270</c:v>
                </c:pt>
                <c:pt idx="4">
                  <c:v>56638</c:v>
                </c:pt>
                <c:pt idx="5">
                  <c:v>60252</c:v>
                </c:pt>
                <c:pt idx="6">
                  <c:v>59979</c:v>
                </c:pt>
                <c:pt idx="7">
                  <c:v>59470</c:v>
                </c:pt>
                <c:pt idx="8">
                  <c:v>56246</c:v>
                </c:pt>
                <c:pt idx="9">
                  <c:v>58750</c:v>
                </c:pt>
                <c:pt idx="10">
                  <c:v>60728</c:v>
                </c:pt>
                <c:pt idx="11">
                  <c:v>58732</c:v>
                </c:pt>
                <c:pt idx="12">
                  <c:v>61433</c:v>
                </c:pt>
                <c:pt idx="13">
                  <c:v>57661</c:v>
                </c:pt>
                <c:pt idx="14">
                  <c:v>61230</c:v>
                </c:pt>
                <c:pt idx="15">
                  <c:v>61690</c:v>
                </c:pt>
                <c:pt idx="16">
                  <c:v>60315</c:v>
                </c:pt>
                <c:pt idx="17">
                  <c:v>57553</c:v>
                </c:pt>
                <c:pt idx="18">
                  <c:v>58577</c:v>
                </c:pt>
                <c:pt idx="19">
                  <c:v>60725</c:v>
                </c:pt>
                <c:pt idx="20">
                  <c:v>61369</c:v>
                </c:pt>
                <c:pt idx="21">
                  <c:v>57470</c:v>
                </c:pt>
                <c:pt idx="22">
                  <c:v>60300</c:v>
                </c:pt>
                <c:pt idx="23">
                  <c:v>56451</c:v>
                </c:pt>
                <c:pt idx="24">
                  <c:v>58978</c:v>
                </c:pt>
                <c:pt idx="25">
                  <c:v>61553</c:v>
                </c:pt>
                <c:pt idx="26">
                  <c:v>58994</c:v>
                </c:pt>
                <c:pt idx="27">
                  <c:v>58137</c:v>
                </c:pt>
                <c:pt idx="28">
                  <c:v>59476</c:v>
                </c:pt>
                <c:pt idx="29">
                  <c:v>59146</c:v>
                </c:pt>
                <c:pt idx="30">
                  <c:v>59108</c:v>
                </c:pt>
                <c:pt idx="31">
                  <c:v>59104</c:v>
                </c:pt>
                <c:pt idx="32">
                  <c:v>59165</c:v>
                </c:pt>
                <c:pt idx="33">
                  <c:v>61021</c:v>
                </c:pt>
                <c:pt idx="34">
                  <c:v>57953</c:v>
                </c:pt>
                <c:pt idx="35">
                  <c:v>6011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C-859C-4CDA-B307-A2E7EE1D40F8}"/>
            </c:ext>
          </c:extLst>
        </c:ser>
        <c:ser>
          <c:idx val="13"/>
          <c:order val="13"/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Q$42:$Q$77</c:f>
              <c:numCache>
                <c:formatCode>General</c:formatCode>
                <c:ptCount val="36"/>
                <c:pt idx="0">
                  <c:v>59895</c:v>
                </c:pt>
                <c:pt idx="1">
                  <c:v>58654</c:v>
                </c:pt>
                <c:pt idx="2">
                  <c:v>57217</c:v>
                </c:pt>
                <c:pt idx="3">
                  <c:v>58732</c:v>
                </c:pt>
                <c:pt idx="4">
                  <c:v>58408</c:v>
                </c:pt>
                <c:pt idx="5">
                  <c:v>57773</c:v>
                </c:pt>
                <c:pt idx="6">
                  <c:v>60754</c:v>
                </c:pt>
                <c:pt idx="7">
                  <c:v>59082</c:v>
                </c:pt>
                <c:pt idx="8">
                  <c:v>54813</c:v>
                </c:pt>
                <c:pt idx="9">
                  <c:v>58919</c:v>
                </c:pt>
                <c:pt idx="10">
                  <c:v>55511</c:v>
                </c:pt>
                <c:pt idx="11">
                  <c:v>58507</c:v>
                </c:pt>
                <c:pt idx="12">
                  <c:v>58258</c:v>
                </c:pt>
                <c:pt idx="13">
                  <c:v>59174</c:v>
                </c:pt>
                <c:pt idx="14">
                  <c:v>58818</c:v>
                </c:pt>
                <c:pt idx="15">
                  <c:v>55903</c:v>
                </c:pt>
                <c:pt idx="16">
                  <c:v>57532</c:v>
                </c:pt>
                <c:pt idx="17">
                  <c:v>59273</c:v>
                </c:pt>
                <c:pt idx="18">
                  <c:v>55793</c:v>
                </c:pt>
                <c:pt idx="19">
                  <c:v>61133</c:v>
                </c:pt>
                <c:pt idx="20">
                  <c:v>58340</c:v>
                </c:pt>
                <c:pt idx="21">
                  <c:v>58904</c:v>
                </c:pt>
                <c:pt idx="22">
                  <c:v>57086</c:v>
                </c:pt>
                <c:pt idx="23">
                  <c:v>54795</c:v>
                </c:pt>
                <c:pt idx="24">
                  <c:v>57610</c:v>
                </c:pt>
                <c:pt idx="25">
                  <c:v>56182</c:v>
                </c:pt>
                <c:pt idx="26">
                  <c:v>55411</c:v>
                </c:pt>
                <c:pt idx="27">
                  <c:v>54918</c:v>
                </c:pt>
                <c:pt idx="28">
                  <c:v>55449</c:v>
                </c:pt>
                <c:pt idx="29">
                  <c:v>58199</c:v>
                </c:pt>
                <c:pt idx="30">
                  <c:v>58092</c:v>
                </c:pt>
                <c:pt idx="31">
                  <c:v>57071</c:v>
                </c:pt>
                <c:pt idx="32">
                  <c:v>59514</c:v>
                </c:pt>
                <c:pt idx="33">
                  <c:v>58587</c:v>
                </c:pt>
                <c:pt idx="34">
                  <c:v>60554</c:v>
                </c:pt>
                <c:pt idx="35">
                  <c:v>5663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D-859C-4CDA-B307-A2E7EE1D40F8}"/>
            </c:ext>
          </c:extLst>
        </c:ser>
        <c:ser>
          <c:idx val="14"/>
          <c:order val="14"/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5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R$42:$R$77</c:f>
              <c:numCache>
                <c:formatCode>General</c:formatCode>
                <c:ptCount val="36"/>
                <c:pt idx="0">
                  <c:v>53772</c:v>
                </c:pt>
                <c:pt idx="1">
                  <c:v>53028</c:v>
                </c:pt>
                <c:pt idx="2">
                  <c:v>51752</c:v>
                </c:pt>
                <c:pt idx="3">
                  <c:v>52410</c:v>
                </c:pt>
                <c:pt idx="4">
                  <c:v>52283</c:v>
                </c:pt>
                <c:pt idx="5">
                  <c:v>52710</c:v>
                </c:pt>
                <c:pt idx="6">
                  <c:v>51936</c:v>
                </c:pt>
                <c:pt idx="7">
                  <c:v>53244</c:v>
                </c:pt>
                <c:pt idx="8">
                  <c:v>51251</c:v>
                </c:pt>
                <c:pt idx="9">
                  <c:v>53804</c:v>
                </c:pt>
                <c:pt idx="10">
                  <c:v>53775</c:v>
                </c:pt>
                <c:pt idx="11">
                  <c:v>50002</c:v>
                </c:pt>
                <c:pt idx="12">
                  <c:v>49695</c:v>
                </c:pt>
                <c:pt idx="13">
                  <c:v>56049</c:v>
                </c:pt>
                <c:pt idx="14">
                  <c:v>51084</c:v>
                </c:pt>
                <c:pt idx="15">
                  <c:v>52545</c:v>
                </c:pt>
                <c:pt idx="16">
                  <c:v>54438</c:v>
                </c:pt>
                <c:pt idx="17">
                  <c:v>49364</c:v>
                </c:pt>
                <c:pt idx="18">
                  <c:v>53336</c:v>
                </c:pt>
                <c:pt idx="19">
                  <c:v>47799</c:v>
                </c:pt>
                <c:pt idx="20">
                  <c:v>53970</c:v>
                </c:pt>
                <c:pt idx="21">
                  <c:v>51916</c:v>
                </c:pt>
                <c:pt idx="22">
                  <c:v>50682</c:v>
                </c:pt>
                <c:pt idx="23">
                  <c:v>49824</c:v>
                </c:pt>
                <c:pt idx="24">
                  <c:v>52422</c:v>
                </c:pt>
                <c:pt idx="25">
                  <c:v>52587</c:v>
                </c:pt>
                <c:pt idx="26">
                  <c:v>53856</c:v>
                </c:pt>
                <c:pt idx="27">
                  <c:v>55400</c:v>
                </c:pt>
                <c:pt idx="28">
                  <c:v>51774</c:v>
                </c:pt>
                <c:pt idx="29">
                  <c:v>51146</c:v>
                </c:pt>
                <c:pt idx="30">
                  <c:v>55762</c:v>
                </c:pt>
                <c:pt idx="31">
                  <c:v>49402</c:v>
                </c:pt>
                <c:pt idx="32">
                  <c:v>53038</c:v>
                </c:pt>
                <c:pt idx="33">
                  <c:v>52342</c:v>
                </c:pt>
                <c:pt idx="34">
                  <c:v>54871</c:v>
                </c:pt>
                <c:pt idx="35">
                  <c:v>5271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E-859C-4CDA-B307-A2E7EE1D40F8}"/>
            </c:ext>
          </c:extLst>
        </c:ser>
        <c:ser>
          <c:idx val="15"/>
          <c:order val="15"/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S$42:$S$77</c:f>
              <c:numCache>
                <c:formatCode>General</c:formatCode>
                <c:ptCount val="36"/>
                <c:pt idx="0">
                  <c:v>41920</c:v>
                </c:pt>
                <c:pt idx="1">
                  <c:v>43196</c:v>
                </c:pt>
                <c:pt idx="2">
                  <c:v>41715</c:v>
                </c:pt>
                <c:pt idx="3">
                  <c:v>42263</c:v>
                </c:pt>
                <c:pt idx="4">
                  <c:v>42744</c:v>
                </c:pt>
                <c:pt idx="5">
                  <c:v>45170</c:v>
                </c:pt>
                <c:pt idx="6">
                  <c:v>44183</c:v>
                </c:pt>
                <c:pt idx="7">
                  <c:v>44610</c:v>
                </c:pt>
                <c:pt idx="8">
                  <c:v>44648</c:v>
                </c:pt>
                <c:pt idx="9">
                  <c:v>44100</c:v>
                </c:pt>
                <c:pt idx="10">
                  <c:v>43243</c:v>
                </c:pt>
                <c:pt idx="11">
                  <c:v>42249</c:v>
                </c:pt>
                <c:pt idx="12">
                  <c:v>43660</c:v>
                </c:pt>
                <c:pt idx="13">
                  <c:v>41893</c:v>
                </c:pt>
                <c:pt idx="14">
                  <c:v>44439</c:v>
                </c:pt>
                <c:pt idx="15">
                  <c:v>42190</c:v>
                </c:pt>
                <c:pt idx="16">
                  <c:v>45752</c:v>
                </c:pt>
                <c:pt idx="17">
                  <c:v>43795</c:v>
                </c:pt>
                <c:pt idx="18">
                  <c:v>42735</c:v>
                </c:pt>
                <c:pt idx="19">
                  <c:v>44060</c:v>
                </c:pt>
                <c:pt idx="20">
                  <c:v>44209</c:v>
                </c:pt>
                <c:pt idx="21">
                  <c:v>43387</c:v>
                </c:pt>
                <c:pt idx="22">
                  <c:v>42550</c:v>
                </c:pt>
                <c:pt idx="23">
                  <c:v>41505</c:v>
                </c:pt>
                <c:pt idx="24">
                  <c:v>44087</c:v>
                </c:pt>
                <c:pt idx="25">
                  <c:v>44685</c:v>
                </c:pt>
                <c:pt idx="26">
                  <c:v>44665</c:v>
                </c:pt>
                <c:pt idx="27">
                  <c:v>45815</c:v>
                </c:pt>
                <c:pt idx="28">
                  <c:v>44230</c:v>
                </c:pt>
                <c:pt idx="29">
                  <c:v>40551</c:v>
                </c:pt>
                <c:pt idx="30">
                  <c:v>43918</c:v>
                </c:pt>
                <c:pt idx="31">
                  <c:v>41774</c:v>
                </c:pt>
                <c:pt idx="32">
                  <c:v>42498</c:v>
                </c:pt>
                <c:pt idx="33">
                  <c:v>45368</c:v>
                </c:pt>
                <c:pt idx="34">
                  <c:v>42401</c:v>
                </c:pt>
                <c:pt idx="35">
                  <c:v>4173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F-859C-4CDA-B307-A2E7EE1D40F8}"/>
            </c:ext>
          </c:extLst>
        </c:ser>
        <c:ser>
          <c:idx val="16"/>
          <c:order val="16"/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T$42:$T$77</c:f>
              <c:numCache>
                <c:formatCode>General</c:formatCode>
                <c:ptCount val="36"/>
                <c:pt idx="0">
                  <c:v>49974</c:v>
                </c:pt>
                <c:pt idx="1">
                  <c:v>51491</c:v>
                </c:pt>
                <c:pt idx="2">
                  <c:v>47826</c:v>
                </c:pt>
                <c:pt idx="3">
                  <c:v>46813</c:v>
                </c:pt>
                <c:pt idx="4">
                  <c:v>49680</c:v>
                </c:pt>
                <c:pt idx="5">
                  <c:v>46144</c:v>
                </c:pt>
                <c:pt idx="6">
                  <c:v>50404</c:v>
                </c:pt>
                <c:pt idx="7">
                  <c:v>48671</c:v>
                </c:pt>
                <c:pt idx="8">
                  <c:v>47268</c:v>
                </c:pt>
                <c:pt idx="9">
                  <c:v>49504</c:v>
                </c:pt>
                <c:pt idx="10">
                  <c:v>48056</c:v>
                </c:pt>
                <c:pt idx="11">
                  <c:v>49129</c:v>
                </c:pt>
                <c:pt idx="12">
                  <c:v>52000</c:v>
                </c:pt>
                <c:pt idx="13">
                  <c:v>49471</c:v>
                </c:pt>
                <c:pt idx="14">
                  <c:v>47886</c:v>
                </c:pt>
                <c:pt idx="15">
                  <c:v>46049</c:v>
                </c:pt>
                <c:pt idx="16">
                  <c:v>49791</c:v>
                </c:pt>
                <c:pt idx="17">
                  <c:v>48033</c:v>
                </c:pt>
                <c:pt idx="18">
                  <c:v>47376</c:v>
                </c:pt>
                <c:pt idx="19">
                  <c:v>45365</c:v>
                </c:pt>
                <c:pt idx="20">
                  <c:v>46306</c:v>
                </c:pt>
                <c:pt idx="21">
                  <c:v>47810</c:v>
                </c:pt>
                <c:pt idx="22">
                  <c:v>46868</c:v>
                </c:pt>
                <c:pt idx="23">
                  <c:v>47350</c:v>
                </c:pt>
                <c:pt idx="24">
                  <c:v>47103</c:v>
                </c:pt>
                <c:pt idx="25">
                  <c:v>49338</c:v>
                </c:pt>
                <c:pt idx="26">
                  <c:v>48858</c:v>
                </c:pt>
                <c:pt idx="27">
                  <c:v>47189</c:v>
                </c:pt>
                <c:pt idx="28">
                  <c:v>48551</c:v>
                </c:pt>
                <c:pt idx="29">
                  <c:v>47007</c:v>
                </c:pt>
                <c:pt idx="30">
                  <c:v>49898</c:v>
                </c:pt>
                <c:pt idx="31">
                  <c:v>46724</c:v>
                </c:pt>
                <c:pt idx="32">
                  <c:v>47423</c:v>
                </c:pt>
                <c:pt idx="33">
                  <c:v>47816</c:v>
                </c:pt>
                <c:pt idx="34">
                  <c:v>45608</c:v>
                </c:pt>
                <c:pt idx="35">
                  <c:v>4869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10-859C-4CDA-B307-A2E7EE1D40F8}"/>
            </c:ext>
          </c:extLst>
        </c:ser>
        <c:ser>
          <c:idx val="17"/>
          <c:order val="17"/>
          <c:spPr>
            <a:ln w="1905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bg1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2021.05.04'!$C$42:$C$77</c:f>
              <c:numCache>
                <c:formatCode>General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xVal>
          <c:yVal>
            <c:numRef>
              <c:f>'2021.05.04'!$U$42:$U$77</c:f>
              <c:numCache>
                <c:formatCode>General</c:formatCode>
                <c:ptCount val="36"/>
                <c:pt idx="0">
                  <c:v>45689</c:v>
                </c:pt>
                <c:pt idx="1">
                  <c:v>46779</c:v>
                </c:pt>
                <c:pt idx="2">
                  <c:v>45334</c:v>
                </c:pt>
                <c:pt idx="3">
                  <c:v>44877</c:v>
                </c:pt>
                <c:pt idx="4">
                  <c:v>44695</c:v>
                </c:pt>
                <c:pt idx="5">
                  <c:v>44341</c:v>
                </c:pt>
                <c:pt idx="6">
                  <c:v>43432</c:v>
                </c:pt>
                <c:pt idx="7">
                  <c:v>46445</c:v>
                </c:pt>
                <c:pt idx="8">
                  <c:v>46722</c:v>
                </c:pt>
                <c:pt idx="9">
                  <c:v>47453</c:v>
                </c:pt>
                <c:pt idx="10">
                  <c:v>41873</c:v>
                </c:pt>
                <c:pt idx="11">
                  <c:v>44184</c:v>
                </c:pt>
                <c:pt idx="12">
                  <c:v>41446</c:v>
                </c:pt>
                <c:pt idx="13">
                  <c:v>43966</c:v>
                </c:pt>
                <c:pt idx="14">
                  <c:v>46635</c:v>
                </c:pt>
                <c:pt idx="15">
                  <c:v>47043</c:v>
                </c:pt>
                <c:pt idx="16">
                  <c:v>45118</c:v>
                </c:pt>
                <c:pt idx="17">
                  <c:v>47582</c:v>
                </c:pt>
                <c:pt idx="18">
                  <c:v>45288</c:v>
                </c:pt>
                <c:pt idx="19">
                  <c:v>44885</c:v>
                </c:pt>
                <c:pt idx="20">
                  <c:v>45485</c:v>
                </c:pt>
                <c:pt idx="21">
                  <c:v>44922</c:v>
                </c:pt>
                <c:pt idx="22">
                  <c:v>42975</c:v>
                </c:pt>
                <c:pt idx="23">
                  <c:v>46421</c:v>
                </c:pt>
                <c:pt idx="24">
                  <c:v>44292</c:v>
                </c:pt>
                <c:pt idx="25">
                  <c:v>43216</c:v>
                </c:pt>
                <c:pt idx="26">
                  <c:v>45945</c:v>
                </c:pt>
                <c:pt idx="27">
                  <c:v>45601</c:v>
                </c:pt>
                <c:pt idx="28">
                  <c:v>44090</c:v>
                </c:pt>
                <c:pt idx="29">
                  <c:v>44511</c:v>
                </c:pt>
                <c:pt idx="30">
                  <c:v>45373</c:v>
                </c:pt>
                <c:pt idx="31">
                  <c:v>43225</c:v>
                </c:pt>
                <c:pt idx="32">
                  <c:v>42296</c:v>
                </c:pt>
                <c:pt idx="33">
                  <c:v>45695</c:v>
                </c:pt>
                <c:pt idx="34">
                  <c:v>42686</c:v>
                </c:pt>
                <c:pt idx="35">
                  <c:v>4371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11-859C-4CDA-B307-A2E7EE1D40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35952"/>
        <c:axId val="227132688"/>
      </c:scatterChart>
      <c:valAx>
        <c:axId val="227135952"/>
        <c:scaling>
          <c:orientation val="minMax"/>
          <c:max val="3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dirty="0"/>
                  <a:t>Time (se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2688"/>
        <c:crosses val="autoZero"/>
        <c:crossBetween val="midCat"/>
      </c:valAx>
      <c:valAx>
        <c:axId val="2271326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5952"/>
        <c:crosses val="autoZero"/>
        <c:crossBetween val="midCat"/>
        <c:dispUnits>
          <c:builtInUnit val="tenThousands"/>
        </c:dispUnits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N$6:$N$9</c:f>
              <c:strCache>
                <c:ptCount val="4"/>
                <c:pt idx="0">
                  <c:v>CHO WT</c:v>
                </c:pt>
                <c:pt idx="1">
                  <c:v>plasmid</c:v>
                </c:pt>
                <c:pt idx="2">
                  <c:v>210 kb BAC</c:v>
                </c:pt>
                <c:pt idx="3">
                  <c:v>70 kb BAC</c:v>
                </c:pt>
              </c:strCache>
            </c:strRef>
          </c:cat>
          <c:val>
            <c:numRef>
              <c:f>Sheet1!$O$6:$O$9</c:f>
              <c:numCache>
                <c:formatCode>#\ ##0.0</c:formatCode>
                <c:ptCount val="4"/>
                <c:pt idx="0">
                  <c:v>0</c:v>
                </c:pt>
                <c:pt idx="1">
                  <c:v>17.079999999999998</c:v>
                </c:pt>
                <c:pt idx="2">
                  <c:v>4.13</c:v>
                </c:pt>
                <c:pt idx="3">
                  <c:v>11.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27133232"/>
        <c:axId val="2109512512"/>
      </c:barChart>
      <c:catAx>
        <c:axId val="227133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09512512"/>
        <c:crosses val="autoZero"/>
        <c:auto val="1"/>
        <c:lblAlgn val="ctr"/>
        <c:lblOffset val="100"/>
        <c:noMultiLvlLbl val="0"/>
      </c:catAx>
      <c:valAx>
        <c:axId val="21095125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hu-HU" sz="1100"/>
                  <a:t>GFP + cells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\ 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3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0" i="0" u="none" strike="noStrike" baseline="0">
                <a:effectLst/>
              </a:rPr>
              <a:t>MIODOGGB</a:t>
            </a:r>
            <a:endParaRPr lang="hu-HU"/>
          </a:p>
        </c:rich>
      </c:tx>
      <c:layout>
        <c:manualLayout>
          <c:xMode val="edge"/>
          <c:yMode val="edge"/>
          <c:x val="0.1203662636537660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8001511698382254E-2"/>
          <c:y val="3.2293981481481479E-2"/>
          <c:w val="0.83890396107216669"/>
          <c:h val="0.83367546296296291"/>
        </c:manualLayout>
      </c:layout>
      <c:lineChart>
        <c:grouping val="standard"/>
        <c:varyColors val="0"/>
        <c:ser>
          <c:idx val="0"/>
          <c:order val="0"/>
          <c:spPr>
            <a:ln w="19050" cap="rnd" cmpd="sng">
              <a:solidFill>
                <a:srgbClr val="FFC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C$69:$C$104</c:f>
              <c:numCache>
                <c:formatCode>General</c:formatCode>
                <c:ptCount val="36"/>
                <c:pt idx="0">
                  <c:v>50804</c:v>
                </c:pt>
                <c:pt idx="1">
                  <c:v>54076</c:v>
                </c:pt>
                <c:pt idx="2">
                  <c:v>51221</c:v>
                </c:pt>
                <c:pt idx="3">
                  <c:v>52376</c:v>
                </c:pt>
                <c:pt idx="4">
                  <c:v>50941</c:v>
                </c:pt>
                <c:pt idx="5">
                  <c:v>59035</c:v>
                </c:pt>
                <c:pt idx="6">
                  <c:v>109361</c:v>
                </c:pt>
                <c:pt idx="7">
                  <c:v>144621</c:v>
                </c:pt>
                <c:pt idx="8">
                  <c:v>167213</c:v>
                </c:pt>
                <c:pt idx="9">
                  <c:v>174942</c:v>
                </c:pt>
                <c:pt idx="10">
                  <c:v>182927</c:v>
                </c:pt>
                <c:pt idx="11">
                  <c:v>185078</c:v>
                </c:pt>
                <c:pt idx="12">
                  <c:v>188757</c:v>
                </c:pt>
                <c:pt idx="13">
                  <c:v>191643</c:v>
                </c:pt>
                <c:pt idx="14">
                  <c:v>203661</c:v>
                </c:pt>
                <c:pt idx="15">
                  <c:v>202866</c:v>
                </c:pt>
                <c:pt idx="16">
                  <c:v>201770</c:v>
                </c:pt>
                <c:pt idx="17">
                  <c:v>207547</c:v>
                </c:pt>
                <c:pt idx="18">
                  <c:v>202055</c:v>
                </c:pt>
                <c:pt idx="19">
                  <c:v>210978</c:v>
                </c:pt>
                <c:pt idx="20">
                  <c:v>206298</c:v>
                </c:pt>
                <c:pt idx="21">
                  <c:v>209070</c:v>
                </c:pt>
                <c:pt idx="22">
                  <c:v>202233</c:v>
                </c:pt>
                <c:pt idx="23">
                  <c:v>211357</c:v>
                </c:pt>
                <c:pt idx="24">
                  <c:v>204885</c:v>
                </c:pt>
                <c:pt idx="25">
                  <c:v>213095</c:v>
                </c:pt>
                <c:pt idx="26">
                  <c:v>209360</c:v>
                </c:pt>
                <c:pt idx="27">
                  <c:v>204786</c:v>
                </c:pt>
                <c:pt idx="28">
                  <c:v>204664</c:v>
                </c:pt>
                <c:pt idx="29">
                  <c:v>204369</c:v>
                </c:pt>
                <c:pt idx="30">
                  <c:v>199507</c:v>
                </c:pt>
                <c:pt idx="31">
                  <c:v>197977</c:v>
                </c:pt>
                <c:pt idx="32">
                  <c:v>201959</c:v>
                </c:pt>
                <c:pt idx="33">
                  <c:v>200022</c:v>
                </c:pt>
                <c:pt idx="34">
                  <c:v>199736</c:v>
                </c:pt>
                <c:pt idx="35">
                  <c:v>20090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252-4384-9D7D-4ED8E1B54CAD}"/>
            </c:ext>
          </c:extLst>
        </c:ser>
        <c:ser>
          <c:idx val="1"/>
          <c:order val="1"/>
          <c:spPr>
            <a:ln w="19050" cap="rnd" cmpd="sng">
              <a:solidFill>
                <a:srgbClr val="FFC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D$69:$D$104</c:f>
              <c:numCache>
                <c:formatCode>General</c:formatCode>
                <c:ptCount val="36"/>
                <c:pt idx="0">
                  <c:v>52335</c:v>
                </c:pt>
                <c:pt idx="1">
                  <c:v>52022</c:v>
                </c:pt>
                <c:pt idx="2">
                  <c:v>51271</c:v>
                </c:pt>
                <c:pt idx="3">
                  <c:v>51276</c:v>
                </c:pt>
                <c:pt idx="4">
                  <c:v>53650</c:v>
                </c:pt>
                <c:pt idx="5">
                  <c:v>60436</c:v>
                </c:pt>
                <c:pt idx="6">
                  <c:v>124353</c:v>
                </c:pt>
                <c:pt idx="7">
                  <c:v>163234</c:v>
                </c:pt>
                <c:pt idx="8">
                  <c:v>185345</c:v>
                </c:pt>
                <c:pt idx="9">
                  <c:v>194949</c:v>
                </c:pt>
                <c:pt idx="10">
                  <c:v>199134</c:v>
                </c:pt>
                <c:pt idx="11">
                  <c:v>199407</c:v>
                </c:pt>
                <c:pt idx="12">
                  <c:v>200084</c:v>
                </c:pt>
                <c:pt idx="13">
                  <c:v>213372</c:v>
                </c:pt>
                <c:pt idx="14">
                  <c:v>203290</c:v>
                </c:pt>
                <c:pt idx="15">
                  <c:v>203216</c:v>
                </c:pt>
                <c:pt idx="16">
                  <c:v>207253</c:v>
                </c:pt>
                <c:pt idx="17">
                  <c:v>210365</c:v>
                </c:pt>
                <c:pt idx="18">
                  <c:v>212891</c:v>
                </c:pt>
                <c:pt idx="19">
                  <c:v>211989</c:v>
                </c:pt>
                <c:pt idx="20">
                  <c:v>210406</c:v>
                </c:pt>
                <c:pt idx="21">
                  <c:v>204028</c:v>
                </c:pt>
                <c:pt idx="22">
                  <c:v>215522</c:v>
                </c:pt>
                <c:pt idx="23">
                  <c:v>206990</c:v>
                </c:pt>
                <c:pt idx="24">
                  <c:v>208651</c:v>
                </c:pt>
                <c:pt idx="25">
                  <c:v>208201</c:v>
                </c:pt>
                <c:pt idx="26">
                  <c:v>207011</c:v>
                </c:pt>
                <c:pt idx="27">
                  <c:v>216089</c:v>
                </c:pt>
                <c:pt idx="28">
                  <c:v>207243</c:v>
                </c:pt>
                <c:pt idx="29">
                  <c:v>208628</c:v>
                </c:pt>
                <c:pt idx="30">
                  <c:v>208271</c:v>
                </c:pt>
                <c:pt idx="31">
                  <c:v>207561</c:v>
                </c:pt>
                <c:pt idx="32">
                  <c:v>204622</c:v>
                </c:pt>
                <c:pt idx="33">
                  <c:v>205498</c:v>
                </c:pt>
                <c:pt idx="34">
                  <c:v>201899</c:v>
                </c:pt>
                <c:pt idx="35">
                  <c:v>20451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252-4384-9D7D-4ED8E1B54CAD}"/>
            </c:ext>
          </c:extLst>
        </c:ser>
        <c:ser>
          <c:idx val="2"/>
          <c:order val="2"/>
          <c:spPr>
            <a:ln w="19050" cap="rnd" cmpd="sng">
              <a:solidFill>
                <a:srgbClr val="FFC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E$69:$E$104</c:f>
              <c:numCache>
                <c:formatCode>General</c:formatCode>
                <c:ptCount val="36"/>
                <c:pt idx="0">
                  <c:v>48043</c:v>
                </c:pt>
                <c:pt idx="1">
                  <c:v>47371</c:v>
                </c:pt>
                <c:pt idx="2">
                  <c:v>47584</c:v>
                </c:pt>
                <c:pt idx="3">
                  <c:v>47212</c:v>
                </c:pt>
                <c:pt idx="4">
                  <c:v>47954</c:v>
                </c:pt>
                <c:pt idx="5">
                  <c:v>53958</c:v>
                </c:pt>
                <c:pt idx="6">
                  <c:v>120697</c:v>
                </c:pt>
                <c:pt idx="7">
                  <c:v>164650</c:v>
                </c:pt>
                <c:pt idx="8">
                  <c:v>181045</c:v>
                </c:pt>
                <c:pt idx="9">
                  <c:v>193989</c:v>
                </c:pt>
                <c:pt idx="10">
                  <c:v>188220</c:v>
                </c:pt>
                <c:pt idx="11">
                  <c:v>188530</c:v>
                </c:pt>
                <c:pt idx="12">
                  <c:v>192567</c:v>
                </c:pt>
                <c:pt idx="13">
                  <c:v>193266</c:v>
                </c:pt>
                <c:pt idx="14">
                  <c:v>192918</c:v>
                </c:pt>
                <c:pt idx="15">
                  <c:v>196035</c:v>
                </c:pt>
                <c:pt idx="16">
                  <c:v>192510</c:v>
                </c:pt>
                <c:pt idx="17">
                  <c:v>193577</c:v>
                </c:pt>
                <c:pt idx="18">
                  <c:v>197130</c:v>
                </c:pt>
                <c:pt idx="19">
                  <c:v>195427</c:v>
                </c:pt>
                <c:pt idx="20">
                  <c:v>192851</c:v>
                </c:pt>
                <c:pt idx="21">
                  <c:v>192723</c:v>
                </c:pt>
                <c:pt idx="22">
                  <c:v>197976</c:v>
                </c:pt>
                <c:pt idx="23">
                  <c:v>201041</c:v>
                </c:pt>
                <c:pt idx="24">
                  <c:v>195700</c:v>
                </c:pt>
                <c:pt idx="25">
                  <c:v>188467</c:v>
                </c:pt>
                <c:pt idx="26">
                  <c:v>187972</c:v>
                </c:pt>
                <c:pt idx="27">
                  <c:v>190123</c:v>
                </c:pt>
                <c:pt idx="28">
                  <c:v>190532</c:v>
                </c:pt>
                <c:pt idx="29">
                  <c:v>198588</c:v>
                </c:pt>
                <c:pt idx="30">
                  <c:v>193604</c:v>
                </c:pt>
                <c:pt idx="31">
                  <c:v>191193</c:v>
                </c:pt>
                <c:pt idx="32">
                  <c:v>194432</c:v>
                </c:pt>
                <c:pt idx="33">
                  <c:v>192477</c:v>
                </c:pt>
                <c:pt idx="34">
                  <c:v>192806</c:v>
                </c:pt>
                <c:pt idx="35">
                  <c:v>19267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252-4384-9D7D-4ED8E1B54CAD}"/>
            </c:ext>
          </c:extLst>
        </c:ser>
        <c:ser>
          <c:idx val="3"/>
          <c:order val="3"/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F$69:$F$104</c:f>
              <c:numCache>
                <c:formatCode>General</c:formatCode>
                <c:ptCount val="36"/>
                <c:pt idx="0">
                  <c:v>26338</c:v>
                </c:pt>
                <c:pt idx="1">
                  <c:v>27239</c:v>
                </c:pt>
                <c:pt idx="2">
                  <c:v>27803</c:v>
                </c:pt>
                <c:pt idx="3">
                  <c:v>25490</c:v>
                </c:pt>
                <c:pt idx="4">
                  <c:v>27423</c:v>
                </c:pt>
                <c:pt idx="5">
                  <c:v>28235</c:v>
                </c:pt>
                <c:pt idx="6">
                  <c:v>29725</c:v>
                </c:pt>
                <c:pt idx="7">
                  <c:v>29559</c:v>
                </c:pt>
                <c:pt idx="8">
                  <c:v>30146</c:v>
                </c:pt>
                <c:pt idx="9">
                  <c:v>29423</c:v>
                </c:pt>
                <c:pt idx="10">
                  <c:v>28588</c:v>
                </c:pt>
                <c:pt idx="11">
                  <c:v>32279</c:v>
                </c:pt>
                <c:pt idx="12">
                  <c:v>30921</c:v>
                </c:pt>
                <c:pt idx="13">
                  <c:v>29275</c:v>
                </c:pt>
                <c:pt idx="14">
                  <c:v>28764</c:v>
                </c:pt>
                <c:pt idx="15">
                  <c:v>30490</c:v>
                </c:pt>
                <c:pt idx="16">
                  <c:v>30007</c:v>
                </c:pt>
                <c:pt idx="17">
                  <c:v>30005</c:v>
                </c:pt>
                <c:pt idx="18">
                  <c:v>28127</c:v>
                </c:pt>
                <c:pt idx="19">
                  <c:v>28262</c:v>
                </c:pt>
                <c:pt idx="20">
                  <c:v>28218</c:v>
                </c:pt>
                <c:pt idx="21">
                  <c:v>28915</c:v>
                </c:pt>
                <c:pt idx="22">
                  <c:v>32133</c:v>
                </c:pt>
                <c:pt idx="23">
                  <c:v>29559</c:v>
                </c:pt>
                <c:pt idx="24">
                  <c:v>28854</c:v>
                </c:pt>
                <c:pt idx="25">
                  <c:v>30472</c:v>
                </c:pt>
                <c:pt idx="26">
                  <c:v>30747</c:v>
                </c:pt>
                <c:pt idx="27">
                  <c:v>29387</c:v>
                </c:pt>
                <c:pt idx="28">
                  <c:v>31203</c:v>
                </c:pt>
                <c:pt idx="29">
                  <c:v>30571</c:v>
                </c:pt>
                <c:pt idx="30">
                  <c:v>29284</c:v>
                </c:pt>
                <c:pt idx="31">
                  <c:v>29828</c:v>
                </c:pt>
                <c:pt idx="32">
                  <c:v>28874</c:v>
                </c:pt>
                <c:pt idx="33">
                  <c:v>30871</c:v>
                </c:pt>
                <c:pt idx="34">
                  <c:v>3079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252-4384-9D7D-4ED8E1B54CAD}"/>
            </c:ext>
          </c:extLst>
        </c:ser>
        <c:ser>
          <c:idx val="4"/>
          <c:order val="4"/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G$69:$G$104</c:f>
              <c:numCache>
                <c:formatCode>General</c:formatCode>
                <c:ptCount val="36"/>
                <c:pt idx="0">
                  <c:v>29492</c:v>
                </c:pt>
                <c:pt idx="1">
                  <c:v>29223</c:v>
                </c:pt>
                <c:pt idx="2">
                  <c:v>28504</c:v>
                </c:pt>
                <c:pt idx="3">
                  <c:v>28178</c:v>
                </c:pt>
                <c:pt idx="4">
                  <c:v>28463</c:v>
                </c:pt>
                <c:pt idx="5">
                  <c:v>30229</c:v>
                </c:pt>
                <c:pt idx="6">
                  <c:v>31001</c:v>
                </c:pt>
                <c:pt idx="7">
                  <c:v>28686</c:v>
                </c:pt>
                <c:pt idx="8">
                  <c:v>29079</c:v>
                </c:pt>
                <c:pt idx="9">
                  <c:v>27872</c:v>
                </c:pt>
                <c:pt idx="10">
                  <c:v>31342</c:v>
                </c:pt>
                <c:pt idx="11">
                  <c:v>32502</c:v>
                </c:pt>
                <c:pt idx="12">
                  <c:v>30178</c:v>
                </c:pt>
                <c:pt idx="13">
                  <c:v>30108</c:v>
                </c:pt>
                <c:pt idx="14">
                  <c:v>29276</c:v>
                </c:pt>
                <c:pt idx="15">
                  <c:v>30966</c:v>
                </c:pt>
                <c:pt idx="16">
                  <c:v>30451</c:v>
                </c:pt>
                <c:pt idx="17">
                  <c:v>31080</c:v>
                </c:pt>
                <c:pt idx="18">
                  <c:v>31283</c:v>
                </c:pt>
                <c:pt idx="19">
                  <c:v>28951</c:v>
                </c:pt>
                <c:pt idx="20">
                  <c:v>29420</c:v>
                </c:pt>
                <c:pt idx="21">
                  <c:v>29600</c:v>
                </c:pt>
                <c:pt idx="22">
                  <c:v>29224</c:v>
                </c:pt>
                <c:pt idx="23">
                  <c:v>30839</c:v>
                </c:pt>
                <c:pt idx="24">
                  <c:v>28526</c:v>
                </c:pt>
                <c:pt idx="25">
                  <c:v>31014</c:v>
                </c:pt>
                <c:pt idx="26">
                  <c:v>31143</c:v>
                </c:pt>
                <c:pt idx="27">
                  <c:v>29095</c:v>
                </c:pt>
                <c:pt idx="28">
                  <c:v>32540</c:v>
                </c:pt>
                <c:pt idx="29">
                  <c:v>29732</c:v>
                </c:pt>
                <c:pt idx="30">
                  <c:v>32634</c:v>
                </c:pt>
                <c:pt idx="31">
                  <c:v>31247</c:v>
                </c:pt>
                <c:pt idx="32">
                  <c:v>30458</c:v>
                </c:pt>
                <c:pt idx="33">
                  <c:v>33431</c:v>
                </c:pt>
                <c:pt idx="34">
                  <c:v>2973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252-4384-9D7D-4ED8E1B54CAD}"/>
            </c:ext>
          </c:extLst>
        </c:ser>
        <c:ser>
          <c:idx val="5"/>
          <c:order val="5"/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H$69:$H$104</c:f>
              <c:numCache>
                <c:formatCode>General</c:formatCode>
                <c:ptCount val="36"/>
                <c:pt idx="0">
                  <c:v>25900</c:v>
                </c:pt>
                <c:pt idx="1">
                  <c:v>27404</c:v>
                </c:pt>
                <c:pt idx="2">
                  <c:v>25298</c:v>
                </c:pt>
                <c:pt idx="3">
                  <c:v>25566</c:v>
                </c:pt>
                <c:pt idx="4">
                  <c:v>26285</c:v>
                </c:pt>
                <c:pt idx="5">
                  <c:v>25516</c:v>
                </c:pt>
                <c:pt idx="6">
                  <c:v>26036</c:v>
                </c:pt>
                <c:pt idx="7">
                  <c:v>25084</c:v>
                </c:pt>
                <c:pt idx="8">
                  <c:v>27005</c:v>
                </c:pt>
                <c:pt idx="9">
                  <c:v>24016</c:v>
                </c:pt>
                <c:pt idx="10">
                  <c:v>24209</c:v>
                </c:pt>
                <c:pt idx="11">
                  <c:v>25979</c:v>
                </c:pt>
                <c:pt idx="12">
                  <c:v>26222</c:v>
                </c:pt>
                <c:pt idx="13">
                  <c:v>25893</c:v>
                </c:pt>
                <c:pt idx="14">
                  <c:v>27189</c:v>
                </c:pt>
                <c:pt idx="15">
                  <c:v>25057</c:v>
                </c:pt>
                <c:pt idx="16">
                  <c:v>27885</c:v>
                </c:pt>
                <c:pt idx="17">
                  <c:v>26656</c:v>
                </c:pt>
                <c:pt idx="18">
                  <c:v>25545</c:v>
                </c:pt>
                <c:pt idx="19">
                  <c:v>28163</c:v>
                </c:pt>
                <c:pt idx="20">
                  <c:v>24819</c:v>
                </c:pt>
                <c:pt idx="21">
                  <c:v>26752</c:v>
                </c:pt>
                <c:pt idx="22">
                  <c:v>26876</c:v>
                </c:pt>
                <c:pt idx="23">
                  <c:v>27216</c:v>
                </c:pt>
                <c:pt idx="24">
                  <c:v>27707</c:v>
                </c:pt>
                <c:pt idx="25">
                  <c:v>28282</c:v>
                </c:pt>
                <c:pt idx="26">
                  <c:v>26309</c:v>
                </c:pt>
                <c:pt idx="27">
                  <c:v>25925</c:v>
                </c:pt>
                <c:pt idx="28">
                  <c:v>25848</c:v>
                </c:pt>
                <c:pt idx="29">
                  <c:v>25476</c:v>
                </c:pt>
                <c:pt idx="30">
                  <c:v>27141</c:v>
                </c:pt>
                <c:pt idx="31">
                  <c:v>27938</c:v>
                </c:pt>
                <c:pt idx="32">
                  <c:v>26608</c:v>
                </c:pt>
                <c:pt idx="33">
                  <c:v>28433</c:v>
                </c:pt>
                <c:pt idx="34">
                  <c:v>2450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A252-4384-9D7D-4ED8E1B54CAD}"/>
            </c:ext>
          </c:extLst>
        </c:ser>
        <c:ser>
          <c:idx val="6"/>
          <c:order val="6"/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I$69:$I$104</c:f>
              <c:numCache>
                <c:formatCode>General</c:formatCode>
                <c:ptCount val="36"/>
                <c:pt idx="0">
                  <c:v>55363</c:v>
                </c:pt>
                <c:pt idx="1">
                  <c:v>58135</c:v>
                </c:pt>
                <c:pt idx="2">
                  <c:v>57146</c:v>
                </c:pt>
                <c:pt idx="3">
                  <c:v>56095</c:v>
                </c:pt>
                <c:pt idx="4">
                  <c:v>54439</c:v>
                </c:pt>
                <c:pt idx="5">
                  <c:v>61711</c:v>
                </c:pt>
                <c:pt idx="6">
                  <c:v>68611</c:v>
                </c:pt>
                <c:pt idx="7">
                  <c:v>89008</c:v>
                </c:pt>
                <c:pt idx="8">
                  <c:v>116221</c:v>
                </c:pt>
                <c:pt idx="9">
                  <c:v>134901</c:v>
                </c:pt>
                <c:pt idx="10">
                  <c:v>154969</c:v>
                </c:pt>
                <c:pt idx="11">
                  <c:v>172635</c:v>
                </c:pt>
                <c:pt idx="12">
                  <c:v>194118</c:v>
                </c:pt>
                <c:pt idx="13">
                  <c:v>200413</c:v>
                </c:pt>
                <c:pt idx="14">
                  <c:v>216473</c:v>
                </c:pt>
                <c:pt idx="15">
                  <c:v>217809</c:v>
                </c:pt>
                <c:pt idx="16">
                  <c:v>232632</c:v>
                </c:pt>
                <c:pt idx="17">
                  <c:v>239899</c:v>
                </c:pt>
                <c:pt idx="18">
                  <c:v>238517</c:v>
                </c:pt>
                <c:pt idx="19">
                  <c:v>233137</c:v>
                </c:pt>
                <c:pt idx="20">
                  <c:v>246840</c:v>
                </c:pt>
                <c:pt idx="21">
                  <c:v>244606</c:v>
                </c:pt>
                <c:pt idx="22">
                  <c:v>244776</c:v>
                </c:pt>
                <c:pt idx="23">
                  <c:v>241191</c:v>
                </c:pt>
                <c:pt idx="24">
                  <c:v>248493</c:v>
                </c:pt>
                <c:pt idx="25">
                  <c:v>246983</c:v>
                </c:pt>
                <c:pt idx="26">
                  <c:v>250598</c:v>
                </c:pt>
                <c:pt idx="27">
                  <c:v>240916</c:v>
                </c:pt>
                <c:pt idx="28">
                  <c:v>245353</c:v>
                </c:pt>
                <c:pt idx="29">
                  <c:v>249049</c:v>
                </c:pt>
                <c:pt idx="30">
                  <c:v>240548</c:v>
                </c:pt>
                <c:pt idx="31">
                  <c:v>243421</c:v>
                </c:pt>
                <c:pt idx="32">
                  <c:v>243743</c:v>
                </c:pt>
                <c:pt idx="33">
                  <c:v>238148</c:v>
                </c:pt>
                <c:pt idx="34">
                  <c:v>230027</c:v>
                </c:pt>
                <c:pt idx="35">
                  <c:v>23976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A252-4384-9D7D-4ED8E1B54CAD}"/>
            </c:ext>
          </c:extLst>
        </c:ser>
        <c:ser>
          <c:idx val="7"/>
          <c:order val="7"/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J$69:$J$104</c:f>
              <c:numCache>
                <c:formatCode>General</c:formatCode>
                <c:ptCount val="36"/>
                <c:pt idx="0">
                  <c:v>50960</c:v>
                </c:pt>
                <c:pt idx="1">
                  <c:v>51877</c:v>
                </c:pt>
                <c:pt idx="2">
                  <c:v>50830</c:v>
                </c:pt>
                <c:pt idx="3">
                  <c:v>49080</c:v>
                </c:pt>
                <c:pt idx="4">
                  <c:v>49198</c:v>
                </c:pt>
                <c:pt idx="5">
                  <c:v>50918</c:v>
                </c:pt>
                <c:pt idx="6">
                  <c:v>69781</c:v>
                </c:pt>
                <c:pt idx="7">
                  <c:v>92369</c:v>
                </c:pt>
                <c:pt idx="8">
                  <c:v>119400</c:v>
                </c:pt>
                <c:pt idx="9">
                  <c:v>138931</c:v>
                </c:pt>
                <c:pt idx="10">
                  <c:v>157097</c:v>
                </c:pt>
                <c:pt idx="11">
                  <c:v>164415</c:v>
                </c:pt>
                <c:pt idx="12">
                  <c:v>180614</c:v>
                </c:pt>
                <c:pt idx="13">
                  <c:v>190609</c:v>
                </c:pt>
                <c:pt idx="14">
                  <c:v>188885</c:v>
                </c:pt>
                <c:pt idx="15">
                  <c:v>192558</c:v>
                </c:pt>
                <c:pt idx="16">
                  <c:v>194904</c:v>
                </c:pt>
                <c:pt idx="17">
                  <c:v>201065</c:v>
                </c:pt>
                <c:pt idx="18">
                  <c:v>203250</c:v>
                </c:pt>
                <c:pt idx="19">
                  <c:v>200050</c:v>
                </c:pt>
                <c:pt idx="20">
                  <c:v>196905</c:v>
                </c:pt>
                <c:pt idx="21">
                  <c:v>204115</c:v>
                </c:pt>
                <c:pt idx="22">
                  <c:v>207857</c:v>
                </c:pt>
                <c:pt idx="23">
                  <c:v>200769</c:v>
                </c:pt>
                <c:pt idx="24">
                  <c:v>197567</c:v>
                </c:pt>
                <c:pt idx="25">
                  <c:v>196526</c:v>
                </c:pt>
                <c:pt idx="26">
                  <c:v>202552</c:v>
                </c:pt>
                <c:pt idx="27">
                  <c:v>198407</c:v>
                </c:pt>
                <c:pt idx="28">
                  <c:v>201875</c:v>
                </c:pt>
                <c:pt idx="29">
                  <c:v>201828</c:v>
                </c:pt>
                <c:pt idx="30">
                  <c:v>196092</c:v>
                </c:pt>
                <c:pt idx="31">
                  <c:v>190941</c:v>
                </c:pt>
                <c:pt idx="32">
                  <c:v>186996</c:v>
                </c:pt>
                <c:pt idx="33">
                  <c:v>192740</c:v>
                </c:pt>
                <c:pt idx="34">
                  <c:v>191392</c:v>
                </c:pt>
                <c:pt idx="35">
                  <c:v>18777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A252-4384-9D7D-4ED8E1B54CAD}"/>
            </c:ext>
          </c:extLst>
        </c:ser>
        <c:ser>
          <c:idx val="8"/>
          <c:order val="8"/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K$69:$K$104</c:f>
              <c:numCache>
                <c:formatCode>General</c:formatCode>
                <c:ptCount val="36"/>
                <c:pt idx="0">
                  <c:v>57957</c:v>
                </c:pt>
                <c:pt idx="1">
                  <c:v>60860</c:v>
                </c:pt>
                <c:pt idx="2">
                  <c:v>59915</c:v>
                </c:pt>
                <c:pt idx="3">
                  <c:v>57813</c:v>
                </c:pt>
                <c:pt idx="4">
                  <c:v>61085</c:v>
                </c:pt>
                <c:pt idx="5">
                  <c:v>61698</c:v>
                </c:pt>
                <c:pt idx="6">
                  <c:v>74508</c:v>
                </c:pt>
                <c:pt idx="7">
                  <c:v>96676</c:v>
                </c:pt>
                <c:pt idx="8">
                  <c:v>115242</c:v>
                </c:pt>
                <c:pt idx="9">
                  <c:v>147432</c:v>
                </c:pt>
                <c:pt idx="10">
                  <c:v>164217</c:v>
                </c:pt>
                <c:pt idx="11">
                  <c:v>176014</c:v>
                </c:pt>
                <c:pt idx="12">
                  <c:v>198177</c:v>
                </c:pt>
                <c:pt idx="13">
                  <c:v>208142</c:v>
                </c:pt>
                <c:pt idx="14">
                  <c:v>212620</c:v>
                </c:pt>
                <c:pt idx="15">
                  <c:v>218773</c:v>
                </c:pt>
                <c:pt idx="16">
                  <c:v>223608</c:v>
                </c:pt>
                <c:pt idx="17">
                  <c:v>231245</c:v>
                </c:pt>
                <c:pt idx="18">
                  <c:v>235699</c:v>
                </c:pt>
                <c:pt idx="19">
                  <c:v>233863</c:v>
                </c:pt>
                <c:pt idx="20">
                  <c:v>232516</c:v>
                </c:pt>
                <c:pt idx="21">
                  <c:v>239984</c:v>
                </c:pt>
                <c:pt idx="22">
                  <c:v>246952</c:v>
                </c:pt>
                <c:pt idx="23">
                  <c:v>244030</c:v>
                </c:pt>
                <c:pt idx="24">
                  <c:v>232157</c:v>
                </c:pt>
                <c:pt idx="25">
                  <c:v>236461</c:v>
                </c:pt>
                <c:pt idx="26">
                  <c:v>233483</c:v>
                </c:pt>
                <c:pt idx="27">
                  <c:v>232926</c:v>
                </c:pt>
                <c:pt idx="28">
                  <c:v>230033</c:v>
                </c:pt>
                <c:pt idx="29">
                  <c:v>232683</c:v>
                </c:pt>
                <c:pt idx="30">
                  <c:v>230165</c:v>
                </c:pt>
                <c:pt idx="31">
                  <c:v>230853</c:v>
                </c:pt>
                <c:pt idx="32">
                  <c:v>225494</c:v>
                </c:pt>
                <c:pt idx="33">
                  <c:v>225347</c:v>
                </c:pt>
                <c:pt idx="34">
                  <c:v>223531</c:v>
                </c:pt>
                <c:pt idx="35">
                  <c:v>21622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A252-4384-9D7D-4ED8E1B54CAD}"/>
            </c:ext>
          </c:extLst>
        </c:ser>
        <c:ser>
          <c:idx val="9"/>
          <c:order val="9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L$69:$L$104</c:f>
              <c:numCache>
                <c:formatCode>General</c:formatCode>
                <c:ptCount val="36"/>
                <c:pt idx="0">
                  <c:v>29605</c:v>
                </c:pt>
                <c:pt idx="1">
                  <c:v>31507</c:v>
                </c:pt>
                <c:pt idx="2">
                  <c:v>30632</c:v>
                </c:pt>
                <c:pt idx="3">
                  <c:v>30600</c:v>
                </c:pt>
                <c:pt idx="4">
                  <c:v>28364</c:v>
                </c:pt>
                <c:pt idx="5">
                  <c:v>30539</c:v>
                </c:pt>
                <c:pt idx="6">
                  <c:v>29252</c:v>
                </c:pt>
                <c:pt idx="7">
                  <c:v>31079</c:v>
                </c:pt>
                <c:pt idx="8">
                  <c:v>31931</c:v>
                </c:pt>
                <c:pt idx="9">
                  <c:v>30760</c:v>
                </c:pt>
                <c:pt idx="10">
                  <c:v>30167</c:v>
                </c:pt>
                <c:pt idx="11">
                  <c:v>32361</c:v>
                </c:pt>
                <c:pt idx="12">
                  <c:v>31521</c:v>
                </c:pt>
                <c:pt idx="13">
                  <c:v>32342</c:v>
                </c:pt>
                <c:pt idx="14">
                  <c:v>30787</c:v>
                </c:pt>
                <c:pt idx="15">
                  <c:v>30454</c:v>
                </c:pt>
                <c:pt idx="16">
                  <c:v>32155</c:v>
                </c:pt>
                <c:pt idx="17">
                  <c:v>31640</c:v>
                </c:pt>
                <c:pt idx="18">
                  <c:v>31096</c:v>
                </c:pt>
                <c:pt idx="19">
                  <c:v>30526</c:v>
                </c:pt>
                <c:pt idx="20">
                  <c:v>33870</c:v>
                </c:pt>
                <c:pt idx="21">
                  <c:v>28068</c:v>
                </c:pt>
                <c:pt idx="22">
                  <c:v>31467</c:v>
                </c:pt>
                <c:pt idx="23">
                  <c:v>31704</c:v>
                </c:pt>
                <c:pt idx="24">
                  <c:v>30962</c:v>
                </c:pt>
                <c:pt idx="25">
                  <c:v>31029</c:v>
                </c:pt>
                <c:pt idx="26">
                  <c:v>31099</c:v>
                </c:pt>
                <c:pt idx="27">
                  <c:v>32363</c:v>
                </c:pt>
                <c:pt idx="28">
                  <c:v>30830</c:v>
                </c:pt>
                <c:pt idx="29">
                  <c:v>30170</c:v>
                </c:pt>
                <c:pt idx="30">
                  <c:v>32602</c:v>
                </c:pt>
                <c:pt idx="31">
                  <c:v>31235</c:v>
                </c:pt>
                <c:pt idx="32">
                  <c:v>32912</c:v>
                </c:pt>
                <c:pt idx="33">
                  <c:v>32441</c:v>
                </c:pt>
                <c:pt idx="34">
                  <c:v>30661</c:v>
                </c:pt>
                <c:pt idx="35">
                  <c:v>296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A252-4384-9D7D-4ED8E1B54CAD}"/>
            </c:ext>
          </c:extLst>
        </c:ser>
        <c:ser>
          <c:idx val="10"/>
          <c:order val="1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M$69:$M$104</c:f>
              <c:numCache>
                <c:formatCode>General</c:formatCode>
                <c:ptCount val="36"/>
                <c:pt idx="0">
                  <c:v>27165</c:v>
                </c:pt>
                <c:pt idx="1">
                  <c:v>24592</c:v>
                </c:pt>
                <c:pt idx="2">
                  <c:v>25860</c:v>
                </c:pt>
                <c:pt idx="3">
                  <c:v>26844</c:v>
                </c:pt>
                <c:pt idx="4">
                  <c:v>26262</c:v>
                </c:pt>
                <c:pt idx="5">
                  <c:v>25301</c:v>
                </c:pt>
                <c:pt idx="6">
                  <c:v>23875</c:v>
                </c:pt>
                <c:pt idx="7">
                  <c:v>27071</c:v>
                </c:pt>
                <c:pt idx="8">
                  <c:v>26111</c:v>
                </c:pt>
                <c:pt idx="9">
                  <c:v>26573</c:v>
                </c:pt>
                <c:pt idx="10">
                  <c:v>26000</c:v>
                </c:pt>
                <c:pt idx="11">
                  <c:v>28018</c:v>
                </c:pt>
                <c:pt idx="12">
                  <c:v>24800</c:v>
                </c:pt>
                <c:pt idx="13">
                  <c:v>27531</c:v>
                </c:pt>
                <c:pt idx="14">
                  <c:v>25407</c:v>
                </c:pt>
                <c:pt idx="15">
                  <c:v>26889</c:v>
                </c:pt>
                <c:pt idx="16">
                  <c:v>25428</c:v>
                </c:pt>
                <c:pt idx="17">
                  <c:v>27596</c:v>
                </c:pt>
                <c:pt idx="18">
                  <c:v>27117</c:v>
                </c:pt>
                <c:pt idx="19">
                  <c:v>26678</c:v>
                </c:pt>
                <c:pt idx="20">
                  <c:v>26768</c:v>
                </c:pt>
                <c:pt idx="21">
                  <c:v>28342</c:v>
                </c:pt>
                <c:pt idx="22">
                  <c:v>25103</c:v>
                </c:pt>
                <c:pt idx="23">
                  <c:v>25257</c:v>
                </c:pt>
                <c:pt idx="24">
                  <c:v>27143</c:v>
                </c:pt>
                <c:pt idx="25">
                  <c:v>26721</c:v>
                </c:pt>
                <c:pt idx="26">
                  <c:v>26268</c:v>
                </c:pt>
                <c:pt idx="27">
                  <c:v>25380</c:v>
                </c:pt>
                <c:pt idx="28">
                  <c:v>26688</c:v>
                </c:pt>
                <c:pt idx="29">
                  <c:v>26203</c:v>
                </c:pt>
                <c:pt idx="30">
                  <c:v>27140</c:v>
                </c:pt>
                <c:pt idx="31">
                  <c:v>25346</c:v>
                </c:pt>
                <c:pt idx="32">
                  <c:v>26054</c:v>
                </c:pt>
                <c:pt idx="33">
                  <c:v>28890</c:v>
                </c:pt>
                <c:pt idx="34">
                  <c:v>26568</c:v>
                </c:pt>
                <c:pt idx="35">
                  <c:v>2504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A252-4384-9D7D-4ED8E1B54CAD}"/>
            </c:ext>
          </c:extLst>
        </c:ser>
        <c:ser>
          <c:idx val="11"/>
          <c:order val="1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N$69:$N$104</c:f>
              <c:numCache>
                <c:formatCode>General</c:formatCode>
                <c:ptCount val="36"/>
                <c:pt idx="0">
                  <c:v>26503</c:v>
                </c:pt>
                <c:pt idx="1">
                  <c:v>26549</c:v>
                </c:pt>
                <c:pt idx="2">
                  <c:v>25495</c:v>
                </c:pt>
                <c:pt idx="3">
                  <c:v>27765</c:v>
                </c:pt>
                <c:pt idx="4">
                  <c:v>26683</c:v>
                </c:pt>
                <c:pt idx="5">
                  <c:v>27349</c:v>
                </c:pt>
                <c:pt idx="6">
                  <c:v>27135</c:v>
                </c:pt>
                <c:pt idx="7">
                  <c:v>26974</c:v>
                </c:pt>
                <c:pt idx="8">
                  <c:v>25341</c:v>
                </c:pt>
                <c:pt idx="9">
                  <c:v>24921</c:v>
                </c:pt>
                <c:pt idx="10">
                  <c:v>28189</c:v>
                </c:pt>
                <c:pt idx="11">
                  <c:v>25965</c:v>
                </c:pt>
                <c:pt idx="12">
                  <c:v>25232</c:v>
                </c:pt>
                <c:pt idx="13">
                  <c:v>26425</c:v>
                </c:pt>
                <c:pt idx="14">
                  <c:v>25792</c:v>
                </c:pt>
                <c:pt idx="15">
                  <c:v>28044</c:v>
                </c:pt>
                <c:pt idx="16">
                  <c:v>25907</c:v>
                </c:pt>
                <c:pt idx="17">
                  <c:v>27154</c:v>
                </c:pt>
                <c:pt idx="18">
                  <c:v>28800</c:v>
                </c:pt>
                <c:pt idx="19">
                  <c:v>26620</c:v>
                </c:pt>
                <c:pt idx="20">
                  <c:v>29410</c:v>
                </c:pt>
                <c:pt idx="21">
                  <c:v>28382</c:v>
                </c:pt>
                <c:pt idx="22">
                  <c:v>26355</c:v>
                </c:pt>
                <c:pt idx="23">
                  <c:v>25969</c:v>
                </c:pt>
                <c:pt idx="24">
                  <c:v>26985</c:v>
                </c:pt>
                <c:pt idx="25">
                  <c:v>27705</c:v>
                </c:pt>
                <c:pt idx="26">
                  <c:v>28406</c:v>
                </c:pt>
                <c:pt idx="27">
                  <c:v>27759</c:v>
                </c:pt>
                <c:pt idx="28">
                  <c:v>28647</c:v>
                </c:pt>
                <c:pt idx="29">
                  <c:v>27827</c:v>
                </c:pt>
                <c:pt idx="30">
                  <c:v>26595</c:v>
                </c:pt>
                <c:pt idx="31">
                  <c:v>28710</c:v>
                </c:pt>
                <c:pt idx="32">
                  <c:v>27699</c:v>
                </c:pt>
                <c:pt idx="33">
                  <c:v>26548</c:v>
                </c:pt>
                <c:pt idx="34">
                  <c:v>26730</c:v>
                </c:pt>
                <c:pt idx="35">
                  <c:v>2598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A252-4384-9D7D-4ED8E1B54CAD}"/>
            </c:ext>
          </c:extLst>
        </c:ser>
        <c:ser>
          <c:idx val="12"/>
          <c:order val="12"/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O$69:$O$104</c:f>
              <c:numCache>
                <c:formatCode>General</c:formatCode>
                <c:ptCount val="36"/>
                <c:pt idx="0">
                  <c:v>62342</c:v>
                </c:pt>
                <c:pt idx="1">
                  <c:v>62773</c:v>
                </c:pt>
                <c:pt idx="2">
                  <c:v>61289</c:v>
                </c:pt>
                <c:pt idx="3">
                  <c:v>60961</c:v>
                </c:pt>
                <c:pt idx="4">
                  <c:v>62671</c:v>
                </c:pt>
                <c:pt idx="5">
                  <c:v>63848</c:v>
                </c:pt>
                <c:pt idx="6">
                  <c:v>99972</c:v>
                </c:pt>
                <c:pt idx="7">
                  <c:v>147352</c:v>
                </c:pt>
                <c:pt idx="8">
                  <c:v>190150</c:v>
                </c:pt>
                <c:pt idx="9">
                  <c:v>213593</c:v>
                </c:pt>
                <c:pt idx="10">
                  <c:v>244788</c:v>
                </c:pt>
                <c:pt idx="11">
                  <c:v>263592</c:v>
                </c:pt>
                <c:pt idx="12">
                  <c:v>277706</c:v>
                </c:pt>
                <c:pt idx="13">
                  <c:v>293932</c:v>
                </c:pt>
                <c:pt idx="14">
                  <c:v>293992</c:v>
                </c:pt>
                <c:pt idx="15">
                  <c:v>293334</c:v>
                </c:pt>
                <c:pt idx="16">
                  <c:v>304056</c:v>
                </c:pt>
                <c:pt idx="17">
                  <c:v>306820</c:v>
                </c:pt>
                <c:pt idx="18">
                  <c:v>303584</c:v>
                </c:pt>
                <c:pt idx="19">
                  <c:v>314846</c:v>
                </c:pt>
                <c:pt idx="20">
                  <c:v>308021</c:v>
                </c:pt>
                <c:pt idx="21">
                  <c:v>315759</c:v>
                </c:pt>
                <c:pt idx="22">
                  <c:v>319062</c:v>
                </c:pt>
                <c:pt idx="23">
                  <c:v>319245</c:v>
                </c:pt>
                <c:pt idx="24">
                  <c:v>315769</c:v>
                </c:pt>
                <c:pt idx="25">
                  <c:v>321782</c:v>
                </c:pt>
                <c:pt idx="26">
                  <c:v>324904</c:v>
                </c:pt>
                <c:pt idx="27">
                  <c:v>321272</c:v>
                </c:pt>
                <c:pt idx="28">
                  <c:v>317817</c:v>
                </c:pt>
                <c:pt idx="29">
                  <c:v>313147</c:v>
                </c:pt>
                <c:pt idx="30">
                  <c:v>318062</c:v>
                </c:pt>
                <c:pt idx="31">
                  <c:v>320828</c:v>
                </c:pt>
                <c:pt idx="32">
                  <c:v>315128</c:v>
                </c:pt>
                <c:pt idx="33">
                  <c:v>317909</c:v>
                </c:pt>
                <c:pt idx="34">
                  <c:v>319261</c:v>
                </c:pt>
                <c:pt idx="35">
                  <c:v>31599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A252-4384-9D7D-4ED8E1B54CAD}"/>
            </c:ext>
          </c:extLst>
        </c:ser>
        <c:ser>
          <c:idx val="13"/>
          <c:order val="13"/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P$69:$P$104</c:f>
              <c:numCache>
                <c:formatCode>General</c:formatCode>
                <c:ptCount val="36"/>
                <c:pt idx="0">
                  <c:v>59720</c:v>
                </c:pt>
                <c:pt idx="1">
                  <c:v>59825</c:v>
                </c:pt>
                <c:pt idx="2">
                  <c:v>61039</c:v>
                </c:pt>
                <c:pt idx="3">
                  <c:v>60531</c:v>
                </c:pt>
                <c:pt idx="4">
                  <c:v>62122</c:v>
                </c:pt>
                <c:pt idx="5">
                  <c:v>65426</c:v>
                </c:pt>
                <c:pt idx="6">
                  <c:v>103090</c:v>
                </c:pt>
                <c:pt idx="7">
                  <c:v>154368</c:v>
                </c:pt>
                <c:pt idx="8">
                  <c:v>195548</c:v>
                </c:pt>
                <c:pt idx="9">
                  <c:v>225191</c:v>
                </c:pt>
                <c:pt idx="10">
                  <c:v>247045</c:v>
                </c:pt>
                <c:pt idx="11">
                  <c:v>266802</c:v>
                </c:pt>
                <c:pt idx="12">
                  <c:v>285446</c:v>
                </c:pt>
                <c:pt idx="13">
                  <c:v>300730</c:v>
                </c:pt>
                <c:pt idx="14">
                  <c:v>304036</c:v>
                </c:pt>
                <c:pt idx="15">
                  <c:v>313827</c:v>
                </c:pt>
                <c:pt idx="16">
                  <c:v>319061</c:v>
                </c:pt>
                <c:pt idx="17">
                  <c:v>315313</c:v>
                </c:pt>
                <c:pt idx="18">
                  <c:v>323157</c:v>
                </c:pt>
                <c:pt idx="19">
                  <c:v>328019</c:v>
                </c:pt>
                <c:pt idx="20">
                  <c:v>322156</c:v>
                </c:pt>
                <c:pt idx="21">
                  <c:v>325140</c:v>
                </c:pt>
                <c:pt idx="22">
                  <c:v>324850</c:v>
                </c:pt>
                <c:pt idx="23">
                  <c:v>321319</c:v>
                </c:pt>
                <c:pt idx="24">
                  <c:v>328936</c:v>
                </c:pt>
                <c:pt idx="25">
                  <c:v>328579</c:v>
                </c:pt>
                <c:pt idx="26">
                  <c:v>328799</c:v>
                </c:pt>
                <c:pt idx="27">
                  <c:v>328358</c:v>
                </c:pt>
                <c:pt idx="28">
                  <c:v>335488</c:v>
                </c:pt>
                <c:pt idx="29">
                  <c:v>335943</c:v>
                </c:pt>
                <c:pt idx="30">
                  <c:v>327944</c:v>
                </c:pt>
                <c:pt idx="31">
                  <c:v>332018</c:v>
                </c:pt>
                <c:pt idx="32">
                  <c:v>327042</c:v>
                </c:pt>
                <c:pt idx="33">
                  <c:v>327729</c:v>
                </c:pt>
                <c:pt idx="34">
                  <c:v>326930</c:v>
                </c:pt>
                <c:pt idx="35">
                  <c:v>3210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D-A252-4384-9D7D-4ED8E1B54CAD}"/>
            </c:ext>
          </c:extLst>
        </c:ser>
        <c:ser>
          <c:idx val="14"/>
          <c:order val="14"/>
          <c:spPr>
            <a:ln w="19050" cap="rnd">
              <a:solidFill>
                <a:srgbClr val="FF00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Q$69:$Q$104</c:f>
              <c:numCache>
                <c:formatCode>General</c:formatCode>
                <c:ptCount val="36"/>
                <c:pt idx="0">
                  <c:v>60879</c:v>
                </c:pt>
                <c:pt idx="1">
                  <c:v>59913</c:v>
                </c:pt>
                <c:pt idx="2">
                  <c:v>60562</c:v>
                </c:pt>
                <c:pt idx="3">
                  <c:v>60484</c:v>
                </c:pt>
                <c:pt idx="4">
                  <c:v>61641</c:v>
                </c:pt>
                <c:pt idx="5">
                  <c:v>67915</c:v>
                </c:pt>
                <c:pt idx="6">
                  <c:v>105254</c:v>
                </c:pt>
                <c:pt idx="7">
                  <c:v>153217</c:v>
                </c:pt>
                <c:pt idx="8">
                  <c:v>192151</c:v>
                </c:pt>
                <c:pt idx="9">
                  <c:v>216485</c:v>
                </c:pt>
                <c:pt idx="10">
                  <c:v>244410</c:v>
                </c:pt>
                <c:pt idx="11">
                  <c:v>256541</c:v>
                </c:pt>
                <c:pt idx="12">
                  <c:v>266053</c:v>
                </c:pt>
                <c:pt idx="13">
                  <c:v>281271</c:v>
                </c:pt>
                <c:pt idx="14">
                  <c:v>280785</c:v>
                </c:pt>
                <c:pt idx="15">
                  <c:v>288121</c:v>
                </c:pt>
                <c:pt idx="16">
                  <c:v>295003</c:v>
                </c:pt>
                <c:pt idx="17">
                  <c:v>288687</c:v>
                </c:pt>
                <c:pt idx="18">
                  <c:v>298652</c:v>
                </c:pt>
                <c:pt idx="19">
                  <c:v>288987</c:v>
                </c:pt>
                <c:pt idx="20">
                  <c:v>294775</c:v>
                </c:pt>
                <c:pt idx="21">
                  <c:v>294993</c:v>
                </c:pt>
                <c:pt idx="22">
                  <c:v>297799</c:v>
                </c:pt>
                <c:pt idx="23">
                  <c:v>300120</c:v>
                </c:pt>
                <c:pt idx="24">
                  <c:v>289306</c:v>
                </c:pt>
                <c:pt idx="25">
                  <c:v>294886</c:v>
                </c:pt>
                <c:pt idx="26">
                  <c:v>294264</c:v>
                </c:pt>
                <c:pt idx="27">
                  <c:v>295103</c:v>
                </c:pt>
                <c:pt idx="28">
                  <c:v>308874</c:v>
                </c:pt>
                <c:pt idx="29">
                  <c:v>301369</c:v>
                </c:pt>
                <c:pt idx="30">
                  <c:v>298163</c:v>
                </c:pt>
                <c:pt idx="31">
                  <c:v>304708</c:v>
                </c:pt>
                <c:pt idx="32">
                  <c:v>300153</c:v>
                </c:pt>
                <c:pt idx="33">
                  <c:v>310758</c:v>
                </c:pt>
                <c:pt idx="34">
                  <c:v>304397</c:v>
                </c:pt>
                <c:pt idx="35">
                  <c:v>30642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E-A252-4384-9D7D-4ED8E1B54CAD}"/>
            </c:ext>
          </c:extLst>
        </c:ser>
        <c:ser>
          <c:idx val="15"/>
          <c:order val="15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R$69:$R$104</c:f>
              <c:numCache>
                <c:formatCode>General</c:formatCode>
                <c:ptCount val="36"/>
                <c:pt idx="0">
                  <c:v>45840</c:v>
                </c:pt>
                <c:pt idx="1">
                  <c:v>48356</c:v>
                </c:pt>
                <c:pt idx="2">
                  <c:v>49666</c:v>
                </c:pt>
                <c:pt idx="3">
                  <c:v>48838</c:v>
                </c:pt>
                <c:pt idx="4">
                  <c:v>44152</c:v>
                </c:pt>
                <c:pt idx="5">
                  <c:v>48747</c:v>
                </c:pt>
                <c:pt idx="6">
                  <c:v>49430</c:v>
                </c:pt>
                <c:pt idx="7">
                  <c:v>50043</c:v>
                </c:pt>
                <c:pt idx="8">
                  <c:v>47285</c:v>
                </c:pt>
                <c:pt idx="9">
                  <c:v>49965</c:v>
                </c:pt>
                <c:pt idx="10">
                  <c:v>49662</c:v>
                </c:pt>
                <c:pt idx="11">
                  <c:v>50445</c:v>
                </c:pt>
                <c:pt idx="12">
                  <c:v>47032</c:v>
                </c:pt>
                <c:pt idx="13">
                  <c:v>48665</c:v>
                </c:pt>
                <c:pt idx="14">
                  <c:v>51826</c:v>
                </c:pt>
                <c:pt idx="15">
                  <c:v>48161</c:v>
                </c:pt>
                <c:pt idx="16">
                  <c:v>50424</c:v>
                </c:pt>
                <c:pt idx="17">
                  <c:v>50182</c:v>
                </c:pt>
                <c:pt idx="18">
                  <c:v>50060</c:v>
                </c:pt>
                <c:pt idx="19">
                  <c:v>49976</c:v>
                </c:pt>
                <c:pt idx="20">
                  <c:v>48507</c:v>
                </c:pt>
                <c:pt idx="21">
                  <c:v>51143</c:v>
                </c:pt>
                <c:pt idx="22">
                  <c:v>51016</c:v>
                </c:pt>
                <c:pt idx="23">
                  <c:v>51085</c:v>
                </c:pt>
                <c:pt idx="24">
                  <c:v>51328</c:v>
                </c:pt>
                <c:pt idx="25">
                  <c:v>50770</c:v>
                </c:pt>
                <c:pt idx="26">
                  <c:v>53031</c:v>
                </c:pt>
                <c:pt idx="27">
                  <c:v>50294</c:v>
                </c:pt>
                <c:pt idx="28">
                  <c:v>50094</c:v>
                </c:pt>
                <c:pt idx="29">
                  <c:v>49447</c:v>
                </c:pt>
                <c:pt idx="30">
                  <c:v>51629</c:v>
                </c:pt>
                <c:pt idx="31">
                  <c:v>50485</c:v>
                </c:pt>
                <c:pt idx="32">
                  <c:v>51146</c:v>
                </c:pt>
                <c:pt idx="33">
                  <c:v>50632</c:v>
                </c:pt>
                <c:pt idx="34">
                  <c:v>49992</c:v>
                </c:pt>
                <c:pt idx="35">
                  <c:v>4971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F-A252-4384-9D7D-4ED8E1B54CAD}"/>
            </c:ext>
          </c:extLst>
        </c:ser>
        <c:ser>
          <c:idx val="16"/>
          <c:order val="16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S$69:$S$104</c:f>
              <c:numCache>
                <c:formatCode>General</c:formatCode>
                <c:ptCount val="36"/>
                <c:pt idx="0">
                  <c:v>47821</c:v>
                </c:pt>
                <c:pt idx="1">
                  <c:v>50798</c:v>
                </c:pt>
                <c:pt idx="2">
                  <c:v>49770</c:v>
                </c:pt>
                <c:pt idx="3">
                  <c:v>51016</c:v>
                </c:pt>
                <c:pt idx="4">
                  <c:v>52657</c:v>
                </c:pt>
                <c:pt idx="5">
                  <c:v>53763</c:v>
                </c:pt>
                <c:pt idx="6">
                  <c:v>50865</c:v>
                </c:pt>
                <c:pt idx="7">
                  <c:v>50861</c:v>
                </c:pt>
                <c:pt idx="8">
                  <c:v>49717</c:v>
                </c:pt>
                <c:pt idx="9">
                  <c:v>53359</c:v>
                </c:pt>
                <c:pt idx="10">
                  <c:v>53369</c:v>
                </c:pt>
                <c:pt idx="11">
                  <c:v>49817</c:v>
                </c:pt>
                <c:pt idx="12">
                  <c:v>51449</c:v>
                </c:pt>
                <c:pt idx="13">
                  <c:v>49947</c:v>
                </c:pt>
                <c:pt idx="14">
                  <c:v>56227</c:v>
                </c:pt>
                <c:pt idx="15">
                  <c:v>52762</c:v>
                </c:pt>
                <c:pt idx="16">
                  <c:v>54071</c:v>
                </c:pt>
                <c:pt idx="17">
                  <c:v>52658</c:v>
                </c:pt>
                <c:pt idx="18">
                  <c:v>52843</c:v>
                </c:pt>
                <c:pt idx="19">
                  <c:v>53317</c:v>
                </c:pt>
                <c:pt idx="20">
                  <c:v>52829</c:v>
                </c:pt>
                <c:pt idx="21">
                  <c:v>52504</c:v>
                </c:pt>
                <c:pt idx="22">
                  <c:v>52330</c:v>
                </c:pt>
                <c:pt idx="23">
                  <c:v>53472</c:v>
                </c:pt>
                <c:pt idx="24">
                  <c:v>57465</c:v>
                </c:pt>
                <c:pt idx="25">
                  <c:v>53626</c:v>
                </c:pt>
                <c:pt idx="26">
                  <c:v>51098</c:v>
                </c:pt>
                <c:pt idx="27">
                  <c:v>52082</c:v>
                </c:pt>
                <c:pt idx="28">
                  <c:v>51597</c:v>
                </c:pt>
                <c:pt idx="29">
                  <c:v>52813</c:v>
                </c:pt>
                <c:pt idx="30">
                  <c:v>52432</c:v>
                </c:pt>
                <c:pt idx="31">
                  <c:v>51807</c:v>
                </c:pt>
                <c:pt idx="32">
                  <c:v>53647</c:v>
                </c:pt>
                <c:pt idx="33">
                  <c:v>54016</c:v>
                </c:pt>
                <c:pt idx="34">
                  <c:v>52928</c:v>
                </c:pt>
                <c:pt idx="35">
                  <c:v>5250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0-A252-4384-9D7D-4ED8E1B54CAD}"/>
            </c:ext>
          </c:extLst>
        </c:ser>
        <c:ser>
          <c:idx val="17"/>
          <c:order val="17"/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T$69:$T$104</c:f>
              <c:numCache>
                <c:formatCode>General</c:formatCode>
                <c:ptCount val="36"/>
                <c:pt idx="0">
                  <c:v>25973</c:v>
                </c:pt>
                <c:pt idx="1">
                  <c:v>26746</c:v>
                </c:pt>
                <c:pt idx="2">
                  <c:v>25717</c:v>
                </c:pt>
                <c:pt idx="3">
                  <c:v>24810</c:v>
                </c:pt>
                <c:pt idx="4">
                  <c:v>25159</c:v>
                </c:pt>
                <c:pt idx="5">
                  <c:v>27346</c:v>
                </c:pt>
                <c:pt idx="6">
                  <c:v>25935</c:v>
                </c:pt>
                <c:pt idx="7">
                  <c:v>27911</c:v>
                </c:pt>
                <c:pt idx="8">
                  <c:v>26999</c:v>
                </c:pt>
                <c:pt idx="9">
                  <c:v>26274</c:v>
                </c:pt>
                <c:pt idx="10">
                  <c:v>25855</c:v>
                </c:pt>
                <c:pt idx="11">
                  <c:v>28337</c:v>
                </c:pt>
                <c:pt idx="12">
                  <c:v>30052</c:v>
                </c:pt>
                <c:pt idx="13">
                  <c:v>29049</c:v>
                </c:pt>
                <c:pt idx="14">
                  <c:v>26139</c:v>
                </c:pt>
                <c:pt idx="15">
                  <c:v>27403</c:v>
                </c:pt>
                <c:pt idx="16">
                  <c:v>28316</c:v>
                </c:pt>
                <c:pt idx="17">
                  <c:v>27686</c:v>
                </c:pt>
                <c:pt idx="18">
                  <c:v>27486</c:v>
                </c:pt>
                <c:pt idx="19">
                  <c:v>27409</c:v>
                </c:pt>
                <c:pt idx="20">
                  <c:v>29415</c:v>
                </c:pt>
                <c:pt idx="21">
                  <c:v>28244</c:v>
                </c:pt>
                <c:pt idx="22">
                  <c:v>27356</c:v>
                </c:pt>
                <c:pt idx="23">
                  <c:v>26580</c:v>
                </c:pt>
                <c:pt idx="24">
                  <c:v>27662</c:v>
                </c:pt>
                <c:pt idx="25">
                  <c:v>27195</c:v>
                </c:pt>
                <c:pt idx="26">
                  <c:v>26831</c:v>
                </c:pt>
                <c:pt idx="27">
                  <c:v>27692</c:v>
                </c:pt>
                <c:pt idx="28">
                  <c:v>26888</c:v>
                </c:pt>
                <c:pt idx="29">
                  <c:v>30211</c:v>
                </c:pt>
                <c:pt idx="30">
                  <c:v>26089</c:v>
                </c:pt>
                <c:pt idx="31">
                  <c:v>25333</c:v>
                </c:pt>
                <c:pt idx="32">
                  <c:v>26878</c:v>
                </c:pt>
                <c:pt idx="33">
                  <c:v>25679</c:v>
                </c:pt>
                <c:pt idx="34">
                  <c:v>26161</c:v>
                </c:pt>
                <c:pt idx="35">
                  <c:v>271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1-A252-4384-9D7D-4ED8E1B54CAD}"/>
            </c:ext>
          </c:extLst>
        </c:ser>
        <c:ser>
          <c:idx val="18"/>
          <c:order val="18"/>
          <c:spPr>
            <a:ln w="19050" cap="rnd">
              <a:solidFill>
                <a:srgbClr val="0070C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U$69:$U$104</c:f>
              <c:numCache>
                <c:formatCode>General</c:formatCode>
                <c:ptCount val="36"/>
                <c:pt idx="0">
                  <c:v>94611</c:v>
                </c:pt>
                <c:pt idx="1">
                  <c:v>97105</c:v>
                </c:pt>
                <c:pt idx="2">
                  <c:v>91680</c:v>
                </c:pt>
                <c:pt idx="3">
                  <c:v>91905</c:v>
                </c:pt>
                <c:pt idx="4">
                  <c:v>96546</c:v>
                </c:pt>
                <c:pt idx="5">
                  <c:v>111150</c:v>
                </c:pt>
                <c:pt idx="6">
                  <c:v>134297</c:v>
                </c:pt>
                <c:pt idx="7">
                  <c:v>165260</c:v>
                </c:pt>
                <c:pt idx="8">
                  <c:v>188430</c:v>
                </c:pt>
                <c:pt idx="9">
                  <c:v>213618</c:v>
                </c:pt>
                <c:pt idx="10">
                  <c:v>219918</c:v>
                </c:pt>
                <c:pt idx="11">
                  <c:v>233823</c:v>
                </c:pt>
                <c:pt idx="12">
                  <c:v>233363</c:v>
                </c:pt>
                <c:pt idx="13">
                  <c:v>239848</c:v>
                </c:pt>
                <c:pt idx="14">
                  <c:v>242594</c:v>
                </c:pt>
                <c:pt idx="15">
                  <c:v>242882</c:v>
                </c:pt>
                <c:pt idx="16">
                  <c:v>245261</c:v>
                </c:pt>
                <c:pt idx="17">
                  <c:v>244896</c:v>
                </c:pt>
                <c:pt idx="18">
                  <c:v>242962</c:v>
                </c:pt>
                <c:pt idx="19">
                  <c:v>244097</c:v>
                </c:pt>
                <c:pt idx="20">
                  <c:v>248988</c:v>
                </c:pt>
                <c:pt idx="21">
                  <c:v>240689</c:v>
                </c:pt>
                <c:pt idx="22">
                  <c:v>240176</c:v>
                </c:pt>
                <c:pt idx="23">
                  <c:v>242765</c:v>
                </c:pt>
                <c:pt idx="24">
                  <c:v>245560</c:v>
                </c:pt>
                <c:pt idx="25">
                  <c:v>243661</c:v>
                </c:pt>
                <c:pt idx="26">
                  <c:v>243473</c:v>
                </c:pt>
                <c:pt idx="27">
                  <c:v>245030</c:v>
                </c:pt>
                <c:pt idx="28">
                  <c:v>238211</c:v>
                </c:pt>
                <c:pt idx="29">
                  <c:v>250635</c:v>
                </c:pt>
                <c:pt idx="30">
                  <c:v>243135</c:v>
                </c:pt>
                <c:pt idx="31">
                  <c:v>239900</c:v>
                </c:pt>
                <c:pt idx="32">
                  <c:v>238006</c:v>
                </c:pt>
                <c:pt idx="33">
                  <c:v>243042</c:v>
                </c:pt>
                <c:pt idx="34">
                  <c:v>236354</c:v>
                </c:pt>
                <c:pt idx="35">
                  <c:v>24375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2-A252-4384-9D7D-4ED8E1B54CAD}"/>
            </c:ext>
          </c:extLst>
        </c:ser>
        <c:ser>
          <c:idx val="19"/>
          <c:order val="19"/>
          <c:spPr>
            <a:ln w="19050" cap="rnd">
              <a:solidFill>
                <a:srgbClr val="0070C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V$69:$V$104</c:f>
              <c:numCache>
                <c:formatCode>General</c:formatCode>
                <c:ptCount val="36"/>
                <c:pt idx="0">
                  <c:v>69499</c:v>
                </c:pt>
                <c:pt idx="1">
                  <c:v>69845</c:v>
                </c:pt>
                <c:pt idx="2">
                  <c:v>73430</c:v>
                </c:pt>
                <c:pt idx="3">
                  <c:v>68951</c:v>
                </c:pt>
                <c:pt idx="4">
                  <c:v>70539</c:v>
                </c:pt>
                <c:pt idx="5">
                  <c:v>69838</c:v>
                </c:pt>
                <c:pt idx="6">
                  <c:v>86180</c:v>
                </c:pt>
                <c:pt idx="7">
                  <c:v>116281</c:v>
                </c:pt>
                <c:pt idx="8">
                  <c:v>142386</c:v>
                </c:pt>
                <c:pt idx="9">
                  <c:v>157992</c:v>
                </c:pt>
                <c:pt idx="10">
                  <c:v>171579</c:v>
                </c:pt>
                <c:pt idx="11">
                  <c:v>172786</c:v>
                </c:pt>
                <c:pt idx="12">
                  <c:v>182720</c:v>
                </c:pt>
                <c:pt idx="13">
                  <c:v>188720</c:v>
                </c:pt>
                <c:pt idx="14">
                  <c:v>191766</c:v>
                </c:pt>
                <c:pt idx="15">
                  <c:v>194112</c:v>
                </c:pt>
                <c:pt idx="16">
                  <c:v>193893</c:v>
                </c:pt>
                <c:pt idx="17">
                  <c:v>192997</c:v>
                </c:pt>
                <c:pt idx="18">
                  <c:v>197591</c:v>
                </c:pt>
                <c:pt idx="19">
                  <c:v>197831</c:v>
                </c:pt>
                <c:pt idx="20">
                  <c:v>191821</c:v>
                </c:pt>
                <c:pt idx="21">
                  <c:v>199122</c:v>
                </c:pt>
                <c:pt idx="22">
                  <c:v>201398</c:v>
                </c:pt>
                <c:pt idx="23">
                  <c:v>196980</c:v>
                </c:pt>
                <c:pt idx="24">
                  <c:v>197594</c:v>
                </c:pt>
                <c:pt idx="25">
                  <c:v>198628</c:v>
                </c:pt>
                <c:pt idx="26">
                  <c:v>203385</c:v>
                </c:pt>
                <c:pt idx="27">
                  <c:v>200301</c:v>
                </c:pt>
                <c:pt idx="28">
                  <c:v>198349</c:v>
                </c:pt>
                <c:pt idx="29">
                  <c:v>195596</c:v>
                </c:pt>
                <c:pt idx="30">
                  <c:v>197202</c:v>
                </c:pt>
                <c:pt idx="31">
                  <c:v>192304</c:v>
                </c:pt>
                <c:pt idx="32">
                  <c:v>200298</c:v>
                </c:pt>
                <c:pt idx="33">
                  <c:v>200284</c:v>
                </c:pt>
                <c:pt idx="34">
                  <c:v>198635</c:v>
                </c:pt>
                <c:pt idx="35">
                  <c:v>19818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3-A252-4384-9D7D-4ED8E1B54CAD}"/>
            </c:ext>
          </c:extLst>
        </c:ser>
        <c:ser>
          <c:idx val="20"/>
          <c:order val="20"/>
          <c:spPr>
            <a:ln w="19050" cap="rnd">
              <a:solidFill>
                <a:srgbClr val="0070C0"/>
              </a:solidFill>
              <a:prstDash val="sysDash"/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W$69:$W$104</c:f>
              <c:numCache>
                <c:formatCode>General</c:formatCode>
                <c:ptCount val="36"/>
                <c:pt idx="0">
                  <c:v>70854</c:v>
                </c:pt>
                <c:pt idx="1">
                  <c:v>71623</c:v>
                </c:pt>
                <c:pt idx="2">
                  <c:v>74037</c:v>
                </c:pt>
                <c:pt idx="3">
                  <c:v>72740</c:v>
                </c:pt>
                <c:pt idx="4">
                  <c:v>76139</c:v>
                </c:pt>
                <c:pt idx="5">
                  <c:v>78065</c:v>
                </c:pt>
                <c:pt idx="6">
                  <c:v>110600</c:v>
                </c:pt>
                <c:pt idx="7">
                  <c:v>153658</c:v>
                </c:pt>
                <c:pt idx="8">
                  <c:v>185461</c:v>
                </c:pt>
                <c:pt idx="9">
                  <c:v>199113</c:v>
                </c:pt>
                <c:pt idx="10">
                  <c:v>211713</c:v>
                </c:pt>
                <c:pt idx="11">
                  <c:v>225165</c:v>
                </c:pt>
                <c:pt idx="12">
                  <c:v>222717</c:v>
                </c:pt>
                <c:pt idx="13">
                  <c:v>226385</c:v>
                </c:pt>
                <c:pt idx="14">
                  <c:v>223614</c:v>
                </c:pt>
                <c:pt idx="15">
                  <c:v>220336</c:v>
                </c:pt>
                <c:pt idx="16">
                  <c:v>218999</c:v>
                </c:pt>
                <c:pt idx="17">
                  <c:v>225470</c:v>
                </c:pt>
                <c:pt idx="18">
                  <c:v>231637</c:v>
                </c:pt>
                <c:pt idx="19">
                  <c:v>230398</c:v>
                </c:pt>
                <c:pt idx="20">
                  <c:v>228916</c:v>
                </c:pt>
                <c:pt idx="21">
                  <c:v>226683</c:v>
                </c:pt>
                <c:pt idx="22">
                  <c:v>233043</c:v>
                </c:pt>
                <c:pt idx="23">
                  <c:v>225032</c:v>
                </c:pt>
                <c:pt idx="24">
                  <c:v>227421</c:v>
                </c:pt>
                <c:pt idx="25">
                  <c:v>222893</c:v>
                </c:pt>
                <c:pt idx="26">
                  <c:v>226516</c:v>
                </c:pt>
                <c:pt idx="27">
                  <c:v>223316</c:v>
                </c:pt>
                <c:pt idx="28">
                  <c:v>227078</c:v>
                </c:pt>
                <c:pt idx="29">
                  <c:v>221031</c:v>
                </c:pt>
                <c:pt idx="30">
                  <c:v>221449</c:v>
                </c:pt>
                <c:pt idx="31">
                  <c:v>222498</c:v>
                </c:pt>
                <c:pt idx="32">
                  <c:v>220849</c:v>
                </c:pt>
                <c:pt idx="33">
                  <c:v>218257</c:v>
                </c:pt>
                <c:pt idx="34">
                  <c:v>222966</c:v>
                </c:pt>
                <c:pt idx="35">
                  <c:v>22247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4-A252-4384-9D7D-4ED8E1B54CAD}"/>
            </c:ext>
          </c:extLst>
        </c:ser>
        <c:ser>
          <c:idx val="21"/>
          <c:order val="21"/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X$69:$X$104</c:f>
              <c:numCache>
                <c:formatCode>General</c:formatCode>
                <c:ptCount val="36"/>
                <c:pt idx="0">
                  <c:v>36912</c:v>
                </c:pt>
                <c:pt idx="1">
                  <c:v>36178</c:v>
                </c:pt>
                <c:pt idx="2">
                  <c:v>35596</c:v>
                </c:pt>
                <c:pt idx="3">
                  <c:v>34310</c:v>
                </c:pt>
                <c:pt idx="4">
                  <c:v>36906</c:v>
                </c:pt>
                <c:pt idx="5">
                  <c:v>36221</c:v>
                </c:pt>
                <c:pt idx="6">
                  <c:v>37159</c:v>
                </c:pt>
                <c:pt idx="7">
                  <c:v>35607</c:v>
                </c:pt>
                <c:pt idx="8">
                  <c:v>37884</c:v>
                </c:pt>
                <c:pt idx="9">
                  <c:v>36641</c:v>
                </c:pt>
                <c:pt idx="10">
                  <c:v>42229</c:v>
                </c:pt>
                <c:pt idx="11">
                  <c:v>37825</c:v>
                </c:pt>
                <c:pt idx="12">
                  <c:v>38657</c:v>
                </c:pt>
                <c:pt idx="13">
                  <c:v>39842</c:v>
                </c:pt>
                <c:pt idx="14">
                  <c:v>36498</c:v>
                </c:pt>
                <c:pt idx="15">
                  <c:v>38458</c:v>
                </c:pt>
                <c:pt idx="16">
                  <c:v>38673</c:v>
                </c:pt>
                <c:pt idx="17">
                  <c:v>38446</c:v>
                </c:pt>
                <c:pt idx="18">
                  <c:v>37947</c:v>
                </c:pt>
                <c:pt idx="19">
                  <c:v>39971</c:v>
                </c:pt>
                <c:pt idx="20">
                  <c:v>40434</c:v>
                </c:pt>
                <c:pt idx="21">
                  <c:v>39780</c:v>
                </c:pt>
                <c:pt idx="22">
                  <c:v>37135</c:v>
                </c:pt>
                <c:pt idx="23">
                  <c:v>38612</c:v>
                </c:pt>
                <c:pt idx="24">
                  <c:v>42678</c:v>
                </c:pt>
                <c:pt idx="25">
                  <c:v>37901</c:v>
                </c:pt>
                <c:pt idx="26">
                  <c:v>37675</c:v>
                </c:pt>
                <c:pt idx="27">
                  <c:v>38218</c:v>
                </c:pt>
                <c:pt idx="28">
                  <c:v>37712</c:v>
                </c:pt>
                <c:pt idx="29">
                  <c:v>40221</c:v>
                </c:pt>
                <c:pt idx="30">
                  <c:v>37459</c:v>
                </c:pt>
                <c:pt idx="31">
                  <c:v>37607</c:v>
                </c:pt>
                <c:pt idx="32">
                  <c:v>37801</c:v>
                </c:pt>
                <c:pt idx="33">
                  <c:v>37263</c:v>
                </c:pt>
                <c:pt idx="34">
                  <c:v>39143</c:v>
                </c:pt>
                <c:pt idx="35">
                  <c:v>3693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5-A252-4384-9D7D-4ED8E1B54CAD}"/>
            </c:ext>
          </c:extLst>
        </c:ser>
        <c:ser>
          <c:idx val="22"/>
          <c:order val="22"/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Y$69:$Y$104</c:f>
              <c:numCache>
                <c:formatCode>General</c:formatCode>
                <c:ptCount val="36"/>
                <c:pt idx="0">
                  <c:v>43354</c:v>
                </c:pt>
                <c:pt idx="1">
                  <c:v>42003</c:v>
                </c:pt>
                <c:pt idx="2">
                  <c:v>40983</c:v>
                </c:pt>
                <c:pt idx="3">
                  <c:v>43226</c:v>
                </c:pt>
                <c:pt idx="4">
                  <c:v>38556</c:v>
                </c:pt>
                <c:pt idx="5">
                  <c:v>42156</c:v>
                </c:pt>
                <c:pt idx="6">
                  <c:v>42438</c:v>
                </c:pt>
                <c:pt idx="7">
                  <c:v>38794</c:v>
                </c:pt>
                <c:pt idx="8">
                  <c:v>42447</c:v>
                </c:pt>
                <c:pt idx="9">
                  <c:v>42076</c:v>
                </c:pt>
                <c:pt idx="10">
                  <c:v>43804</c:v>
                </c:pt>
                <c:pt idx="11">
                  <c:v>41730</c:v>
                </c:pt>
                <c:pt idx="12">
                  <c:v>43393</c:v>
                </c:pt>
                <c:pt idx="13">
                  <c:v>43956</c:v>
                </c:pt>
                <c:pt idx="14">
                  <c:v>42476</c:v>
                </c:pt>
                <c:pt idx="15">
                  <c:v>46541</c:v>
                </c:pt>
                <c:pt idx="16">
                  <c:v>45445</c:v>
                </c:pt>
                <c:pt idx="17">
                  <c:v>44416</c:v>
                </c:pt>
                <c:pt idx="18">
                  <c:v>40117</c:v>
                </c:pt>
                <c:pt idx="19">
                  <c:v>44205</c:v>
                </c:pt>
                <c:pt idx="20">
                  <c:v>42128</c:v>
                </c:pt>
                <c:pt idx="21">
                  <c:v>43950</c:v>
                </c:pt>
                <c:pt idx="22">
                  <c:v>43864</c:v>
                </c:pt>
                <c:pt idx="23">
                  <c:v>42561</c:v>
                </c:pt>
                <c:pt idx="24">
                  <c:v>42885</c:v>
                </c:pt>
                <c:pt idx="25">
                  <c:v>44471</c:v>
                </c:pt>
                <c:pt idx="26">
                  <c:v>44911</c:v>
                </c:pt>
                <c:pt idx="27">
                  <c:v>43675</c:v>
                </c:pt>
                <c:pt idx="28">
                  <c:v>43785</c:v>
                </c:pt>
                <c:pt idx="29">
                  <c:v>45001</c:v>
                </c:pt>
                <c:pt idx="30">
                  <c:v>41569</c:v>
                </c:pt>
                <c:pt idx="31">
                  <c:v>43999</c:v>
                </c:pt>
                <c:pt idx="32">
                  <c:v>41562</c:v>
                </c:pt>
                <c:pt idx="33">
                  <c:v>43517</c:v>
                </c:pt>
                <c:pt idx="34">
                  <c:v>44103</c:v>
                </c:pt>
                <c:pt idx="35">
                  <c:v>451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6-A252-4384-9D7D-4ED8E1B54CAD}"/>
            </c:ext>
          </c:extLst>
        </c:ser>
        <c:ser>
          <c:idx val="23"/>
          <c:order val="23"/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'cikk SUM'!$B$69:$B$104</c:f>
              <c:numCache>
                <c:formatCode>0</c:formatCode>
                <c:ptCount val="3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</c:numCache>
            </c:numRef>
          </c:cat>
          <c:val>
            <c:numRef>
              <c:f>'cikk SUM'!$Z$69:$Z$104</c:f>
              <c:numCache>
                <c:formatCode>General</c:formatCode>
                <c:ptCount val="36"/>
                <c:pt idx="0">
                  <c:v>41415</c:v>
                </c:pt>
                <c:pt idx="1">
                  <c:v>42026</c:v>
                </c:pt>
                <c:pt idx="2">
                  <c:v>41024</c:v>
                </c:pt>
                <c:pt idx="3">
                  <c:v>41181</c:v>
                </c:pt>
                <c:pt idx="4">
                  <c:v>43060</c:v>
                </c:pt>
                <c:pt idx="5">
                  <c:v>45249</c:v>
                </c:pt>
                <c:pt idx="6">
                  <c:v>41921</c:v>
                </c:pt>
                <c:pt idx="7">
                  <c:v>41363</c:v>
                </c:pt>
                <c:pt idx="8">
                  <c:v>43615</c:v>
                </c:pt>
                <c:pt idx="9">
                  <c:v>46274</c:v>
                </c:pt>
                <c:pt idx="10">
                  <c:v>43215</c:v>
                </c:pt>
                <c:pt idx="11">
                  <c:v>45004</c:v>
                </c:pt>
                <c:pt idx="12">
                  <c:v>45852</c:v>
                </c:pt>
                <c:pt idx="13">
                  <c:v>45655</c:v>
                </c:pt>
                <c:pt idx="14">
                  <c:v>43789</c:v>
                </c:pt>
                <c:pt idx="15">
                  <c:v>44563</c:v>
                </c:pt>
                <c:pt idx="16">
                  <c:v>46966</c:v>
                </c:pt>
                <c:pt idx="17">
                  <c:v>47150</c:v>
                </c:pt>
                <c:pt idx="18">
                  <c:v>44859</c:v>
                </c:pt>
                <c:pt idx="19">
                  <c:v>47948</c:v>
                </c:pt>
                <c:pt idx="20">
                  <c:v>44677</c:v>
                </c:pt>
                <c:pt idx="21">
                  <c:v>45059</c:v>
                </c:pt>
                <c:pt idx="22">
                  <c:v>48391</c:v>
                </c:pt>
                <c:pt idx="23">
                  <c:v>44784</c:v>
                </c:pt>
                <c:pt idx="24">
                  <c:v>45878</c:v>
                </c:pt>
                <c:pt idx="25">
                  <c:v>44710</c:v>
                </c:pt>
                <c:pt idx="26">
                  <c:v>45853</c:v>
                </c:pt>
                <c:pt idx="27">
                  <c:v>43687</c:v>
                </c:pt>
                <c:pt idx="28">
                  <c:v>44133</c:v>
                </c:pt>
                <c:pt idx="29">
                  <c:v>46499</c:v>
                </c:pt>
                <c:pt idx="30">
                  <c:v>46731</c:v>
                </c:pt>
                <c:pt idx="31">
                  <c:v>46945</c:v>
                </c:pt>
                <c:pt idx="32">
                  <c:v>45970</c:v>
                </c:pt>
                <c:pt idx="33">
                  <c:v>46011</c:v>
                </c:pt>
                <c:pt idx="34">
                  <c:v>43511</c:v>
                </c:pt>
                <c:pt idx="35">
                  <c:v>4793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17-A252-4384-9D7D-4ED8E1B54C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701552"/>
        <c:axId val="227134864"/>
      </c:lineChart>
      <c:dateAx>
        <c:axId val="1907015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4864"/>
        <c:crosses val="autoZero"/>
        <c:auto val="0"/>
        <c:lblOffset val="100"/>
        <c:baseTimeUnit val="days"/>
        <c:majorUnit val="10"/>
        <c:majorTimeUnit val="days"/>
        <c:minorUnit val="5"/>
        <c:minorTimeUnit val="days"/>
      </c:dateAx>
      <c:valAx>
        <c:axId val="227134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alpha val="94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701552"/>
        <c:crosses val="autoZero"/>
        <c:crossBetween val="midCat"/>
        <c:dispUnits>
          <c:builtInUnit val="tenThousands"/>
        </c:dispUnits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10a</a:t>
            </a:r>
          </a:p>
        </c:rich>
      </c:tx>
      <c:layout>
        <c:manualLayout>
          <c:xMode val="edge"/>
          <c:yMode val="edge"/>
          <c:x val="0.6734143165233407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C$24:$C$38</c:f>
              <c:numCache>
                <c:formatCode>0</c:formatCode>
                <c:ptCount val="15"/>
                <c:pt idx="0">
                  <c:v>147.96578507933958</c:v>
                </c:pt>
                <c:pt idx="1">
                  <c:v>152.35297413451514</c:v>
                </c:pt>
                <c:pt idx="2">
                  <c:v>271.23242344081405</c:v>
                </c:pt>
                <c:pt idx="3">
                  <c:v>249.75359895972846</c:v>
                </c:pt>
                <c:pt idx="4">
                  <c:v>264.70071929450773</c:v>
                </c:pt>
                <c:pt idx="5">
                  <c:v>157.14497624517912</c:v>
                </c:pt>
                <c:pt idx="6">
                  <c:v>208.92506846676199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322.20465669501658</c:v>
                </c:pt>
                <c:pt idx="13">
                  <c:v>#N/A</c:v>
                </c:pt>
                <c:pt idx="14">
                  <c:v>243.7995959185852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60C-491C-950A-B9B1D7410D2B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D$24:$D$38</c:f>
              <c:numCache>
                <c:formatCode>0</c:formatCode>
                <c:ptCount val="15"/>
                <c:pt idx="0">
                  <c:v>50.230737457863093</c:v>
                </c:pt>
                <c:pt idx="1">
                  <c:v>50.502782432951157</c:v>
                </c:pt>
                <c:pt idx="2">
                  <c:v>241.43279489989987</c:v>
                </c:pt>
                <c:pt idx="3">
                  <c:v>51.368853681997436</c:v>
                </c:pt>
                <c:pt idx="4">
                  <c:v>74.31949886103439</c:v>
                </c:pt>
                <c:pt idx="5">
                  <c:v>45.301436406197709</c:v>
                </c:pt>
                <c:pt idx="6">
                  <c:v>49.365370524651048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93.047576705561013</c:v>
                </c:pt>
                <c:pt idx="13">
                  <c:v>#N/A</c:v>
                </c:pt>
                <c:pt idx="14">
                  <c:v>119.866384410097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60C-491C-950A-B9B1D7410D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39216"/>
        <c:axId val="227138128"/>
      </c:scatterChart>
      <c:valAx>
        <c:axId val="227139216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8128"/>
        <c:crosses val="autoZero"/>
        <c:crossBetween val="midCat"/>
      </c:valAx>
      <c:valAx>
        <c:axId val="227138128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9216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13a</a:t>
            </a:r>
          </a:p>
        </c:rich>
      </c:tx>
      <c:layout>
        <c:manualLayout>
          <c:xMode val="edge"/>
          <c:yMode val="edge"/>
          <c:x val="0.6734143165233407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E$24:$E$38</c:f>
              <c:numCache>
                <c:formatCode>0</c:formatCode>
                <c:ptCount val="15"/>
                <c:pt idx="0">
                  <c:v>209.51879890078743</c:v>
                </c:pt>
                <c:pt idx="1">
                  <c:v>123.55634339082447</c:v>
                </c:pt>
                <c:pt idx="2">
                  <c:v>188.21944595023365</c:v>
                </c:pt>
                <c:pt idx="3">
                  <c:v>235.02689854800519</c:v>
                </c:pt>
                <c:pt idx="4">
                  <c:v>#N/A</c:v>
                </c:pt>
                <c:pt idx="5">
                  <c:v>189.56037846731923</c:v>
                </c:pt>
                <c:pt idx="6">
                  <c:v>195.97172279499409</c:v>
                </c:pt>
                <c:pt idx="7">
                  <c:v>184.00445213146125</c:v>
                </c:pt>
                <c:pt idx="8">
                  <c:v>#N/A</c:v>
                </c:pt>
                <c:pt idx="9">
                  <c:v>#N/A</c:v>
                </c:pt>
                <c:pt idx="10">
                  <c:v>280.01075199428664</c:v>
                </c:pt>
                <c:pt idx="11">
                  <c:v>#N/A</c:v>
                </c:pt>
                <c:pt idx="12">
                  <c:v>#N/A</c:v>
                </c:pt>
                <c:pt idx="13">
                  <c:v>209.67229432679352</c:v>
                </c:pt>
                <c:pt idx="14">
                  <c:v>206.5460833829737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B99-4E9B-AFF0-9399A7EA5EC8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F$24:$F$38</c:f>
              <c:numCache>
                <c:formatCode>0</c:formatCode>
                <c:ptCount val="15"/>
                <c:pt idx="0">
                  <c:v>77.938689638678269</c:v>
                </c:pt>
                <c:pt idx="1">
                  <c:v>57.302081552612314</c:v>
                </c:pt>
                <c:pt idx="2">
                  <c:v>136.03741400424377</c:v>
                </c:pt>
                <c:pt idx="3">
                  <c:v>50.272935081864922</c:v>
                </c:pt>
                <c:pt idx="4">
                  <c:v>#N/A</c:v>
                </c:pt>
                <c:pt idx="5">
                  <c:v>117.09791680425778</c:v>
                </c:pt>
                <c:pt idx="6">
                  <c:v>68.325042518870262</c:v>
                </c:pt>
                <c:pt idx="7">
                  <c:v>73.229851313862341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50.982324072064046</c:v>
                </c:pt>
                <c:pt idx="14">
                  <c:v>43.76842129819868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B99-4E9B-AFF0-9399A7EA5E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45200"/>
        <c:axId val="227139760"/>
      </c:scatterChart>
      <c:valAx>
        <c:axId val="227145200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9760"/>
        <c:crosses val="autoZero"/>
        <c:crossBetween val="midCat"/>
      </c:valAx>
      <c:valAx>
        <c:axId val="227139760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5200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47a</a:t>
            </a:r>
          </a:p>
        </c:rich>
      </c:tx>
      <c:layout>
        <c:manualLayout>
          <c:xMode val="edge"/>
          <c:yMode val="edge"/>
          <c:x val="0.6734143165233407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G$24:$G$38</c:f>
              <c:numCache>
                <c:formatCode>0</c:formatCode>
                <c:ptCount val="15"/>
                <c:pt idx="0">
                  <c:v>232.09733335703504</c:v>
                </c:pt>
                <c:pt idx="1">
                  <c:v>242.01105270477404</c:v>
                </c:pt>
                <c:pt idx="2">
                  <c:v>277.58413890497286</c:v>
                </c:pt>
                <c:pt idx="3">
                  <c:v>213.34917723742404</c:v>
                </c:pt>
                <c:pt idx="4">
                  <c:v>253.92433165163695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313.71840251351671</c:v>
                </c:pt>
                <c:pt idx="9">
                  <c:v>292.14916583363311</c:v>
                </c:pt>
                <c:pt idx="10">
                  <c:v>#N/A</c:v>
                </c:pt>
                <c:pt idx="11">
                  <c:v>#N/A</c:v>
                </c:pt>
                <c:pt idx="12">
                  <c:v>243.74262095992671</c:v>
                </c:pt>
                <c:pt idx="13">
                  <c:v>287.78007607547329</c:v>
                </c:pt>
                <c:pt idx="14">
                  <c:v>286.5498751422821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E8A-4A5C-A895-AB4B6AD7A59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H$24:$H$38</c:f>
              <c:numCache>
                <c:formatCode>0</c:formatCode>
                <c:ptCount val="15"/>
                <c:pt idx="0">
                  <c:v>240.62021456640412</c:v>
                </c:pt>
                <c:pt idx="1">
                  <c:v>195.37777387019523</c:v>
                </c:pt>
                <c:pt idx="2">
                  <c:v>266.76175520672041</c:v>
                </c:pt>
                <c:pt idx="3">
                  <c:v>275.42751283424604</c:v>
                </c:pt>
                <c:pt idx="4">
                  <c:v>339.08270995786603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130.83783063362137</c:v>
                </c:pt>
                <c:pt idx="9">
                  <c:v>289.29936171435514</c:v>
                </c:pt>
                <c:pt idx="10">
                  <c:v>#N/A</c:v>
                </c:pt>
                <c:pt idx="11">
                  <c:v>#N/A</c:v>
                </c:pt>
                <c:pt idx="12">
                  <c:v>232.05190399872779</c:v>
                </c:pt>
                <c:pt idx="13">
                  <c:v>271.73081081325756</c:v>
                </c:pt>
                <c:pt idx="14">
                  <c:v>296.418159492523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E8A-4A5C-A895-AB4B6AD7A5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45744"/>
        <c:axId val="227138672"/>
      </c:scatterChart>
      <c:valAx>
        <c:axId val="227145744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8672"/>
        <c:crosses val="autoZero"/>
        <c:crossBetween val="midCat"/>
      </c:valAx>
      <c:valAx>
        <c:axId val="227138672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5744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49b</a:t>
            </a:r>
          </a:p>
        </c:rich>
      </c:tx>
      <c:layout>
        <c:manualLayout>
          <c:xMode val="edge"/>
          <c:yMode val="edge"/>
          <c:x val="0.6562817581872044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I$24:$I$38</c:f>
              <c:numCache>
                <c:formatCode>0</c:formatCode>
                <c:ptCount val="15"/>
                <c:pt idx="0">
                  <c:v>233.58787375208246</c:v>
                </c:pt>
                <c:pt idx="1">
                  <c:v>263.21424539940341</c:v>
                </c:pt>
                <c:pt idx="2">
                  <c:v>332.51837034030689</c:v>
                </c:pt>
                <c:pt idx="3">
                  <c:v>322.39662737081466</c:v>
                </c:pt>
                <c:pt idx="4">
                  <c:v>219.87996832341477</c:v>
                </c:pt>
                <c:pt idx="5">
                  <c:v>362.61204452041579</c:v>
                </c:pt>
                <c:pt idx="6">
                  <c:v>252.41490397318401</c:v>
                </c:pt>
                <c:pt idx="7">
                  <c:v>168.52868480684836</c:v>
                </c:pt>
                <c:pt idx="8">
                  <c:v>351.5928871176236</c:v>
                </c:pt>
                <c:pt idx="9">
                  <c:v>180.27994382173554</c:v>
                </c:pt>
                <c:pt idx="10">
                  <c:v>#N/A</c:v>
                </c:pt>
                <c:pt idx="11">
                  <c:v>#N/A</c:v>
                </c:pt>
                <c:pt idx="12">
                  <c:v>319.94613141035921</c:v>
                </c:pt>
                <c:pt idx="13">
                  <c:v>365.34905603208352</c:v>
                </c:pt>
                <c:pt idx="14">
                  <c:v>344.3202236169405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4F9-4FE3-AE4A-64B5076667F2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J$24:$J$38</c:f>
              <c:numCache>
                <c:formatCode>0</c:formatCode>
                <c:ptCount val="15"/>
                <c:pt idx="0">
                  <c:v>124.604248558305</c:v>
                </c:pt>
                <c:pt idx="1">
                  <c:v>189.37107542056782</c:v>
                </c:pt>
                <c:pt idx="2">
                  <c:v>254.23605404233535</c:v>
                </c:pt>
                <c:pt idx="3">
                  <c:v>247.24235753037703</c:v>
                </c:pt>
                <c:pt idx="4">
                  <c:v>215.82604296619564</c:v>
                </c:pt>
                <c:pt idx="5">
                  <c:v>273.15518533530627</c:v>
                </c:pt>
                <c:pt idx="6">
                  <c:v>206.39098461711902</c:v>
                </c:pt>
                <c:pt idx="7">
                  <c:v>192.14927446856746</c:v>
                </c:pt>
                <c:pt idx="8">
                  <c:v>#N/A</c:v>
                </c:pt>
                <c:pt idx="9">
                  <c:v>147.96302360796358</c:v>
                </c:pt>
                <c:pt idx="10">
                  <c:v>#N/A</c:v>
                </c:pt>
                <c:pt idx="11">
                  <c:v>#N/A</c:v>
                </c:pt>
                <c:pt idx="12">
                  <c:v>285.72728004579881</c:v>
                </c:pt>
                <c:pt idx="13">
                  <c:v>312.8641709912568</c:v>
                </c:pt>
                <c:pt idx="14">
                  <c:v>301.9267453789765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4F9-4FE3-AE4A-64B5076667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37584"/>
        <c:axId val="227140304"/>
      </c:scatterChart>
      <c:valAx>
        <c:axId val="227137584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0304"/>
        <c:crosses val="autoZero"/>
        <c:crossBetween val="midCat"/>
      </c:valAx>
      <c:valAx>
        <c:axId val="227140304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7584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71a</a:t>
            </a:r>
          </a:p>
        </c:rich>
      </c:tx>
      <c:layout>
        <c:manualLayout>
          <c:xMode val="edge"/>
          <c:yMode val="edge"/>
          <c:x val="0.65628175818720447"/>
          <c:y val="1.95987654320987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K$24:$K$38</c:f>
              <c:numCache>
                <c:formatCode>0</c:formatCode>
                <c:ptCount val="15"/>
                <c:pt idx="0">
                  <c:v>242.65583330067014</c:v>
                </c:pt>
                <c:pt idx="1">
                  <c:v>338.27880032802466</c:v>
                </c:pt>
                <c:pt idx="2">
                  <c:v>326.56572134895009</c:v>
                </c:pt>
                <c:pt idx="3">
                  <c:v>259.71268174329191</c:v>
                </c:pt>
                <c:pt idx="4">
                  <c:v>296.41385632378757</c:v>
                </c:pt>
                <c:pt idx="5">
                  <c:v>316.8481681071695</c:v>
                </c:pt>
                <c:pt idx="6">
                  <c:v>315.31793965672961</c:v>
                </c:pt>
                <c:pt idx="7">
                  <c:v>321.26188708023409</c:v>
                </c:pt>
                <c:pt idx="8">
                  <c:v>377.4271654984467</c:v>
                </c:pt>
                <c:pt idx="9">
                  <c:v>280.64978201329905</c:v>
                </c:pt>
                <c:pt idx="10">
                  <c:v>#N/A</c:v>
                </c:pt>
                <c:pt idx="11">
                  <c:v>#N/A</c:v>
                </c:pt>
                <c:pt idx="12">
                  <c:v>395.47687250373167</c:v>
                </c:pt>
                <c:pt idx="13">
                  <c:v>307.66421222861271</c:v>
                </c:pt>
                <c:pt idx="14">
                  <c:v>320.6915370434508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1CF-49F1-92E1-90CCC434E947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L$24:$L$38</c:f>
              <c:numCache>
                <c:formatCode>0</c:formatCode>
                <c:ptCount val="15"/>
                <c:pt idx="0">
                  <c:v>34.311832807485864</c:v>
                </c:pt>
                <c:pt idx="1">
                  <c:v>29.345586333128477</c:v>
                </c:pt>
                <c:pt idx="2">
                  <c:v>37.531497617984442</c:v>
                </c:pt>
                <c:pt idx="3">
                  <c:v>41.206650584341432</c:v>
                </c:pt>
                <c:pt idx="4">
                  <c:v>64.3566612212</c:v>
                </c:pt>
                <c:pt idx="5">
                  <c:v>38.28754080424774</c:v>
                </c:pt>
                <c:pt idx="6">
                  <c:v>47.309397172403713</c:v>
                </c:pt>
                <c:pt idx="7">
                  <c:v>52.045708614556254</c:v>
                </c:pt>
                <c:pt idx="8">
                  <c:v>#N/A</c:v>
                </c:pt>
                <c:pt idx="9">
                  <c:v>53.676052401432983</c:v>
                </c:pt>
                <c:pt idx="10">
                  <c:v>#N/A</c:v>
                </c:pt>
                <c:pt idx="11">
                  <c:v>#N/A</c:v>
                </c:pt>
                <c:pt idx="12">
                  <c:v>47.478301917124192</c:v>
                </c:pt>
                <c:pt idx="13">
                  <c:v>58.965732235473467</c:v>
                </c:pt>
                <c:pt idx="14">
                  <c:v>44.20477182785487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01CF-49F1-92E1-90CCC434E9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43024"/>
        <c:axId val="227140848"/>
      </c:scatterChart>
      <c:valAx>
        <c:axId val="227143024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0848"/>
        <c:crosses val="autoZero"/>
        <c:crossBetween val="midCat"/>
      </c:valAx>
      <c:valAx>
        <c:axId val="227140848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3024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85b</a:t>
            </a:r>
          </a:p>
        </c:rich>
      </c:tx>
      <c:layout>
        <c:manualLayout>
          <c:xMode val="edge"/>
          <c:yMode val="edge"/>
          <c:x val="0.6391491998510681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M$24:$M$38</c:f>
              <c:numCache>
                <c:formatCode>0</c:formatCode>
                <c:ptCount val="15"/>
                <c:pt idx="0">
                  <c:v>147.39620591575058</c:v>
                </c:pt>
                <c:pt idx="1">
                  <c:v>285.83621481826174</c:v>
                </c:pt>
                <c:pt idx="2">
                  <c:v>229.64180009749549</c:v>
                </c:pt>
                <c:pt idx="3">
                  <c:v>213.18756367250145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321.14771961992693</c:v>
                </c:pt>
                <c:pt idx="9">
                  <c:v>218.50320139203245</c:v>
                </c:pt>
                <c:pt idx="10">
                  <c:v>285.5896129148897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CDF-4C29-AE93-609642A6CE86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N$24:$N$38</c:f>
              <c:numCache>
                <c:formatCode>0</c:formatCode>
                <c:ptCount val="15"/>
                <c:pt idx="0">
                  <c:v>78.698098142142584</c:v>
                </c:pt>
                <c:pt idx="1">
                  <c:v>118.93422752080207</c:v>
                </c:pt>
                <c:pt idx="2">
                  <c:v>170.91992223128008</c:v>
                </c:pt>
                <c:pt idx="3">
                  <c:v>65.953198420289766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184.28977752317149</c:v>
                </c:pt>
                <c:pt idx="9">
                  <c:v>68.210522688728574</c:v>
                </c:pt>
                <c:pt idx="10">
                  <c:v>74.6299200497957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CDF-4C29-AE93-609642A6CE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33776"/>
        <c:axId val="227141392"/>
      </c:scatterChart>
      <c:valAx>
        <c:axId val="227133776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1392"/>
        <c:crosses val="autoZero"/>
        <c:crossBetween val="midCat"/>
      </c:valAx>
      <c:valAx>
        <c:axId val="227141392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3776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hu-HU"/>
              <a:t>OR98a</a:t>
            </a:r>
          </a:p>
        </c:rich>
      </c:tx>
      <c:layout>
        <c:manualLayout>
          <c:xMode val="edge"/>
          <c:yMode val="edge"/>
          <c:x val="0.74765540264659813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43727598566308"/>
          <c:y val="9.0864969135802456E-2"/>
          <c:w val="0.80102688172043013"/>
          <c:h val="0.74239120370370371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88500"/>
                </a:schemeClr>
              </a:solidFill>
              <a:ln w="9525">
                <a:solidFill>
                  <a:schemeClr val="dk1">
                    <a:tint val="885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885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O$24:$O$38</c:f>
              <c:numCache>
                <c:formatCode>0</c:formatCode>
                <c:ptCount val="15"/>
                <c:pt idx="0">
                  <c:v>226.06322497668154</c:v>
                </c:pt>
                <c:pt idx="1">
                  <c:v>237.09698025023985</c:v>
                </c:pt>
                <c:pt idx="2">
                  <c:v>461.538460662364</c:v>
                </c:pt>
                <c:pt idx="3">
                  <c:v>397.35678133968395</c:v>
                </c:pt>
                <c:pt idx="4">
                  <c:v>398.21938707110587</c:v>
                </c:pt>
                <c:pt idx="5">
                  <c:v>376.76297823947755</c:v>
                </c:pt>
                <c:pt idx="6">
                  <c:v>330.3403054683759</c:v>
                </c:pt>
                <c:pt idx="7">
                  <c:v>351.59775246275302</c:v>
                </c:pt>
                <c:pt idx="8">
                  <c:v>425.81151619371519</c:v>
                </c:pt>
                <c:pt idx="9">
                  <c:v>362.76144651358828</c:v>
                </c:pt>
                <c:pt idx="10">
                  <c:v>#N/A</c:v>
                </c:pt>
                <c:pt idx="11">
                  <c:v>#N/A</c:v>
                </c:pt>
                <c:pt idx="12">
                  <c:v>372.39660293800239</c:v>
                </c:pt>
                <c:pt idx="13">
                  <c:v>287.61204949730381</c:v>
                </c:pt>
                <c:pt idx="14">
                  <c:v>363.3734590474742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F0D-4151-B83C-C1C9F7B95E79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dk1">
                  <a:tint val="55000"/>
                </a:schemeClr>
              </a:solidFill>
              <a:ln w="9525">
                <a:solidFill>
                  <a:schemeClr val="dk1">
                    <a:tint val="55000"/>
                  </a:schemeClr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dk1">
                    <a:tint val="55000"/>
                  </a:schemeClr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expresszió stabilitás (3)'!$B$24:$B$38</c:f>
              <c:numCache>
                <c:formatCode>General</c:formatCode>
                <c:ptCount val="15"/>
                <c:pt idx="0">
                  <c:v>1</c:v>
                </c:pt>
                <c:pt idx="1">
                  <c:v>7</c:v>
                </c:pt>
                <c:pt idx="2">
                  <c:v>8</c:v>
                </c:pt>
                <c:pt idx="3">
                  <c:v>12</c:v>
                </c:pt>
                <c:pt idx="4">
                  <c:v>13</c:v>
                </c:pt>
                <c:pt idx="5">
                  <c:v>15</c:v>
                </c:pt>
                <c:pt idx="6">
                  <c:v>19</c:v>
                </c:pt>
                <c:pt idx="7">
                  <c:v>22</c:v>
                </c:pt>
                <c:pt idx="8">
                  <c:v>36</c:v>
                </c:pt>
                <c:pt idx="9">
                  <c:v>42</c:v>
                </c:pt>
                <c:pt idx="10">
                  <c:v>44</c:v>
                </c:pt>
                <c:pt idx="11">
                  <c:v>50</c:v>
                </c:pt>
                <c:pt idx="12">
                  <c:v>51</c:v>
                </c:pt>
                <c:pt idx="13">
                  <c:v>56</c:v>
                </c:pt>
                <c:pt idx="14">
                  <c:v>58</c:v>
                </c:pt>
              </c:numCache>
            </c:numRef>
          </c:xVal>
          <c:yVal>
            <c:numRef>
              <c:f>'expresszió stabilitás (3)'!$P$24:$P$38</c:f>
              <c:numCache>
                <c:formatCode>0</c:formatCode>
                <c:ptCount val="15"/>
                <c:pt idx="0">
                  <c:v>57.32390915407106</c:v>
                </c:pt>
                <c:pt idx="1">
                  <c:v>39.314271912326653</c:v>
                </c:pt>
                <c:pt idx="2">
                  <c:v>66.145238552512069</c:v>
                </c:pt>
                <c:pt idx="3">
                  <c:v>81.246082221571342</c:v>
                </c:pt>
                <c:pt idx="4">
                  <c:v>170.18603009446076</c:v>
                </c:pt>
                <c:pt idx="5">
                  <c:v>197.08097654930387</c:v>
                </c:pt>
                <c:pt idx="6">
                  <c:v>183.13826552232689</c:v>
                </c:pt>
                <c:pt idx="7">
                  <c:v>170.51610435392649</c:v>
                </c:pt>
                <c:pt idx="8">
                  <c:v>#N/A</c:v>
                </c:pt>
                <c:pt idx="9">
                  <c:v>121.52448285335853</c:v>
                </c:pt>
                <c:pt idx="10">
                  <c:v>#N/A</c:v>
                </c:pt>
                <c:pt idx="11">
                  <c:v>#N/A</c:v>
                </c:pt>
                <c:pt idx="12">
                  <c:v>211.13668002656632</c:v>
                </c:pt>
                <c:pt idx="13">
                  <c:v>182.01180145195897</c:v>
                </c:pt>
                <c:pt idx="14">
                  <c:v>250.977222404691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F0D-4151-B83C-C1C9F7B95E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144112"/>
        <c:axId val="227134320"/>
      </c:scatterChart>
      <c:valAx>
        <c:axId val="227144112"/>
        <c:scaling>
          <c:orientation val="minMax"/>
          <c:max val="6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34320"/>
        <c:crosses val="autoZero"/>
        <c:crossBetween val="midCat"/>
      </c:valAx>
      <c:valAx>
        <c:axId val="227134320"/>
        <c:scaling>
          <c:orientation val="minMax"/>
          <c:max val="50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7144112"/>
        <c:crosses val="autoZero"/>
        <c:crossBetween val="midCat"/>
        <c:majorUnit val="10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686</cdr:x>
      <cdr:y>0.32651</cdr:y>
    </cdr:from>
    <cdr:to>
      <cdr:x>0.13874</cdr:x>
      <cdr:y>0.51389</cdr:y>
    </cdr:to>
    <cdr:sp macro="" textlink="">
      <cdr:nvSpPr>
        <cdr:cNvPr id="2" name="TextBox 42"/>
        <cdr:cNvSpPr txBox="1"/>
      </cdr:nvSpPr>
      <cdr:spPr>
        <a:xfrm xmlns:a="http://schemas.openxmlformats.org/drawingml/2006/main" rot="-5400000">
          <a:off x="369452" y="1512675"/>
          <a:ext cx="732893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hu-HU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100" dirty="0"/>
            <a:t>RFU x 10</a:t>
          </a:r>
          <a:r>
            <a:rPr lang="hu-HU" sz="1100" baseline="30000" dirty="0"/>
            <a:t>4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42964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88778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39545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10488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51321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251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1590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74614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1226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12016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62784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2874D-6FCF-4408-A4DD-15CAA1D65DB8}" type="datetimeFigureOut">
              <a:rPr lang="hu-HU" smtClean="0"/>
              <a:t>2023. 11. 30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0FCC4-392D-4351-925D-2EBF98B4B884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93647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2.xml"/><Relationship Id="rId7" Type="http://schemas.openxmlformats.org/officeDocument/2006/relationships/chart" Target="../charts/chart5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image" Target="../media/image1.png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8755639"/>
              </p:ext>
            </p:extLst>
          </p:nvPr>
        </p:nvGraphicFramePr>
        <p:xfrm>
          <a:off x="3701327" y="267551"/>
          <a:ext cx="3124962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0" name="Chart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7429278"/>
              </p:ext>
            </p:extLst>
          </p:nvPr>
        </p:nvGraphicFramePr>
        <p:xfrm>
          <a:off x="363885" y="273777"/>
          <a:ext cx="3101075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1" name="TextBox 40"/>
          <p:cNvSpPr txBox="1"/>
          <p:nvPr/>
        </p:nvSpPr>
        <p:spPr>
          <a:xfrm>
            <a:off x="17023" y="46049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350" b="1" dirty="0"/>
              <a:t>A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362939" y="46049"/>
            <a:ext cx="28245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350" b="1" dirty="0"/>
              <a:t>B</a:t>
            </a:r>
          </a:p>
        </p:txBody>
      </p:sp>
      <p:sp>
        <p:nvSpPr>
          <p:cNvPr id="43" name="TextBox 42"/>
          <p:cNvSpPr txBox="1"/>
          <p:nvPr/>
        </p:nvSpPr>
        <p:spPr>
          <a:xfrm rot="-5400000">
            <a:off x="-123309" y="1073254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100" dirty="0"/>
              <a:t>RFU x 10</a:t>
            </a:r>
            <a:r>
              <a:rPr lang="hu-HU" sz="1100" baseline="30000" dirty="0"/>
              <a:t>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418315" y="2256884"/>
            <a:ext cx="7713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100" dirty="0"/>
              <a:t>Time (sec)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177925" y="493478"/>
            <a:ext cx="590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/>
              <a:t>OR10aOR49b</a:t>
            </a:r>
          </a:p>
          <a:p>
            <a:r>
              <a:rPr lang="hu-HU" sz="1000" dirty="0"/>
              <a:t>OR71a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4052831" y="770477"/>
            <a:ext cx="145256" cy="0"/>
          </a:xfrm>
          <a:prstGeom prst="line">
            <a:avLst/>
          </a:prstGeom>
          <a:ln w="19050" cmpd="sng">
            <a:solidFill>
              <a:srgbClr val="C0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052831" y="922878"/>
            <a:ext cx="145256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770721" y="2256884"/>
            <a:ext cx="7713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100" dirty="0"/>
              <a:t>Time (sec)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674220" y="477294"/>
            <a:ext cx="674925" cy="707886"/>
            <a:chOff x="2455764" y="4122822"/>
            <a:chExt cx="674925" cy="707886"/>
          </a:xfrm>
        </p:grpSpPr>
        <p:sp>
          <p:nvSpPr>
            <p:cNvPr id="50" name="TextBox 49"/>
            <p:cNvSpPr txBox="1"/>
            <p:nvPr/>
          </p:nvSpPr>
          <p:spPr>
            <a:xfrm>
              <a:off x="2539731" y="4122822"/>
              <a:ext cx="59095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000" dirty="0"/>
                <a:t>OR13aOR47a</a:t>
              </a:r>
            </a:p>
            <a:p>
              <a:r>
                <a:rPr lang="hu-HU" sz="1000" dirty="0"/>
                <a:t>OR85b</a:t>
              </a:r>
            </a:p>
            <a:p>
              <a:r>
                <a:rPr lang="hu-HU" sz="1000" dirty="0"/>
                <a:t>OR98a</a:t>
              </a:r>
            </a:p>
          </p:txBody>
        </p:sp>
        <p:cxnSp>
          <p:nvCxnSpPr>
            <p:cNvPr id="51" name="Straight Connector 50"/>
            <p:cNvCxnSpPr/>
            <p:nvPr/>
          </p:nvCxnSpPr>
          <p:spPr>
            <a:xfrm>
              <a:off x="2455764" y="4397463"/>
              <a:ext cx="145256" cy="0"/>
            </a:xfrm>
            <a:prstGeom prst="line">
              <a:avLst/>
            </a:prstGeom>
            <a:ln w="19050" cmpd="sng">
              <a:solidFill>
                <a:srgbClr val="FFC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2455764" y="4549864"/>
              <a:ext cx="145256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2455764" y="4700414"/>
              <a:ext cx="145256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2455764" y="4251413"/>
              <a:ext cx="145256" cy="0"/>
            </a:xfrm>
            <a:prstGeom prst="line">
              <a:avLst/>
            </a:prstGeom>
            <a:ln w="19050" cmpd="sng">
              <a:solidFill>
                <a:srgbClr val="0070C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5" name="Straight Connector 54"/>
          <p:cNvCxnSpPr/>
          <p:nvPr/>
        </p:nvCxnSpPr>
        <p:spPr>
          <a:xfrm>
            <a:off x="4052831" y="610457"/>
            <a:ext cx="145256" cy="0"/>
          </a:xfrm>
          <a:prstGeom prst="line">
            <a:avLst/>
          </a:prstGeom>
          <a:ln w="19050" cmpd="sng">
            <a:solidFill>
              <a:srgbClr val="00206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 rot="-5400000">
            <a:off x="3286097" y="1072752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100" dirty="0"/>
              <a:t>RFU x 10</a:t>
            </a:r>
            <a:r>
              <a:rPr lang="hu-HU" sz="1100" baseline="30000" dirty="0"/>
              <a:t>4</a:t>
            </a:r>
          </a:p>
        </p:txBody>
      </p:sp>
      <p:sp>
        <p:nvSpPr>
          <p:cNvPr id="9" name="Rectangle 8"/>
          <p:cNvSpPr/>
          <p:nvPr/>
        </p:nvSpPr>
        <p:spPr>
          <a:xfrm>
            <a:off x="56924" y="2487389"/>
            <a:ext cx="67371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</a:t>
            </a:r>
            <a:r>
              <a:rPr lang="en-US" sz="1200" b="1"/>
              <a:t>Figure </a:t>
            </a:r>
            <a:r>
              <a:rPr lang="en-US" sz="1200" b="1" smtClean="0"/>
              <a:t>1</a:t>
            </a:r>
            <a:r>
              <a:rPr lang="en-US" sz="1200" b="1" dirty="0"/>
              <a:t>. Inducible GCaMP6-Orco expression of </a:t>
            </a:r>
            <a:r>
              <a:rPr lang="hu-HU" sz="1200" b="1" dirty="0" smtClean="0">
                <a:solidFill>
                  <a:srgbClr val="FF0000"/>
                </a:solidFill>
              </a:rPr>
              <a:t>the</a:t>
            </a:r>
            <a:r>
              <a:rPr lang="hu-HU" sz="1200" b="1" dirty="0" smtClean="0"/>
              <a:t> </a:t>
            </a:r>
            <a:r>
              <a:rPr lang="en-US" sz="1200" b="1" dirty="0" smtClean="0"/>
              <a:t>seven </a:t>
            </a:r>
            <a:r>
              <a:rPr lang="en-US" sz="1200" b="1" dirty="0"/>
              <a:t>biosensor cell lines. </a:t>
            </a:r>
            <a:endParaRPr lang="hu-HU" sz="1200" b="1" dirty="0"/>
          </a:p>
          <a:p>
            <a:pPr marL="228600" indent="-228600">
              <a:buAutoNum type="alphaUcParenBoth"/>
            </a:pPr>
            <a:r>
              <a:rPr lang="en-US" sz="1200" dirty="0"/>
              <a:t>Expression of the four cell lines generated with the MIODOGGB expression vectors</a:t>
            </a:r>
            <a:r>
              <a:rPr lang="hu-HU" sz="1200" dirty="0"/>
              <a:t> (</a:t>
            </a:r>
            <a:r>
              <a:rPr lang="hu-HU" sz="1200" dirty="0" err="1"/>
              <a:t>Figure</a:t>
            </a:r>
            <a:r>
              <a:rPr lang="hu-HU" sz="1200" dirty="0"/>
              <a:t> 1A).</a:t>
            </a:r>
          </a:p>
          <a:p>
            <a:r>
              <a:rPr lang="en-US" sz="1200" dirty="0"/>
              <a:t>(B) Expression of the three cell lines generated by </a:t>
            </a:r>
            <a:r>
              <a:rPr lang="en-US" sz="1200" dirty="0" err="1"/>
              <a:t>cotransfection</a:t>
            </a:r>
            <a:r>
              <a:rPr lang="en-US" sz="1200" dirty="0"/>
              <a:t> of the </a:t>
            </a:r>
            <a:r>
              <a:rPr lang="en-US" sz="1200" dirty="0" err="1"/>
              <a:t>MIOp</a:t>
            </a:r>
            <a:r>
              <a:rPr lang="en-US" sz="1200" dirty="0"/>
              <a:t> plasmids containing the corresponding OR and the DOGGB expression vectors containing the GCaMP6-Orco fusion protein</a:t>
            </a:r>
            <a:r>
              <a:rPr lang="hu-HU" sz="1200" dirty="0"/>
              <a:t>.</a:t>
            </a:r>
          </a:p>
          <a:p>
            <a:r>
              <a:rPr lang="en-US" sz="1200" dirty="0"/>
              <a:t>In all cases, 50 µM VUAA1 was injected into the wells and the fluorescence intensity change was recorded in three replicates. Dashed curves: GCaMP6-Orco expression induced in cells by doxycycline for 48 h, solid curves: no doxycycline added to the cells (control). </a:t>
            </a:r>
            <a:endParaRPr lang="hu-HU" sz="1200" dirty="0"/>
          </a:p>
        </p:txBody>
      </p:sp>
      <p:sp>
        <p:nvSpPr>
          <p:cNvPr id="58" name="Rectangle 57"/>
          <p:cNvSpPr/>
          <p:nvPr/>
        </p:nvSpPr>
        <p:spPr>
          <a:xfrm rot="-5400000">
            <a:off x="-131442" y="4472239"/>
            <a:ext cx="5709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∆𝐹 (%)</a:t>
            </a:r>
          </a:p>
        </p:txBody>
      </p:sp>
      <p:sp>
        <p:nvSpPr>
          <p:cNvPr id="59" name="Rectangle 58"/>
          <p:cNvSpPr/>
          <p:nvPr/>
        </p:nvSpPr>
        <p:spPr>
          <a:xfrm rot="-5400000">
            <a:off x="-97766" y="5963265"/>
            <a:ext cx="5709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∆𝐹 (%)</a:t>
            </a:r>
          </a:p>
        </p:txBody>
      </p:sp>
      <p:sp>
        <p:nvSpPr>
          <p:cNvPr id="60" name="Rectangle 59"/>
          <p:cNvSpPr/>
          <p:nvPr/>
        </p:nvSpPr>
        <p:spPr>
          <a:xfrm rot="-5400000">
            <a:off x="-97764" y="7724300"/>
            <a:ext cx="5709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1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∆𝐹 (%)</a:t>
            </a:r>
          </a:p>
        </p:txBody>
      </p:sp>
      <p:sp>
        <p:nvSpPr>
          <p:cNvPr id="61" name="Rectangle 60"/>
          <p:cNvSpPr/>
          <p:nvPr/>
        </p:nvSpPr>
        <p:spPr>
          <a:xfrm>
            <a:off x="925883" y="5304211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2" name="Rectangle 61"/>
          <p:cNvSpPr/>
          <p:nvPr/>
        </p:nvSpPr>
        <p:spPr>
          <a:xfrm>
            <a:off x="3080266" y="5307511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3" name="Rectangle 62"/>
          <p:cNvSpPr/>
          <p:nvPr/>
        </p:nvSpPr>
        <p:spPr>
          <a:xfrm>
            <a:off x="5249593" y="5304210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4" name="Rectangle 63"/>
          <p:cNvSpPr/>
          <p:nvPr/>
        </p:nvSpPr>
        <p:spPr>
          <a:xfrm>
            <a:off x="925883" y="6857958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5" name="Rectangle 64"/>
          <p:cNvSpPr/>
          <p:nvPr/>
        </p:nvSpPr>
        <p:spPr>
          <a:xfrm>
            <a:off x="3080266" y="6861258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6" name="Rectangle 65"/>
          <p:cNvSpPr/>
          <p:nvPr/>
        </p:nvSpPr>
        <p:spPr>
          <a:xfrm>
            <a:off x="5249593" y="6857957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sp>
        <p:nvSpPr>
          <p:cNvPr id="67" name="Rectangle 66"/>
          <p:cNvSpPr/>
          <p:nvPr/>
        </p:nvSpPr>
        <p:spPr>
          <a:xfrm>
            <a:off x="925883" y="8349656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hu-HU" dirty="0"/>
              <a:t>Time (days)</a:t>
            </a:r>
          </a:p>
        </p:txBody>
      </p:sp>
      <p:grpSp>
        <p:nvGrpSpPr>
          <p:cNvPr id="75" name="Group 74"/>
          <p:cNvGrpSpPr/>
          <p:nvPr/>
        </p:nvGrpSpPr>
        <p:grpSpPr>
          <a:xfrm>
            <a:off x="2696258" y="7250919"/>
            <a:ext cx="1168197" cy="373676"/>
            <a:chOff x="4787900" y="3708815"/>
            <a:chExt cx="1168197" cy="373676"/>
          </a:xfrm>
        </p:grpSpPr>
        <p:pic>
          <p:nvPicPr>
            <p:cNvPr id="76" name="Picture 75"/>
            <p:cNvPicPr>
              <a:picLocks noChangeAspect="1"/>
            </p:cNvPicPr>
            <p:nvPr/>
          </p:nvPicPr>
          <p:blipFill rotWithShape="1">
            <a:blip r:embed="rId4"/>
            <a:srcRect l="63754" t="62778" r="29665" b="26514"/>
            <a:stretch/>
          </p:blipFill>
          <p:spPr>
            <a:xfrm>
              <a:off x="4787900" y="3746687"/>
              <a:ext cx="146050" cy="139700"/>
            </a:xfrm>
            <a:prstGeom prst="rect">
              <a:avLst/>
            </a:prstGeom>
          </p:spPr>
        </p:pic>
        <p:sp>
          <p:nvSpPr>
            <p:cNvPr id="78" name="TextBox 77"/>
            <p:cNvSpPr txBox="1"/>
            <p:nvPr/>
          </p:nvSpPr>
          <p:spPr>
            <a:xfrm>
              <a:off x="4860925" y="3708815"/>
              <a:ext cx="1095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Reference ligand (OR)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858201" y="3867047"/>
              <a:ext cx="8066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/>
                <a:t>VUAA1 (ORCO)</a:t>
              </a:r>
            </a:p>
          </p:txBody>
        </p:sp>
      </p:grpSp>
      <p:sp>
        <p:nvSpPr>
          <p:cNvPr id="10" name="Rectangle 9"/>
          <p:cNvSpPr/>
          <p:nvPr/>
        </p:nvSpPr>
        <p:spPr>
          <a:xfrm>
            <a:off x="17023" y="8615956"/>
            <a:ext cx="68092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200" b="1" dirty="0"/>
              <a:t>Supplementary </a:t>
            </a:r>
            <a:r>
              <a:rPr lang="hu-HU" sz="1200" b="1" dirty="0" err="1"/>
              <a:t>Figure</a:t>
            </a:r>
            <a:r>
              <a:rPr lang="hu-HU" sz="1200" b="1" dirty="0"/>
              <a:t> </a:t>
            </a:r>
            <a:r>
              <a:rPr lang="hu-HU" sz="1200" b="1" dirty="0" smtClean="0"/>
              <a:t>2</a:t>
            </a:r>
            <a:r>
              <a:rPr lang="hu-HU" sz="1200" b="1" dirty="0"/>
              <a:t>. Ligand response stability of </a:t>
            </a:r>
            <a:r>
              <a:rPr lang="hu-HU" sz="1200" b="1" dirty="0" smtClean="0">
                <a:solidFill>
                  <a:srgbClr val="FF0000"/>
                </a:solidFill>
              </a:rPr>
              <a:t>the</a:t>
            </a:r>
            <a:r>
              <a:rPr lang="hu-HU" sz="1200" b="1" dirty="0" smtClean="0"/>
              <a:t> seven </a:t>
            </a:r>
            <a:r>
              <a:rPr lang="hu-HU" sz="1200" b="1" dirty="0"/>
              <a:t>biosensor cell lines.</a:t>
            </a:r>
            <a:r>
              <a:rPr lang="hu-HU" sz="1200" dirty="0"/>
              <a:t> </a:t>
            </a:r>
          </a:p>
          <a:p>
            <a:r>
              <a:rPr lang="hu-HU" sz="1200" dirty="0"/>
              <a:t>Fluorescence intensity change (∆</a:t>
            </a:r>
            <a:r>
              <a:rPr lang="hu-HU" sz="1200" dirty="0" smtClean="0"/>
              <a:t>𝐹%) </a:t>
            </a:r>
            <a:r>
              <a:rPr lang="hu-HU" sz="1200" dirty="0"/>
              <a:t>of </a:t>
            </a:r>
            <a:r>
              <a:rPr lang="hu-HU" sz="1200" dirty="0" err="1"/>
              <a:t>the</a:t>
            </a:r>
            <a:r>
              <a:rPr lang="hu-HU" sz="1200" dirty="0"/>
              <a:t> cell lines in response to their reference ligands (light gray dots): OR10a: 10 </a:t>
            </a:r>
            <a:r>
              <a:rPr lang="el-GR" sz="1200" dirty="0"/>
              <a:t>μ</a:t>
            </a:r>
            <a:r>
              <a:rPr lang="hu-HU" sz="1200" dirty="0"/>
              <a:t>M methyl salicylate, OR13a: 10 </a:t>
            </a:r>
            <a:r>
              <a:rPr lang="el-GR" sz="1200" dirty="0"/>
              <a:t>μ</a:t>
            </a:r>
            <a:r>
              <a:rPr lang="hu-HU" sz="1200" dirty="0"/>
              <a:t>M 1-octen-3-ol, OR47a: 10 </a:t>
            </a:r>
            <a:r>
              <a:rPr lang="el-GR" sz="1200" dirty="0"/>
              <a:t>μ</a:t>
            </a:r>
            <a:r>
              <a:rPr lang="hu-HU" sz="1200" dirty="0"/>
              <a:t>M pentyl acetate, OR49b: 100 </a:t>
            </a:r>
            <a:r>
              <a:rPr lang="el-GR" sz="1200" dirty="0"/>
              <a:t>μ</a:t>
            </a:r>
            <a:r>
              <a:rPr lang="hu-HU" sz="1200" dirty="0"/>
              <a:t>M styrene, OR71a: 100 </a:t>
            </a:r>
            <a:r>
              <a:rPr lang="el-GR" sz="1200" dirty="0"/>
              <a:t>μ</a:t>
            </a:r>
            <a:r>
              <a:rPr lang="hu-HU" sz="1200" dirty="0"/>
              <a:t>M 6-methyl-5-hepten-2-one, OR85b: 100 </a:t>
            </a:r>
            <a:r>
              <a:rPr lang="el-GR" sz="1200" dirty="0"/>
              <a:t>μ</a:t>
            </a:r>
            <a:r>
              <a:rPr lang="hu-HU" sz="1200" dirty="0"/>
              <a:t>M 2-heptanone, OR98a: 100 </a:t>
            </a:r>
            <a:r>
              <a:rPr lang="el-GR" sz="1200" dirty="0"/>
              <a:t>μ</a:t>
            </a:r>
            <a:r>
              <a:rPr lang="hu-HU" sz="1200" dirty="0"/>
              <a:t>M 6-methyl-5-hepten-2-one, and to VUAA1 (black dots) during 60 days of culture.</a:t>
            </a:r>
          </a:p>
        </p:txBody>
      </p:sp>
      <p:graphicFrame>
        <p:nvGraphicFramePr>
          <p:cNvPr id="80" name="Chart 7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4642385"/>
              </p:ext>
            </p:extLst>
          </p:nvPr>
        </p:nvGraphicFramePr>
        <p:xfrm>
          <a:off x="300864" y="4048806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1" name="Chart 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703576"/>
              </p:ext>
            </p:extLst>
          </p:nvPr>
        </p:nvGraphicFramePr>
        <p:xfrm>
          <a:off x="2433976" y="4048253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2" name="Chart 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5677062"/>
              </p:ext>
            </p:extLst>
          </p:nvPr>
        </p:nvGraphicFramePr>
        <p:xfrm>
          <a:off x="4570262" y="4057049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3" name="Chart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9391665"/>
              </p:ext>
            </p:extLst>
          </p:nvPr>
        </p:nvGraphicFramePr>
        <p:xfrm>
          <a:off x="300864" y="5579390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4" name="Chart 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5886322"/>
              </p:ext>
            </p:extLst>
          </p:nvPr>
        </p:nvGraphicFramePr>
        <p:xfrm>
          <a:off x="2409820" y="5570542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85" name="Chart 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6313614"/>
              </p:ext>
            </p:extLst>
          </p:nvPr>
        </p:nvGraphicFramePr>
        <p:xfrm>
          <a:off x="4570262" y="5561694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86" name="Chart 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557571"/>
              </p:ext>
            </p:extLst>
          </p:nvPr>
        </p:nvGraphicFramePr>
        <p:xfrm>
          <a:off x="318534" y="7066856"/>
          <a:ext cx="2223836" cy="12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1" name="Oval 10"/>
          <p:cNvSpPr/>
          <p:nvPr/>
        </p:nvSpPr>
        <p:spPr>
          <a:xfrm>
            <a:off x="2743699" y="7490496"/>
            <a:ext cx="45719" cy="45719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430097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358140"/>
            <a:ext cx="6247002" cy="3955699"/>
            <a:chOff x="-1133578" y="4225086"/>
            <a:chExt cx="7345715" cy="4894367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52928242"/>
                </p:ext>
              </p:extLst>
            </p:nvPr>
          </p:nvGraphicFramePr>
          <p:xfrm>
            <a:off x="-1133578" y="4225086"/>
            <a:ext cx="7345715" cy="48392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6" name="Group 5"/>
            <p:cNvGrpSpPr/>
            <p:nvPr/>
          </p:nvGrpSpPr>
          <p:grpSpPr>
            <a:xfrm>
              <a:off x="725500" y="8586319"/>
              <a:ext cx="4836159" cy="533134"/>
              <a:chOff x="2897200" y="2995144"/>
              <a:chExt cx="4836159" cy="533134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897200" y="3119825"/>
                <a:ext cx="333375" cy="91439"/>
                <a:chOff x="767182" y="4286250"/>
                <a:chExt cx="333375" cy="91439"/>
              </a:xfrm>
            </p:grpSpPr>
            <p:cxnSp>
              <p:nvCxnSpPr>
                <p:cNvPr id="29" name="Straight Connector 28"/>
                <p:cNvCxnSpPr/>
                <p:nvPr/>
              </p:nvCxnSpPr>
              <p:spPr>
                <a:xfrm>
                  <a:off x="767182" y="432435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accent2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Oval 29"/>
                <p:cNvSpPr/>
                <p:nvPr/>
              </p:nvSpPr>
              <p:spPr>
                <a:xfrm>
                  <a:off x="898349" y="4286250"/>
                  <a:ext cx="84773" cy="91439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grpSp>
            <p:nvGrpSpPr>
              <p:cNvPr id="8" name="Group 7"/>
              <p:cNvGrpSpPr/>
              <p:nvPr/>
            </p:nvGrpSpPr>
            <p:grpSpPr>
              <a:xfrm>
                <a:off x="2897200" y="3280124"/>
                <a:ext cx="333375" cy="91439"/>
                <a:chOff x="919582" y="3173730"/>
                <a:chExt cx="333375" cy="91439"/>
              </a:xfrm>
            </p:grpSpPr>
            <p:cxnSp>
              <p:nvCxnSpPr>
                <p:cNvPr id="27" name="Straight Connector 26"/>
                <p:cNvCxnSpPr/>
                <p:nvPr/>
              </p:nvCxnSpPr>
              <p:spPr>
                <a:xfrm>
                  <a:off x="919582" y="321183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accent4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Oval 27"/>
                <p:cNvSpPr/>
                <p:nvPr/>
              </p:nvSpPr>
              <p:spPr>
                <a:xfrm>
                  <a:off x="1050748" y="3173730"/>
                  <a:ext cx="84773" cy="91439"/>
                </a:xfrm>
                <a:prstGeom prst="ellipse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4503335" y="3118493"/>
                <a:ext cx="333375" cy="91439"/>
                <a:chOff x="1666875" y="3326130"/>
                <a:chExt cx="333375" cy="91439"/>
              </a:xfrm>
            </p:grpSpPr>
            <p:cxnSp>
              <p:nvCxnSpPr>
                <p:cNvPr id="25" name="Straight Connector 24"/>
                <p:cNvCxnSpPr/>
                <p:nvPr/>
              </p:nvCxnSpPr>
              <p:spPr>
                <a:xfrm>
                  <a:off x="1666875" y="336423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accent2">
                      <a:lumMod val="40000"/>
                      <a:lumOff val="6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Oval 25"/>
                <p:cNvSpPr/>
                <p:nvPr/>
              </p:nvSpPr>
              <p:spPr>
                <a:xfrm>
                  <a:off x="1789747" y="3326130"/>
                  <a:ext cx="84773" cy="91439"/>
                </a:xfrm>
                <a:prstGeom prst="ellipse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grpSp>
            <p:nvGrpSpPr>
              <p:cNvPr id="10" name="Group 9"/>
              <p:cNvGrpSpPr/>
              <p:nvPr/>
            </p:nvGrpSpPr>
            <p:grpSpPr>
              <a:xfrm>
                <a:off x="4503335" y="3278790"/>
                <a:ext cx="333375" cy="91439"/>
                <a:chOff x="1819275" y="3478530"/>
                <a:chExt cx="333375" cy="91439"/>
              </a:xfrm>
            </p:grpSpPr>
            <p:cxnSp>
              <p:nvCxnSpPr>
                <p:cNvPr id="23" name="Straight Connector 22"/>
                <p:cNvCxnSpPr/>
                <p:nvPr/>
              </p:nvCxnSpPr>
              <p:spPr>
                <a:xfrm>
                  <a:off x="1819275" y="351663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accent2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Oval 23"/>
                <p:cNvSpPr/>
                <p:nvPr/>
              </p:nvSpPr>
              <p:spPr>
                <a:xfrm>
                  <a:off x="1942147" y="3478530"/>
                  <a:ext cx="84773" cy="91439"/>
                </a:xfrm>
                <a:prstGeom prst="ellipse">
                  <a:avLst/>
                </a:prstGeom>
                <a:solidFill>
                  <a:schemeClr val="accent2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grpSp>
            <p:nvGrpSpPr>
              <p:cNvPr id="11" name="Group 10"/>
              <p:cNvGrpSpPr/>
              <p:nvPr/>
            </p:nvGrpSpPr>
            <p:grpSpPr>
              <a:xfrm>
                <a:off x="5969829" y="3112206"/>
                <a:ext cx="333375" cy="93768"/>
                <a:chOff x="1971675" y="3615692"/>
                <a:chExt cx="333375" cy="93768"/>
              </a:xfrm>
            </p:grpSpPr>
            <p:cxnSp>
              <p:nvCxnSpPr>
                <p:cNvPr id="21" name="Straight Connector 20"/>
                <p:cNvCxnSpPr/>
                <p:nvPr/>
              </p:nvCxnSpPr>
              <p:spPr>
                <a:xfrm>
                  <a:off x="1971675" y="366903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Isosceles Triangle 21"/>
                <p:cNvSpPr>
                  <a:spLocks noChangeAspect="1"/>
                </p:cNvSpPr>
                <p:nvPr/>
              </p:nvSpPr>
              <p:spPr>
                <a:xfrm>
                  <a:off x="2089949" y="3615692"/>
                  <a:ext cx="100800" cy="93768"/>
                </a:xfrm>
                <a:prstGeom prst="triangle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5969829" y="3263437"/>
                <a:ext cx="333375" cy="93768"/>
                <a:chOff x="2124075" y="3774546"/>
                <a:chExt cx="333375" cy="93768"/>
              </a:xfrm>
            </p:grpSpPr>
            <p:cxnSp>
              <p:nvCxnSpPr>
                <p:cNvPr id="19" name="Straight Connector 18"/>
                <p:cNvCxnSpPr/>
                <p:nvPr/>
              </p:nvCxnSpPr>
              <p:spPr>
                <a:xfrm>
                  <a:off x="2124075" y="3821430"/>
                  <a:ext cx="333375" cy="0"/>
                </a:xfrm>
                <a:prstGeom prst="line">
                  <a:avLst/>
                </a:prstGeom>
                <a:ln w="25400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Isosceles Triangle 19"/>
                <p:cNvSpPr>
                  <a:spLocks noChangeAspect="1"/>
                </p:cNvSpPr>
                <p:nvPr/>
              </p:nvSpPr>
              <p:spPr>
                <a:xfrm>
                  <a:off x="2239410" y="3774546"/>
                  <a:ext cx="100800" cy="93768"/>
                </a:xfrm>
                <a:prstGeom prst="triangle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</p:grpSp>
          <p:sp>
            <p:nvSpPr>
              <p:cNvPr id="13" name="TextBox 12"/>
              <p:cNvSpPr txBox="1"/>
              <p:nvPr/>
            </p:nvSpPr>
            <p:spPr>
              <a:xfrm>
                <a:off x="3170568" y="2995144"/>
                <a:ext cx="1415965" cy="533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47a 2 </a:t>
                </a:r>
                <a:r>
                  <a:rPr lang="hu-HU" sz="1100" dirty="0" err="1"/>
                  <a:t>mM</a:t>
                </a:r>
                <a:r>
                  <a:rPr lang="hu-HU" sz="1100" dirty="0"/>
                  <a:t> Ca</a:t>
                </a:r>
                <a:r>
                  <a:rPr lang="hu-HU" sz="1100" baseline="30000" dirty="0"/>
                  <a:t>2+</a:t>
                </a:r>
              </a:p>
              <a:p>
                <a:r>
                  <a:rPr lang="hu-HU" sz="1100" dirty="0"/>
                  <a:t>  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776505" y="2998836"/>
                <a:ext cx="109677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47a w/o Ca</a:t>
                </a:r>
                <a:r>
                  <a:rPr lang="hu-HU" sz="1100" baseline="30000" dirty="0"/>
                  <a:t>2+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235833" y="3002687"/>
                <a:ext cx="149752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47a w/o Ca</a:t>
                </a:r>
                <a:r>
                  <a:rPr lang="hu-HU" sz="1100" baseline="30000" dirty="0"/>
                  <a:t>2+ </a:t>
                </a:r>
                <a:r>
                  <a:rPr lang="hu-HU" sz="1100" dirty="0"/>
                  <a:t>+EGTA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170568" y="3155443"/>
                <a:ext cx="1402770" cy="323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CO 2 </a:t>
                </a:r>
                <a:r>
                  <a:rPr lang="hu-HU" sz="1100" dirty="0" err="1"/>
                  <a:t>mM</a:t>
                </a:r>
                <a:r>
                  <a:rPr lang="hu-HU" sz="1100" dirty="0"/>
                  <a:t> Ca</a:t>
                </a:r>
                <a:r>
                  <a:rPr lang="hu-HU" sz="1100" baseline="30000" dirty="0"/>
                  <a:t>2+</a:t>
                </a:r>
                <a:r>
                  <a:rPr lang="hu-HU" sz="1100" dirty="0"/>
                  <a:t> 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776505" y="3167207"/>
                <a:ext cx="105349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CO w/o Ca</a:t>
                </a:r>
                <a:r>
                  <a:rPr lang="hu-HU" sz="1100" baseline="30000" dirty="0"/>
                  <a:t>2+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6232893" y="3152837"/>
                <a:ext cx="1454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1100" dirty="0"/>
                  <a:t>ORCO w/o Ca</a:t>
                </a:r>
                <a:r>
                  <a:rPr lang="hu-HU" sz="1100" baseline="30000" dirty="0"/>
                  <a:t>2+ </a:t>
                </a:r>
                <a:r>
                  <a:rPr lang="hu-HU" sz="1100" dirty="0"/>
                  <a:t>+EGTA</a:t>
                </a:r>
              </a:p>
            </p:txBody>
          </p:sp>
        </p:grpSp>
      </p:grpSp>
      <p:sp>
        <p:nvSpPr>
          <p:cNvPr id="31" name="TextBox 30"/>
          <p:cNvSpPr txBox="1"/>
          <p:nvPr/>
        </p:nvSpPr>
        <p:spPr>
          <a:xfrm>
            <a:off x="171450" y="4396802"/>
            <a:ext cx="64258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Supplementary </a:t>
            </a:r>
            <a:r>
              <a:rPr lang="hu-HU" sz="1200" b="1" dirty="0" err="1"/>
              <a:t>Figure</a:t>
            </a:r>
            <a:r>
              <a:rPr lang="hu-HU" sz="1200" b="1" dirty="0"/>
              <a:t> </a:t>
            </a:r>
            <a:r>
              <a:rPr lang="hu-HU" sz="1200" b="1" dirty="0" smtClean="0"/>
              <a:t>3</a:t>
            </a:r>
            <a:r>
              <a:rPr lang="hu-HU" sz="1200" b="1" dirty="0"/>
              <a:t>. </a:t>
            </a:r>
            <a:r>
              <a:rPr lang="hu-HU" sz="1200" b="1" dirty="0" smtClean="0">
                <a:solidFill>
                  <a:srgbClr val="FF0000"/>
                </a:solidFill>
              </a:rPr>
              <a:t>VUAA1 induced </a:t>
            </a:r>
            <a:r>
              <a:rPr lang="hu-HU" sz="1200" b="1" dirty="0" smtClean="0"/>
              <a:t>OR47a </a:t>
            </a:r>
            <a:r>
              <a:rPr lang="hu-HU" sz="1200" b="1" dirty="0"/>
              <a:t>and ORCO cell line responses </a:t>
            </a:r>
            <a:r>
              <a:rPr lang="hu-HU" sz="1200" b="1" dirty="0" smtClean="0"/>
              <a:t>to the Ca</a:t>
            </a:r>
            <a:r>
              <a:rPr lang="hu-HU" sz="1200" b="1" baseline="30000" dirty="0" smtClean="0"/>
              <a:t>2</a:t>
            </a:r>
            <a:r>
              <a:rPr lang="hu-HU" sz="1200" b="1" baseline="30000" dirty="0"/>
              <a:t>+</a:t>
            </a:r>
            <a:r>
              <a:rPr lang="hu-HU" sz="1200" b="1" dirty="0"/>
              <a:t> content of the assay buffer.</a:t>
            </a:r>
          </a:p>
          <a:p>
            <a:r>
              <a:rPr lang="hu-HU" sz="1200" dirty="0"/>
              <a:t>Each </a:t>
            </a:r>
            <a:r>
              <a:rPr lang="hu-HU" sz="1200" dirty="0" err="1"/>
              <a:t>curve</a:t>
            </a:r>
            <a:r>
              <a:rPr lang="hu-HU" sz="1200" dirty="0"/>
              <a:t> </a:t>
            </a:r>
            <a:r>
              <a:rPr lang="hu-HU" sz="1200" dirty="0" err="1"/>
              <a:t>represents</a:t>
            </a:r>
            <a:r>
              <a:rPr lang="hu-HU" sz="1200" dirty="0"/>
              <a:t> one measurement in one well of a 384-well plate. The same colors indicate same conditions during the measurement. VUAA1 was injected after 5 sec of baseline fluorescence measurement in 50 </a:t>
            </a:r>
            <a:r>
              <a:rPr lang="el-GR" sz="1200" baseline="0" dirty="0">
                <a:latin typeface="+mn-lt"/>
                <a:cs typeface="Arial" panose="020B0604020202020204" pitchFamily="34" charset="0"/>
              </a:rPr>
              <a:t>μ</a:t>
            </a:r>
            <a:r>
              <a:rPr lang="hu-HU" sz="1200" baseline="0" dirty="0">
                <a:latin typeface="+mn-lt"/>
                <a:cs typeface="Arial" panose="020B0604020202020204" pitchFamily="34" charset="0"/>
              </a:rPr>
              <a:t>M final concentration and </a:t>
            </a:r>
            <a:r>
              <a:rPr lang="hu-HU" sz="1200" baseline="0" dirty="0" err="1">
                <a:latin typeface="+mn-lt"/>
                <a:cs typeface="Arial" panose="020B0604020202020204" pitchFamily="34" charset="0"/>
              </a:rPr>
              <a:t>the</a:t>
            </a:r>
            <a:r>
              <a:rPr lang="hu-HU" sz="1200" baseline="0" dirty="0">
                <a:latin typeface="+mn-lt"/>
                <a:cs typeface="Arial" panose="020B0604020202020204" pitchFamily="34" charset="0"/>
              </a:rPr>
              <a:t> </a:t>
            </a:r>
            <a:r>
              <a:rPr lang="hu-HU" sz="1200" baseline="0" dirty="0" err="1">
                <a:latin typeface="+mn-lt"/>
                <a:cs typeface="Arial" panose="020B0604020202020204" pitchFamily="34" charset="0"/>
              </a:rPr>
              <a:t>fluorescence</a:t>
            </a:r>
            <a:r>
              <a:rPr lang="hu-HU" sz="1200" baseline="0" dirty="0">
                <a:latin typeface="+mn-lt"/>
                <a:cs typeface="Arial" panose="020B0604020202020204" pitchFamily="34" charset="0"/>
              </a:rPr>
              <a:t> was measured for an additional 30 sec. </a:t>
            </a:r>
            <a:r>
              <a:rPr lang="hu-HU" sz="1200" dirty="0"/>
              <a:t>OR47a 2 </a:t>
            </a:r>
            <a:r>
              <a:rPr lang="hu-HU" sz="1200" dirty="0" err="1"/>
              <a:t>mM</a:t>
            </a:r>
            <a:r>
              <a:rPr lang="hu-HU" sz="1200" dirty="0"/>
              <a:t> Ca</a:t>
            </a:r>
            <a:r>
              <a:rPr lang="hu-HU" sz="1200" baseline="30000" dirty="0"/>
              <a:t>2+</a:t>
            </a:r>
            <a:r>
              <a:rPr lang="hu-HU" sz="1200" dirty="0"/>
              <a:t> and ORCO 2 </a:t>
            </a:r>
            <a:r>
              <a:rPr lang="hu-HU" sz="1200" dirty="0" err="1"/>
              <a:t>mM</a:t>
            </a:r>
            <a:r>
              <a:rPr lang="hu-HU" sz="1200" dirty="0"/>
              <a:t> Ca</a:t>
            </a:r>
            <a:r>
              <a:rPr lang="hu-HU" sz="1200" baseline="30000" dirty="0"/>
              <a:t>2+</a:t>
            </a:r>
            <a:r>
              <a:rPr lang="hu-HU" sz="1200" dirty="0"/>
              <a:t> measurements were done </a:t>
            </a:r>
            <a:r>
              <a:rPr lang="hu-HU" sz="1200" dirty="0" err="1"/>
              <a:t>with</a:t>
            </a:r>
            <a:r>
              <a:rPr lang="hu-HU" sz="1200" dirty="0"/>
              <a:t> </a:t>
            </a:r>
            <a:r>
              <a:rPr lang="hu-HU" sz="1200" dirty="0" err="1"/>
              <a:t>the</a:t>
            </a:r>
            <a:r>
              <a:rPr lang="hu-HU" sz="1200" dirty="0"/>
              <a:t> standard assay buffer containing </a:t>
            </a:r>
            <a:r>
              <a:rPr lang="en-US" sz="1200" dirty="0"/>
              <a:t>2 mM CaCl</a:t>
            </a:r>
            <a:r>
              <a:rPr lang="en-US" sz="1200" baseline="-25000" dirty="0"/>
              <a:t>2</a:t>
            </a:r>
            <a:r>
              <a:rPr lang="hu-HU" sz="1200" dirty="0"/>
              <a:t>. In </a:t>
            </a:r>
            <a:r>
              <a:rPr lang="hu-HU" sz="1200" dirty="0" err="1"/>
              <a:t>measurements</a:t>
            </a:r>
            <a:r>
              <a:rPr lang="hu-HU" sz="1200" dirty="0"/>
              <a:t> </a:t>
            </a:r>
            <a:r>
              <a:rPr lang="hu-HU" sz="1200" dirty="0" err="1"/>
              <a:t>denoted</a:t>
            </a:r>
            <a:r>
              <a:rPr lang="hu-HU" sz="1200" dirty="0"/>
              <a:t> as „w/o Ca</a:t>
            </a:r>
            <a:r>
              <a:rPr lang="hu-HU" sz="1200" baseline="30000" dirty="0"/>
              <a:t>2+</a:t>
            </a:r>
            <a:r>
              <a:rPr lang="hu-HU" sz="1200" dirty="0"/>
              <a:t>”, CaCl</a:t>
            </a:r>
            <a:r>
              <a:rPr lang="hu-HU" sz="1200" baseline="-25000" dirty="0"/>
              <a:t>2</a:t>
            </a:r>
            <a:r>
              <a:rPr lang="hu-HU" sz="1200" dirty="0"/>
              <a:t> was not present in </a:t>
            </a:r>
            <a:r>
              <a:rPr lang="hu-HU" sz="1200" dirty="0" err="1"/>
              <a:t>the</a:t>
            </a:r>
            <a:r>
              <a:rPr lang="hu-HU" sz="1200" dirty="0"/>
              <a:t> </a:t>
            </a:r>
            <a:r>
              <a:rPr lang="hu-HU" sz="1200" dirty="0" err="1"/>
              <a:t>assay</a:t>
            </a:r>
            <a:r>
              <a:rPr lang="hu-HU" sz="1200" dirty="0"/>
              <a:t> </a:t>
            </a:r>
            <a:r>
              <a:rPr lang="hu-HU" sz="1200" dirty="0" err="1"/>
              <a:t>buffer</a:t>
            </a:r>
            <a:r>
              <a:rPr lang="hu-HU" sz="1200" dirty="0"/>
              <a:t> and „w/o Ca</a:t>
            </a:r>
            <a:r>
              <a:rPr lang="hu-HU" sz="1200" baseline="30000" dirty="0"/>
              <a:t>2+ </a:t>
            </a:r>
            <a:r>
              <a:rPr lang="hu-HU" sz="1200" dirty="0"/>
              <a:t>+EGTA” contained EGTA as a </a:t>
            </a:r>
            <a:r>
              <a:rPr lang="hu-HU" sz="1200" dirty="0" err="1"/>
              <a:t>selective</a:t>
            </a:r>
            <a:r>
              <a:rPr lang="hu-HU" sz="1200" dirty="0"/>
              <a:t> </a:t>
            </a:r>
            <a:r>
              <a:rPr lang="hu-HU" sz="1200" dirty="0" err="1"/>
              <a:t>chelating</a:t>
            </a:r>
            <a:r>
              <a:rPr lang="hu-HU" sz="1200" dirty="0"/>
              <a:t> </a:t>
            </a:r>
            <a:r>
              <a:rPr lang="hu-HU" sz="1200" dirty="0" err="1"/>
              <a:t>agent</a:t>
            </a:r>
            <a:r>
              <a:rPr lang="hu-HU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959732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130987" y="8673949"/>
            <a:ext cx="6582222" cy="1426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b="1" dirty="0"/>
              <a:t>Supplementary </a:t>
            </a:r>
            <a:r>
              <a:rPr lang="hu-HU" sz="1000" b="1" dirty="0" err="1"/>
              <a:t>Figure</a:t>
            </a:r>
            <a:r>
              <a:rPr lang="hu-HU" sz="1000" b="1" dirty="0"/>
              <a:t> </a:t>
            </a:r>
            <a:r>
              <a:rPr lang="hu-HU" sz="1000" b="1" dirty="0" smtClean="0"/>
              <a:t>4</a:t>
            </a:r>
            <a:r>
              <a:rPr lang="hu-HU" sz="1000" b="1" dirty="0"/>
              <a:t>. Generation of the </a:t>
            </a:r>
            <a:r>
              <a:rPr lang="hu-HU" sz="1000" b="1" dirty="0" smtClean="0"/>
              <a:t>truncated </a:t>
            </a:r>
            <a:r>
              <a:rPr lang="hu-HU" sz="1000" b="1" dirty="0"/>
              <a:t>70kb BAC</a:t>
            </a:r>
            <a:r>
              <a:rPr lang="hu-HU" sz="1000" b="1" baseline="30000" dirty="0"/>
              <a:t>Rosa26</a:t>
            </a:r>
            <a:r>
              <a:rPr lang="hu-HU" sz="1000" b="1" dirty="0"/>
              <a:t> and comparison of the transfection efficiency and expression level of the two BAC</a:t>
            </a:r>
            <a:r>
              <a:rPr lang="hu-HU" sz="1000" b="1" baseline="30000" dirty="0"/>
              <a:t>Rosa26</a:t>
            </a:r>
          </a:p>
          <a:p>
            <a:endParaRPr lang="hu-HU" sz="1000" baseline="30000" dirty="0"/>
          </a:p>
          <a:p>
            <a:r>
              <a:rPr lang="hu-HU" sz="1000" dirty="0" smtClean="0"/>
              <a:t>(A) Experimental outline of the truncated 70kb BAC</a:t>
            </a:r>
            <a:r>
              <a:rPr lang="hu-HU" sz="1000" baseline="30000" dirty="0" smtClean="0"/>
              <a:t>Rosa26</a:t>
            </a:r>
            <a:r>
              <a:rPr lang="hu-HU" sz="1000" dirty="0" smtClean="0"/>
              <a:t> generation. The original BAC</a:t>
            </a:r>
            <a:r>
              <a:rPr lang="hu-HU" sz="1000" baseline="30000" dirty="0" smtClean="0"/>
              <a:t>Rosa26</a:t>
            </a:r>
            <a:r>
              <a:rPr lang="hu-HU" sz="1000" dirty="0" smtClean="0"/>
              <a:t> was shortened by homologous recombination and FLP mediated excision of the targeting constructs. (B) Nucleoporation efficiency of different CAG promoter-GFP constructs. Ratio of GFP positive cells was measured by FACS in transfected CHO cells 24 hours after nucleoporation. (C) GFP fluorescence intensity of stable CHO cell pools was measured 2 months after nucleoporation with constitutive G418 selection.</a:t>
            </a:r>
            <a:endParaRPr lang="hu-HU" sz="1000" dirty="0"/>
          </a:p>
          <a:p>
            <a:endParaRPr lang="hu-HU" sz="1000" dirty="0"/>
          </a:p>
        </p:txBody>
      </p:sp>
      <p:grpSp>
        <p:nvGrpSpPr>
          <p:cNvPr id="109" name="Group 108"/>
          <p:cNvGrpSpPr/>
          <p:nvPr/>
        </p:nvGrpSpPr>
        <p:grpSpPr>
          <a:xfrm>
            <a:off x="120451" y="2753451"/>
            <a:ext cx="1367682" cy="434971"/>
            <a:chOff x="4704788" y="1163247"/>
            <a:chExt cx="1367682" cy="434971"/>
          </a:xfrm>
        </p:grpSpPr>
        <p:cxnSp>
          <p:nvCxnSpPr>
            <p:cNvPr id="90" name="Straight Connector 89"/>
            <p:cNvCxnSpPr/>
            <p:nvPr/>
          </p:nvCxnSpPr>
          <p:spPr>
            <a:xfrm>
              <a:off x="4742605" y="1474572"/>
              <a:ext cx="1295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" name="Regular Pentagon 90"/>
            <p:cNvSpPr/>
            <p:nvPr/>
          </p:nvSpPr>
          <p:spPr>
            <a:xfrm>
              <a:off x="4990254" y="1424799"/>
              <a:ext cx="120650" cy="99546"/>
            </a:xfrm>
            <a:prstGeom prst="pent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600" dirty="0" smtClean="0"/>
                <a:t>3</a:t>
              </a:r>
              <a:endParaRPr lang="hu-HU" sz="600" dirty="0"/>
            </a:p>
          </p:txBody>
        </p:sp>
        <p:sp>
          <p:nvSpPr>
            <p:cNvPr id="92" name="Regular Pentagon 91"/>
            <p:cNvSpPr/>
            <p:nvPr/>
          </p:nvSpPr>
          <p:spPr>
            <a:xfrm>
              <a:off x="5682405" y="1424799"/>
              <a:ext cx="120650" cy="99546"/>
            </a:xfrm>
            <a:prstGeom prst="pentagon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600" dirty="0"/>
                <a:t>3</a:t>
              </a:r>
            </a:p>
          </p:txBody>
        </p:sp>
        <p:grpSp>
          <p:nvGrpSpPr>
            <p:cNvPr id="93" name="Group 92"/>
            <p:cNvGrpSpPr/>
            <p:nvPr/>
          </p:nvGrpSpPr>
          <p:grpSpPr>
            <a:xfrm>
              <a:off x="4713298" y="1382774"/>
              <a:ext cx="304892" cy="215444"/>
              <a:chOff x="97693" y="477039"/>
              <a:chExt cx="304892" cy="215444"/>
            </a:xfrm>
          </p:grpSpPr>
          <p:sp>
            <p:nvSpPr>
              <p:cNvPr id="94" name="TextBox 93"/>
              <p:cNvSpPr txBox="1"/>
              <p:nvPr/>
            </p:nvSpPr>
            <p:spPr>
              <a:xfrm>
                <a:off x="166112" y="519064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97693" y="477039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  <p:grpSp>
          <p:nvGrpSpPr>
            <p:cNvPr id="96" name="Group 95"/>
            <p:cNvGrpSpPr/>
            <p:nvPr/>
          </p:nvGrpSpPr>
          <p:grpSpPr>
            <a:xfrm>
              <a:off x="5761141" y="1376084"/>
              <a:ext cx="304892" cy="215444"/>
              <a:chOff x="97693" y="477039"/>
              <a:chExt cx="304892" cy="215444"/>
            </a:xfrm>
          </p:grpSpPr>
          <p:sp>
            <p:nvSpPr>
              <p:cNvPr id="97" name="TextBox 96"/>
              <p:cNvSpPr txBox="1"/>
              <p:nvPr/>
            </p:nvSpPr>
            <p:spPr>
              <a:xfrm>
                <a:off x="166112" y="519064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98" name="Rectangle 97"/>
              <p:cNvSpPr/>
              <p:nvPr/>
            </p:nvSpPr>
            <p:spPr>
              <a:xfrm>
                <a:off x="97693" y="477039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  <p:sp>
          <p:nvSpPr>
            <p:cNvPr id="99" name="Right Arrow 98"/>
            <p:cNvSpPr/>
            <p:nvPr/>
          </p:nvSpPr>
          <p:spPr>
            <a:xfrm>
              <a:off x="5150387" y="1402578"/>
              <a:ext cx="164178" cy="141195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 smtClean="0">
                <a:solidFill>
                  <a:schemeClr val="tx1"/>
                </a:solidFill>
              </a:endParaRPr>
            </a:p>
          </p:txBody>
        </p:sp>
        <p:grpSp>
          <p:nvGrpSpPr>
            <p:cNvPr id="100" name="Group 99"/>
            <p:cNvGrpSpPr/>
            <p:nvPr/>
          </p:nvGrpSpPr>
          <p:grpSpPr>
            <a:xfrm>
              <a:off x="5288767" y="1370363"/>
              <a:ext cx="422260" cy="215444"/>
              <a:chOff x="4674261" y="225775"/>
              <a:chExt cx="626547" cy="298468"/>
            </a:xfrm>
          </p:grpSpPr>
          <p:sp>
            <p:nvSpPr>
              <p:cNvPr id="101" name="Oval 100"/>
              <p:cNvSpPr/>
              <p:nvPr/>
            </p:nvSpPr>
            <p:spPr>
              <a:xfrm>
                <a:off x="4777643" y="251557"/>
                <a:ext cx="419783" cy="24743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4674261" y="225775"/>
                <a:ext cx="626547" cy="298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800" dirty="0" smtClean="0"/>
                  <a:t>Amp</a:t>
                </a:r>
                <a:r>
                  <a:rPr lang="hu-HU" sz="800" baseline="30000" dirty="0" smtClean="0"/>
                  <a:t>R</a:t>
                </a:r>
                <a:endParaRPr lang="hu-HU" sz="800" baseline="30000" dirty="0"/>
              </a:p>
            </p:txBody>
          </p:sp>
        </p:grpSp>
        <p:sp>
          <p:nvSpPr>
            <p:cNvPr id="104" name="Rectangle 103"/>
            <p:cNvSpPr/>
            <p:nvPr/>
          </p:nvSpPr>
          <p:spPr>
            <a:xfrm>
              <a:off x="4704788" y="1163247"/>
              <a:ext cx="136768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hu-HU" altLang="hu-HU" sz="10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3’ </a:t>
              </a:r>
              <a:r>
                <a:rPr lang="en-GB" altLang="hu-HU" sz="10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targeting </a:t>
              </a:r>
              <a:r>
                <a:rPr lang="en-GB" altLang="hu-HU" sz="1000" dirty="0">
                  <a:latin typeface="Arial" panose="020B0604020202020204" pitchFamily="34" charset="0"/>
                  <a:ea typeface="Times New Roman" panose="02020603050405020304" pitchFamily="18" charset="0"/>
                </a:rPr>
                <a:t>construct</a:t>
              </a:r>
              <a:endParaRPr lang="hu-HU" sz="1000" dirty="0"/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820028" y="3206592"/>
            <a:ext cx="4199486" cy="557338"/>
            <a:chOff x="698202" y="1757665"/>
            <a:chExt cx="4187847" cy="557338"/>
          </a:xfrm>
        </p:grpSpPr>
        <p:sp>
          <p:nvSpPr>
            <p:cNvPr id="22" name="Oval 21"/>
            <p:cNvSpPr/>
            <p:nvPr/>
          </p:nvSpPr>
          <p:spPr>
            <a:xfrm>
              <a:off x="698202" y="1920836"/>
              <a:ext cx="4187847" cy="3429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dirty="0" smtClean="0"/>
                <a:t>~</a:t>
              </a:r>
              <a:r>
                <a:rPr lang="hu-HU" sz="1100" dirty="0" smtClean="0">
                  <a:solidFill>
                    <a:schemeClr val="tx1"/>
                  </a:solidFill>
                </a:rPr>
                <a:t>BAC</a:t>
              </a:r>
            </a:p>
          </p:txBody>
        </p:sp>
        <p:sp>
          <p:nvSpPr>
            <p:cNvPr id="28" name="Rounded Rectangle 27"/>
            <p:cNvSpPr/>
            <p:nvPr/>
          </p:nvSpPr>
          <p:spPr>
            <a:xfrm>
              <a:off x="2310896" y="1822400"/>
              <a:ext cx="413766" cy="247430"/>
            </a:xfrm>
            <a:prstGeom prst="round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GOI</a:t>
              </a:r>
            </a:p>
          </p:txBody>
        </p:sp>
        <p:sp>
          <p:nvSpPr>
            <p:cNvPr id="31" name="Right Arrow 30"/>
            <p:cNvSpPr/>
            <p:nvPr/>
          </p:nvSpPr>
          <p:spPr>
            <a:xfrm>
              <a:off x="1653100" y="1757665"/>
              <a:ext cx="607568" cy="359709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CAG</a:t>
              </a:r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32" name="Diamond 31"/>
            <p:cNvSpPr/>
            <p:nvPr/>
          </p:nvSpPr>
          <p:spPr>
            <a:xfrm>
              <a:off x="2767968" y="187517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33" name="Right Arrow 32"/>
            <p:cNvSpPr/>
            <p:nvPr/>
          </p:nvSpPr>
          <p:spPr>
            <a:xfrm>
              <a:off x="2917930" y="1764015"/>
              <a:ext cx="520934" cy="359709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PGK</a:t>
              </a: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3501606" y="1808388"/>
              <a:ext cx="419783" cy="247430"/>
              <a:chOff x="4777643" y="251557"/>
              <a:chExt cx="419783" cy="247430"/>
            </a:xfrm>
          </p:grpSpPr>
          <p:sp>
            <p:nvSpPr>
              <p:cNvPr id="35" name="Oval 34"/>
              <p:cNvSpPr/>
              <p:nvPr/>
            </p:nvSpPr>
            <p:spPr>
              <a:xfrm>
                <a:off x="4777643" y="251557"/>
                <a:ext cx="419783" cy="24743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777643" y="255738"/>
                <a:ext cx="4197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800" dirty="0" smtClean="0"/>
                  <a:t>Neo</a:t>
                </a:r>
                <a:r>
                  <a:rPr lang="hu-HU" sz="800" baseline="30000" dirty="0" smtClean="0"/>
                  <a:t>R</a:t>
                </a:r>
                <a:endParaRPr lang="hu-HU" sz="800" baseline="30000" dirty="0"/>
              </a:p>
            </p:txBody>
          </p:sp>
        </p:grpSp>
        <p:sp>
          <p:nvSpPr>
            <p:cNvPr id="37" name="Diamond 36"/>
            <p:cNvSpPr/>
            <p:nvPr/>
          </p:nvSpPr>
          <p:spPr>
            <a:xfrm>
              <a:off x="3966917" y="189441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grpSp>
          <p:nvGrpSpPr>
            <p:cNvPr id="110" name="Group 109"/>
            <p:cNvGrpSpPr/>
            <p:nvPr/>
          </p:nvGrpSpPr>
          <p:grpSpPr>
            <a:xfrm>
              <a:off x="4247433" y="2099559"/>
              <a:ext cx="304892" cy="215444"/>
              <a:chOff x="-215726" y="681967"/>
              <a:chExt cx="304892" cy="215444"/>
            </a:xfrm>
          </p:grpSpPr>
          <p:sp>
            <p:nvSpPr>
              <p:cNvPr id="111" name="TextBox 110"/>
              <p:cNvSpPr txBox="1"/>
              <p:nvPr/>
            </p:nvSpPr>
            <p:spPr>
              <a:xfrm>
                <a:off x="-150551" y="721545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-215726" y="681967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</p:grpSp>
      <p:sp>
        <p:nvSpPr>
          <p:cNvPr id="117" name="Oval 116"/>
          <p:cNvSpPr/>
          <p:nvPr/>
        </p:nvSpPr>
        <p:spPr>
          <a:xfrm>
            <a:off x="820027" y="4265540"/>
            <a:ext cx="4037348" cy="3429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 smtClean="0"/>
              <a:t>~</a:t>
            </a:r>
            <a:r>
              <a:rPr lang="hu-HU" sz="1100" dirty="0" smtClean="0">
                <a:solidFill>
                  <a:schemeClr val="tx1"/>
                </a:solidFill>
              </a:rPr>
              <a:t>70kb BAC</a:t>
            </a:r>
          </a:p>
        </p:txBody>
      </p:sp>
      <p:sp>
        <p:nvSpPr>
          <p:cNvPr id="118" name="Rounded Rectangle 117"/>
          <p:cNvSpPr/>
          <p:nvPr/>
        </p:nvSpPr>
        <p:spPr>
          <a:xfrm>
            <a:off x="2242339" y="4154428"/>
            <a:ext cx="413766" cy="247430"/>
          </a:xfrm>
          <a:prstGeom prst="round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800" dirty="0" smtClean="0">
                <a:solidFill>
                  <a:schemeClr val="tx1"/>
                </a:solidFill>
              </a:rPr>
              <a:t>GOI</a:t>
            </a:r>
          </a:p>
        </p:txBody>
      </p:sp>
      <p:sp>
        <p:nvSpPr>
          <p:cNvPr id="119" name="Right Arrow 118"/>
          <p:cNvSpPr/>
          <p:nvPr/>
        </p:nvSpPr>
        <p:spPr>
          <a:xfrm>
            <a:off x="1584543" y="4089693"/>
            <a:ext cx="607568" cy="359709"/>
          </a:xfrm>
          <a:prstGeom prst="rightArrow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800" dirty="0" smtClean="0">
                <a:solidFill>
                  <a:schemeClr val="tx1"/>
                </a:solidFill>
              </a:rPr>
              <a:t>CAG</a:t>
            </a:r>
            <a:endParaRPr lang="hu-HU" sz="800" dirty="0">
              <a:solidFill>
                <a:schemeClr val="tx1"/>
              </a:solidFill>
            </a:endParaRPr>
          </a:p>
        </p:txBody>
      </p:sp>
      <p:sp>
        <p:nvSpPr>
          <p:cNvPr id="120" name="Diamond 119"/>
          <p:cNvSpPr/>
          <p:nvPr/>
        </p:nvSpPr>
        <p:spPr>
          <a:xfrm>
            <a:off x="2699411" y="4207203"/>
            <a:ext cx="88900" cy="123715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21" name="Right Arrow 120"/>
          <p:cNvSpPr/>
          <p:nvPr/>
        </p:nvSpPr>
        <p:spPr>
          <a:xfrm>
            <a:off x="2849373" y="4096043"/>
            <a:ext cx="520934" cy="359709"/>
          </a:xfrm>
          <a:prstGeom prst="rightArrow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800" dirty="0" smtClean="0">
                <a:solidFill>
                  <a:schemeClr val="tx1"/>
                </a:solidFill>
              </a:rPr>
              <a:t>PGK</a:t>
            </a:r>
          </a:p>
        </p:txBody>
      </p:sp>
      <p:grpSp>
        <p:nvGrpSpPr>
          <p:cNvPr id="122" name="Group 121"/>
          <p:cNvGrpSpPr/>
          <p:nvPr/>
        </p:nvGrpSpPr>
        <p:grpSpPr>
          <a:xfrm>
            <a:off x="3433049" y="4140416"/>
            <a:ext cx="419783" cy="247430"/>
            <a:chOff x="4777643" y="251557"/>
            <a:chExt cx="419783" cy="247430"/>
          </a:xfrm>
        </p:grpSpPr>
        <p:sp>
          <p:nvSpPr>
            <p:cNvPr id="123" name="Oval 122"/>
            <p:cNvSpPr/>
            <p:nvPr/>
          </p:nvSpPr>
          <p:spPr>
            <a:xfrm>
              <a:off x="4777643" y="251557"/>
              <a:ext cx="419783" cy="24743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777643" y="255738"/>
              <a:ext cx="4197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800" dirty="0" smtClean="0"/>
                <a:t>Neo</a:t>
              </a:r>
              <a:r>
                <a:rPr lang="hu-HU" sz="800" baseline="30000" dirty="0" smtClean="0"/>
                <a:t>R</a:t>
              </a:r>
              <a:endParaRPr lang="hu-HU" sz="800" baseline="30000" dirty="0"/>
            </a:p>
          </p:txBody>
        </p:sp>
      </p:grpSp>
      <p:sp>
        <p:nvSpPr>
          <p:cNvPr id="125" name="Diamond 124"/>
          <p:cNvSpPr/>
          <p:nvPr/>
        </p:nvSpPr>
        <p:spPr>
          <a:xfrm>
            <a:off x="3898360" y="4226443"/>
            <a:ext cx="88900" cy="123715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26" name="Regular Pentagon 125"/>
          <p:cNvSpPr/>
          <p:nvPr/>
        </p:nvSpPr>
        <p:spPr>
          <a:xfrm>
            <a:off x="2014378" y="4555768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grpSp>
        <p:nvGrpSpPr>
          <p:cNvPr id="133" name="Group 132"/>
          <p:cNvGrpSpPr/>
          <p:nvPr/>
        </p:nvGrpSpPr>
        <p:grpSpPr>
          <a:xfrm>
            <a:off x="302621" y="468863"/>
            <a:ext cx="5331154" cy="636692"/>
            <a:chOff x="109496" y="1757665"/>
            <a:chExt cx="5331154" cy="636692"/>
          </a:xfrm>
        </p:grpSpPr>
        <p:sp>
          <p:nvSpPr>
            <p:cNvPr id="134" name="Oval 133"/>
            <p:cNvSpPr/>
            <p:nvPr/>
          </p:nvSpPr>
          <p:spPr>
            <a:xfrm>
              <a:off x="109496" y="1940345"/>
              <a:ext cx="5331154" cy="3429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dirty="0" smtClean="0"/>
                <a:t>~</a:t>
              </a:r>
              <a:r>
                <a:rPr lang="hu-HU" sz="1100" dirty="0" smtClean="0">
                  <a:solidFill>
                    <a:schemeClr val="tx1"/>
                  </a:solidFill>
                </a:rPr>
                <a:t>210kb BAC</a:t>
              </a:r>
            </a:p>
          </p:txBody>
        </p:sp>
        <p:sp>
          <p:nvSpPr>
            <p:cNvPr id="135" name="Rounded Rectangle 134"/>
            <p:cNvSpPr/>
            <p:nvPr/>
          </p:nvSpPr>
          <p:spPr>
            <a:xfrm>
              <a:off x="2310896" y="1822400"/>
              <a:ext cx="413766" cy="247430"/>
            </a:xfrm>
            <a:prstGeom prst="round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GOI</a:t>
              </a:r>
            </a:p>
          </p:txBody>
        </p:sp>
        <p:sp>
          <p:nvSpPr>
            <p:cNvPr id="136" name="Right Arrow 135"/>
            <p:cNvSpPr/>
            <p:nvPr/>
          </p:nvSpPr>
          <p:spPr>
            <a:xfrm>
              <a:off x="1653100" y="1757665"/>
              <a:ext cx="607568" cy="359709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CAG</a:t>
              </a:r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137" name="Diamond 136"/>
            <p:cNvSpPr/>
            <p:nvPr/>
          </p:nvSpPr>
          <p:spPr>
            <a:xfrm>
              <a:off x="2767968" y="187517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138" name="Right Arrow 137"/>
            <p:cNvSpPr/>
            <p:nvPr/>
          </p:nvSpPr>
          <p:spPr>
            <a:xfrm>
              <a:off x="2917930" y="1764015"/>
              <a:ext cx="520934" cy="359709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PGK</a:t>
              </a:r>
            </a:p>
          </p:txBody>
        </p:sp>
        <p:grpSp>
          <p:nvGrpSpPr>
            <p:cNvPr id="139" name="Group 138"/>
            <p:cNvGrpSpPr/>
            <p:nvPr/>
          </p:nvGrpSpPr>
          <p:grpSpPr>
            <a:xfrm>
              <a:off x="3501606" y="1808388"/>
              <a:ext cx="419783" cy="247430"/>
              <a:chOff x="4777643" y="251557"/>
              <a:chExt cx="419783" cy="247430"/>
            </a:xfrm>
          </p:grpSpPr>
          <p:sp>
            <p:nvSpPr>
              <p:cNvPr id="153" name="Oval 152"/>
              <p:cNvSpPr/>
              <p:nvPr/>
            </p:nvSpPr>
            <p:spPr>
              <a:xfrm>
                <a:off x="4777643" y="251557"/>
                <a:ext cx="419783" cy="24743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/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4777643" y="255738"/>
                <a:ext cx="4197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800" dirty="0" smtClean="0"/>
                  <a:t>Neo</a:t>
                </a:r>
                <a:r>
                  <a:rPr lang="hu-HU" sz="800" baseline="30000" dirty="0" smtClean="0"/>
                  <a:t>R</a:t>
                </a:r>
                <a:endParaRPr lang="hu-HU" sz="800" baseline="30000" dirty="0"/>
              </a:p>
            </p:txBody>
          </p:sp>
        </p:grpSp>
        <p:sp>
          <p:nvSpPr>
            <p:cNvPr id="140" name="Diamond 139"/>
            <p:cNvSpPr/>
            <p:nvPr/>
          </p:nvSpPr>
          <p:spPr>
            <a:xfrm>
              <a:off x="3966917" y="189441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grpSp>
          <p:nvGrpSpPr>
            <p:cNvPr id="141" name="Group 140"/>
            <p:cNvGrpSpPr/>
            <p:nvPr/>
          </p:nvGrpSpPr>
          <p:grpSpPr>
            <a:xfrm>
              <a:off x="824476" y="1869550"/>
              <a:ext cx="304892" cy="215444"/>
              <a:chOff x="97693" y="477039"/>
              <a:chExt cx="304892" cy="215444"/>
            </a:xfrm>
          </p:grpSpPr>
          <p:sp>
            <p:nvSpPr>
              <p:cNvPr id="151" name="TextBox 150"/>
              <p:cNvSpPr txBox="1"/>
              <p:nvPr/>
            </p:nvSpPr>
            <p:spPr>
              <a:xfrm>
                <a:off x="166112" y="519064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152" name="Rectangle 151"/>
              <p:cNvSpPr/>
              <p:nvPr/>
            </p:nvSpPr>
            <p:spPr>
              <a:xfrm>
                <a:off x="97693" y="477039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  <p:grpSp>
          <p:nvGrpSpPr>
            <p:cNvPr id="142" name="Group 141"/>
            <p:cNvGrpSpPr/>
            <p:nvPr/>
          </p:nvGrpSpPr>
          <p:grpSpPr>
            <a:xfrm>
              <a:off x="2191306" y="2178913"/>
              <a:ext cx="304892" cy="215444"/>
              <a:chOff x="97693" y="477039"/>
              <a:chExt cx="304892" cy="215444"/>
            </a:xfrm>
          </p:grpSpPr>
          <p:sp>
            <p:nvSpPr>
              <p:cNvPr id="149" name="TextBox 148"/>
              <p:cNvSpPr txBox="1"/>
              <p:nvPr/>
            </p:nvSpPr>
            <p:spPr>
              <a:xfrm>
                <a:off x="166112" y="519064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150" name="Rectangle 149"/>
              <p:cNvSpPr/>
              <p:nvPr/>
            </p:nvSpPr>
            <p:spPr>
              <a:xfrm>
                <a:off x="97693" y="477039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</p:grpSp>
      <p:sp>
        <p:nvSpPr>
          <p:cNvPr id="156" name="Regular Pentagon 155"/>
          <p:cNvSpPr/>
          <p:nvPr/>
        </p:nvSpPr>
        <p:spPr>
          <a:xfrm>
            <a:off x="2028153" y="3637626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64" name="Regular Pentagon 163"/>
          <p:cNvSpPr/>
          <p:nvPr/>
        </p:nvSpPr>
        <p:spPr>
          <a:xfrm>
            <a:off x="3595805" y="3641778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600" dirty="0" smtClean="0"/>
              <a:t>3</a:t>
            </a:r>
            <a:endParaRPr lang="hu-HU" sz="600" dirty="0"/>
          </a:p>
        </p:txBody>
      </p:sp>
      <p:sp>
        <p:nvSpPr>
          <p:cNvPr id="165" name="Regular Pentagon 164"/>
          <p:cNvSpPr/>
          <p:nvPr/>
        </p:nvSpPr>
        <p:spPr>
          <a:xfrm>
            <a:off x="4287661" y="3612070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600" dirty="0"/>
              <a:t>3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3387268" y="3641778"/>
            <a:ext cx="175509" cy="131394"/>
          </a:xfrm>
          <a:prstGeom prst="rect">
            <a:avLst/>
          </a:prstGeom>
          <a:solidFill>
            <a:srgbClr val="92D050"/>
          </a:solidFill>
        </p:spPr>
        <p:txBody>
          <a:bodyPr wrap="square" rtlCol="0">
            <a:spAutoFit/>
          </a:bodyPr>
          <a:lstStyle/>
          <a:p>
            <a:pPr algn="ctr"/>
            <a:endParaRPr lang="hu-HU" sz="600" dirty="0"/>
          </a:p>
        </p:txBody>
      </p:sp>
      <p:sp>
        <p:nvSpPr>
          <p:cNvPr id="167" name="Rectangle 166"/>
          <p:cNvSpPr/>
          <p:nvPr/>
        </p:nvSpPr>
        <p:spPr>
          <a:xfrm>
            <a:off x="3318849" y="3599753"/>
            <a:ext cx="3048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hu-HU" sz="800" dirty="0"/>
              <a:t>HR</a:t>
            </a:r>
          </a:p>
        </p:txBody>
      </p:sp>
      <p:sp>
        <p:nvSpPr>
          <p:cNvPr id="168" name="Right Arrow 167"/>
          <p:cNvSpPr/>
          <p:nvPr/>
        </p:nvSpPr>
        <p:spPr>
          <a:xfrm>
            <a:off x="3755938" y="3619557"/>
            <a:ext cx="164178" cy="141195"/>
          </a:xfrm>
          <a:prstGeom prst="rightArrow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 dirty="0" smtClean="0">
              <a:solidFill>
                <a:schemeClr val="tx1"/>
              </a:solidFill>
            </a:endParaRPr>
          </a:p>
        </p:txBody>
      </p:sp>
      <p:grpSp>
        <p:nvGrpSpPr>
          <p:cNvPr id="170" name="Group 169"/>
          <p:cNvGrpSpPr/>
          <p:nvPr/>
        </p:nvGrpSpPr>
        <p:grpSpPr>
          <a:xfrm>
            <a:off x="3892010" y="3582536"/>
            <a:ext cx="451240" cy="215444"/>
            <a:chOff x="4682321" y="234834"/>
            <a:chExt cx="669547" cy="298468"/>
          </a:xfrm>
        </p:grpSpPr>
        <p:sp>
          <p:nvSpPr>
            <p:cNvPr id="171" name="Oval 170"/>
            <p:cNvSpPr/>
            <p:nvPr/>
          </p:nvSpPr>
          <p:spPr>
            <a:xfrm>
              <a:off x="4777643" y="251557"/>
              <a:ext cx="419783" cy="24743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682321" y="234834"/>
              <a:ext cx="669547" cy="2984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800" dirty="0" smtClean="0"/>
                <a:t>Amp</a:t>
              </a:r>
              <a:r>
                <a:rPr lang="hu-HU" sz="800" baseline="30000" dirty="0" smtClean="0"/>
                <a:t>R</a:t>
              </a:r>
              <a:endParaRPr lang="hu-HU" sz="800" baseline="30000" dirty="0"/>
            </a:p>
          </p:txBody>
        </p:sp>
      </p:grpSp>
      <p:cxnSp>
        <p:nvCxnSpPr>
          <p:cNvPr id="174" name="Straight Arrow Connector 173"/>
          <p:cNvCxnSpPr/>
          <p:nvPr/>
        </p:nvCxnSpPr>
        <p:spPr>
          <a:xfrm>
            <a:off x="2945402" y="1115536"/>
            <a:ext cx="0" cy="2681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/>
          <p:cNvCxnSpPr/>
          <p:nvPr/>
        </p:nvCxnSpPr>
        <p:spPr>
          <a:xfrm>
            <a:off x="2968198" y="3797980"/>
            <a:ext cx="0" cy="2681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Rectangle 175"/>
          <p:cNvSpPr/>
          <p:nvPr/>
        </p:nvSpPr>
        <p:spPr>
          <a:xfrm>
            <a:off x="3034055" y="1109194"/>
            <a:ext cx="3793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000" dirty="0" smtClean="0">
                <a:ea typeface="Times New Roman" panose="02020603050405020304" pitchFamily="18" charset="0"/>
              </a:rPr>
              <a:t>ET-cloning: 5’ 70kb sequence is replaced by the 5’ targeting construct</a:t>
            </a:r>
            <a:endParaRPr lang="hu-HU" sz="1000" dirty="0"/>
          </a:p>
        </p:txBody>
      </p:sp>
      <p:cxnSp>
        <p:nvCxnSpPr>
          <p:cNvPr id="205" name="Straight Arrow Connector 204"/>
          <p:cNvCxnSpPr/>
          <p:nvPr/>
        </p:nvCxnSpPr>
        <p:spPr>
          <a:xfrm>
            <a:off x="2959168" y="2068940"/>
            <a:ext cx="0" cy="2681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Rectangle 205"/>
          <p:cNvSpPr/>
          <p:nvPr/>
        </p:nvSpPr>
        <p:spPr>
          <a:xfrm>
            <a:off x="3064974" y="2945337"/>
            <a:ext cx="379302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000" dirty="0">
                <a:ea typeface="Times New Roman" panose="02020603050405020304" pitchFamily="18" charset="0"/>
              </a:rPr>
              <a:t>ET-cloning: </a:t>
            </a:r>
            <a:r>
              <a:rPr lang="hu-HU" altLang="hu-HU" sz="1000" dirty="0" smtClean="0">
                <a:ea typeface="Times New Roman" panose="02020603050405020304" pitchFamily="18" charset="0"/>
              </a:rPr>
              <a:t>3’ </a:t>
            </a:r>
            <a:r>
              <a:rPr lang="hu-HU" altLang="hu-HU" sz="1000" dirty="0">
                <a:ea typeface="Times New Roman" panose="02020603050405020304" pitchFamily="18" charset="0"/>
              </a:rPr>
              <a:t>70kb sequence </a:t>
            </a:r>
            <a:r>
              <a:rPr lang="hu-HU" altLang="hu-HU" sz="1000" dirty="0" smtClean="0">
                <a:ea typeface="Times New Roman" panose="02020603050405020304" pitchFamily="18" charset="0"/>
              </a:rPr>
              <a:t>is replaced by the 3’ targeting construct</a:t>
            </a:r>
            <a:endParaRPr lang="hu-HU" sz="1000" dirty="0"/>
          </a:p>
        </p:txBody>
      </p:sp>
      <p:grpSp>
        <p:nvGrpSpPr>
          <p:cNvPr id="249" name="Group 248"/>
          <p:cNvGrpSpPr/>
          <p:nvPr/>
        </p:nvGrpSpPr>
        <p:grpSpPr>
          <a:xfrm>
            <a:off x="127709" y="962350"/>
            <a:ext cx="2019418" cy="508062"/>
            <a:chOff x="115169" y="1176138"/>
            <a:chExt cx="2019418" cy="508062"/>
          </a:xfrm>
        </p:grpSpPr>
        <p:grpSp>
          <p:nvGrpSpPr>
            <p:cNvPr id="163" name="Group 162"/>
            <p:cNvGrpSpPr/>
            <p:nvPr/>
          </p:nvGrpSpPr>
          <p:grpSpPr>
            <a:xfrm>
              <a:off x="115169" y="1176138"/>
              <a:ext cx="1367682" cy="444797"/>
              <a:chOff x="490603" y="1223908"/>
              <a:chExt cx="1367682" cy="444797"/>
            </a:xfrm>
          </p:grpSpPr>
          <p:cxnSp>
            <p:nvCxnSpPr>
              <p:cNvPr id="66" name="Straight Connector 65"/>
              <p:cNvCxnSpPr/>
              <p:nvPr/>
            </p:nvCxnSpPr>
            <p:spPr>
              <a:xfrm>
                <a:off x="526744" y="1545059"/>
                <a:ext cx="1295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7" name="Regular Pentagon 66"/>
              <p:cNvSpPr/>
              <p:nvPr/>
            </p:nvSpPr>
            <p:spPr>
              <a:xfrm>
                <a:off x="774393" y="1495286"/>
                <a:ext cx="120650" cy="99546"/>
              </a:xfrm>
              <a:prstGeom prst="pentagon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/>
              </a:p>
            </p:txBody>
          </p:sp>
          <p:sp>
            <p:nvSpPr>
              <p:cNvPr id="68" name="Regular Pentagon 67"/>
              <p:cNvSpPr/>
              <p:nvPr/>
            </p:nvSpPr>
            <p:spPr>
              <a:xfrm>
                <a:off x="1466544" y="1495286"/>
                <a:ext cx="120650" cy="99546"/>
              </a:xfrm>
              <a:prstGeom prst="pentagon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/>
              </a:p>
            </p:txBody>
          </p:sp>
          <p:grpSp>
            <p:nvGrpSpPr>
              <p:cNvPr id="73" name="Group 72"/>
              <p:cNvGrpSpPr/>
              <p:nvPr/>
            </p:nvGrpSpPr>
            <p:grpSpPr>
              <a:xfrm>
                <a:off x="497437" y="1453261"/>
                <a:ext cx="304892" cy="215444"/>
                <a:chOff x="97693" y="477039"/>
                <a:chExt cx="304892" cy="215444"/>
              </a:xfrm>
            </p:grpSpPr>
            <p:sp>
              <p:nvSpPr>
                <p:cNvPr id="71" name="TextBox 70"/>
                <p:cNvSpPr txBox="1"/>
                <p:nvPr/>
              </p:nvSpPr>
              <p:spPr>
                <a:xfrm>
                  <a:off x="166112" y="519064"/>
                  <a:ext cx="175509" cy="131394"/>
                </a:xfrm>
                <a:prstGeom prst="rect">
                  <a:avLst/>
                </a:prstGeom>
                <a:solidFill>
                  <a:srgbClr val="92D050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hu-HU" sz="600" dirty="0"/>
                </a:p>
              </p:txBody>
            </p:sp>
            <p:sp>
              <p:nvSpPr>
                <p:cNvPr id="72" name="Rectangle 71"/>
                <p:cNvSpPr/>
                <p:nvPr/>
              </p:nvSpPr>
              <p:spPr>
                <a:xfrm>
                  <a:off x="97693" y="477039"/>
                  <a:ext cx="304892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hu-HU" sz="800" dirty="0"/>
                    <a:t>HR</a:t>
                  </a:r>
                </a:p>
              </p:txBody>
            </p:sp>
          </p:grpSp>
          <p:grpSp>
            <p:nvGrpSpPr>
              <p:cNvPr id="75" name="Group 74"/>
              <p:cNvGrpSpPr/>
              <p:nvPr/>
            </p:nvGrpSpPr>
            <p:grpSpPr>
              <a:xfrm>
                <a:off x="1545280" y="1446571"/>
                <a:ext cx="304892" cy="215444"/>
                <a:chOff x="97693" y="477039"/>
                <a:chExt cx="304892" cy="215444"/>
              </a:xfrm>
            </p:grpSpPr>
            <p:sp>
              <p:nvSpPr>
                <p:cNvPr id="76" name="TextBox 75"/>
                <p:cNvSpPr txBox="1"/>
                <p:nvPr/>
              </p:nvSpPr>
              <p:spPr>
                <a:xfrm>
                  <a:off x="166112" y="519064"/>
                  <a:ext cx="175509" cy="131394"/>
                </a:xfrm>
                <a:prstGeom prst="rect">
                  <a:avLst/>
                </a:prstGeom>
                <a:solidFill>
                  <a:srgbClr val="92D050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endParaRPr lang="hu-HU" sz="600" dirty="0"/>
                </a:p>
              </p:txBody>
            </p:sp>
            <p:sp>
              <p:nvSpPr>
                <p:cNvPr id="77" name="Rectangle 76"/>
                <p:cNvSpPr/>
                <p:nvPr/>
              </p:nvSpPr>
              <p:spPr>
                <a:xfrm>
                  <a:off x="97693" y="477039"/>
                  <a:ext cx="304892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hu-HU" sz="800" dirty="0"/>
                    <a:t>HR</a:t>
                  </a:r>
                </a:p>
              </p:txBody>
            </p:sp>
          </p:grpSp>
          <p:sp>
            <p:nvSpPr>
              <p:cNvPr id="79" name="Right Arrow 78"/>
              <p:cNvSpPr/>
              <p:nvPr/>
            </p:nvSpPr>
            <p:spPr>
              <a:xfrm>
                <a:off x="934526" y="1473065"/>
                <a:ext cx="164178" cy="141195"/>
              </a:xfrm>
              <a:prstGeom prst="rightArrow">
                <a:avLst/>
              </a:prstGeom>
              <a:solidFill>
                <a:schemeClr val="accent4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 smtClean="0">
                  <a:solidFill>
                    <a:schemeClr val="tx1"/>
                  </a:solidFill>
                </a:endParaRPr>
              </a:p>
            </p:txBody>
          </p:sp>
          <p:grpSp>
            <p:nvGrpSpPr>
              <p:cNvPr id="81" name="Group 80"/>
              <p:cNvGrpSpPr/>
              <p:nvPr/>
            </p:nvGrpSpPr>
            <p:grpSpPr>
              <a:xfrm>
                <a:off x="1102998" y="1435743"/>
                <a:ext cx="404976" cy="215444"/>
                <a:chOff x="4718910" y="218700"/>
                <a:chExt cx="600901" cy="298468"/>
              </a:xfrm>
            </p:grpSpPr>
            <p:sp>
              <p:nvSpPr>
                <p:cNvPr id="82" name="Oval 81"/>
                <p:cNvSpPr/>
                <p:nvPr/>
              </p:nvSpPr>
              <p:spPr>
                <a:xfrm>
                  <a:off x="4777643" y="251557"/>
                  <a:ext cx="419783" cy="247430"/>
                </a:xfrm>
                <a:prstGeom prst="ellipse">
                  <a:avLst/>
                </a:prstGeom>
                <a:solidFill>
                  <a:schemeClr val="bg2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 sz="800" dirty="0"/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4718910" y="218700"/>
                  <a:ext cx="600901" cy="29846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hu-HU" sz="800" dirty="0" smtClean="0"/>
                    <a:t>Kan</a:t>
                  </a:r>
                  <a:r>
                    <a:rPr lang="hu-HU" sz="800" baseline="30000" dirty="0" smtClean="0"/>
                    <a:t>R</a:t>
                  </a:r>
                  <a:endParaRPr lang="hu-HU" sz="800" baseline="30000" dirty="0"/>
                </a:p>
              </p:txBody>
            </p:sp>
          </p:grpSp>
          <p:sp>
            <p:nvSpPr>
              <p:cNvPr id="103" name="Rectangle 102"/>
              <p:cNvSpPr/>
              <p:nvPr/>
            </p:nvSpPr>
            <p:spPr>
              <a:xfrm>
                <a:off x="490603" y="1223908"/>
                <a:ext cx="1367682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altLang="hu-HU" sz="1000" dirty="0" smtClean="0">
                    <a:latin typeface="Arial" panose="020B0604020202020204" pitchFamily="34" charset="0"/>
                    <a:ea typeface="Times New Roman" panose="02020603050405020304" pitchFamily="18" charset="0"/>
                  </a:rPr>
                  <a:t>5</a:t>
                </a:r>
                <a:r>
                  <a:rPr lang="hu-HU" altLang="hu-HU" sz="1000" dirty="0" smtClean="0">
                    <a:latin typeface="Arial" panose="020B0604020202020204" pitchFamily="34" charset="0"/>
                    <a:ea typeface="Times New Roman" panose="02020603050405020304" pitchFamily="18" charset="0"/>
                  </a:rPr>
                  <a:t>’ </a:t>
                </a:r>
                <a:r>
                  <a:rPr lang="en-GB" altLang="hu-HU" sz="1000" dirty="0" smtClean="0">
                    <a:latin typeface="Arial" panose="020B0604020202020204" pitchFamily="34" charset="0"/>
                    <a:ea typeface="Times New Roman" panose="02020603050405020304" pitchFamily="18" charset="0"/>
                  </a:rPr>
                  <a:t>targeting </a:t>
                </a:r>
                <a:r>
                  <a:rPr lang="en-GB" altLang="hu-HU" sz="1000" dirty="0">
                    <a:latin typeface="Arial" panose="020B0604020202020204" pitchFamily="34" charset="0"/>
                    <a:ea typeface="Times New Roman" panose="02020603050405020304" pitchFamily="18" charset="0"/>
                  </a:rPr>
                  <a:t>construct</a:t>
                </a:r>
                <a:endParaRPr lang="hu-HU" sz="1000" dirty="0"/>
              </a:p>
            </p:txBody>
          </p:sp>
        </p:grpSp>
        <p:sp>
          <p:nvSpPr>
            <p:cNvPr id="208" name="TextBox 207"/>
            <p:cNvSpPr txBox="1"/>
            <p:nvPr/>
          </p:nvSpPr>
          <p:spPr>
            <a:xfrm>
              <a:off x="1378439" y="1324229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600" dirty="0"/>
                <a:t>+</a:t>
              </a:r>
            </a:p>
          </p:txBody>
        </p:sp>
        <p:sp>
          <p:nvSpPr>
            <p:cNvPr id="209" name="Oval 208"/>
            <p:cNvSpPr/>
            <p:nvPr/>
          </p:nvSpPr>
          <p:spPr>
            <a:xfrm>
              <a:off x="1603833" y="1269015"/>
              <a:ext cx="421567" cy="41518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10" name="Rectangle 209"/>
            <p:cNvSpPr/>
            <p:nvPr/>
          </p:nvSpPr>
          <p:spPr>
            <a:xfrm>
              <a:off x="1499504" y="1326458"/>
              <a:ext cx="63508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hu-HU" altLang="hu-HU" sz="7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pRed/ET plasmid</a:t>
              </a:r>
              <a:endParaRPr lang="hu-HU" sz="700" dirty="0"/>
            </a:p>
          </p:txBody>
        </p:sp>
      </p:grpSp>
      <p:grpSp>
        <p:nvGrpSpPr>
          <p:cNvPr id="214" name="Group 213"/>
          <p:cNvGrpSpPr/>
          <p:nvPr/>
        </p:nvGrpSpPr>
        <p:grpSpPr>
          <a:xfrm>
            <a:off x="5715077" y="372215"/>
            <a:ext cx="1113125" cy="747397"/>
            <a:chOff x="6081410" y="535698"/>
            <a:chExt cx="1113125" cy="747397"/>
          </a:xfrm>
        </p:grpSpPr>
        <p:grpSp>
          <p:nvGrpSpPr>
            <p:cNvPr id="107" name="Group 106"/>
            <p:cNvGrpSpPr/>
            <p:nvPr/>
          </p:nvGrpSpPr>
          <p:grpSpPr>
            <a:xfrm>
              <a:off x="6175116" y="535698"/>
              <a:ext cx="482254" cy="560880"/>
              <a:chOff x="4975326" y="1036497"/>
              <a:chExt cx="482254" cy="560880"/>
            </a:xfrm>
          </p:grpSpPr>
          <p:grpSp>
            <p:nvGrpSpPr>
              <p:cNvPr id="64" name="Group 63"/>
              <p:cNvGrpSpPr/>
              <p:nvPr/>
            </p:nvGrpSpPr>
            <p:grpSpPr>
              <a:xfrm>
                <a:off x="4975326" y="1036497"/>
                <a:ext cx="482254" cy="387292"/>
                <a:chOff x="4360342" y="423967"/>
                <a:chExt cx="482254" cy="387292"/>
              </a:xfrm>
            </p:grpSpPr>
            <p:sp>
              <p:nvSpPr>
                <p:cNvPr id="43" name="Diamond 42"/>
                <p:cNvSpPr/>
                <p:nvPr/>
              </p:nvSpPr>
              <p:spPr>
                <a:xfrm>
                  <a:off x="4360342" y="489412"/>
                  <a:ext cx="88900" cy="123715"/>
                </a:xfrm>
                <a:prstGeom prst="diamond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4419082" y="423967"/>
                  <a:ext cx="42351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 smtClean="0"/>
                    <a:t>polyA</a:t>
                  </a:r>
                  <a:endParaRPr lang="hu-HU" sz="800" dirty="0"/>
                </a:p>
              </p:txBody>
            </p:sp>
            <p:sp>
              <p:nvSpPr>
                <p:cNvPr id="45" name="Regular Pentagon 44"/>
                <p:cNvSpPr/>
                <p:nvPr/>
              </p:nvSpPr>
              <p:spPr>
                <a:xfrm>
                  <a:off x="4360342" y="669484"/>
                  <a:ext cx="120650" cy="99546"/>
                </a:xfrm>
                <a:prstGeom prst="pentagon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hu-HU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4449242" y="595815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hu-HU" sz="800" dirty="0" smtClean="0"/>
                    <a:t>Frt</a:t>
                  </a:r>
                </a:p>
              </p:txBody>
            </p:sp>
          </p:grpSp>
          <p:sp>
            <p:nvSpPr>
              <p:cNvPr id="105" name="Regular Pentagon 104"/>
              <p:cNvSpPr/>
              <p:nvPr/>
            </p:nvSpPr>
            <p:spPr>
              <a:xfrm>
                <a:off x="4975326" y="1434162"/>
                <a:ext cx="120650" cy="99546"/>
              </a:xfrm>
              <a:prstGeom prst="pentagon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hu-HU" sz="600" dirty="0" smtClean="0"/>
                  <a:t>3</a:t>
                </a:r>
                <a:endParaRPr lang="hu-HU" sz="600" dirty="0"/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5064617" y="1381933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hu-HU" sz="800" dirty="0" smtClean="0"/>
                  <a:t>Frt3</a:t>
                </a:r>
              </a:p>
            </p:txBody>
          </p:sp>
        </p:grpSp>
        <p:sp>
          <p:nvSpPr>
            <p:cNvPr id="211" name="TextBox 210"/>
            <p:cNvSpPr txBox="1"/>
            <p:nvPr/>
          </p:nvSpPr>
          <p:spPr>
            <a:xfrm>
              <a:off x="6149829" y="1102148"/>
              <a:ext cx="175509" cy="131394"/>
            </a:xfrm>
            <a:prstGeom prst="rect">
              <a:avLst/>
            </a:prstGeom>
            <a:solidFill>
              <a:srgbClr val="92D050"/>
            </a:solidFill>
          </p:spPr>
          <p:txBody>
            <a:bodyPr wrap="square" rtlCol="0">
              <a:spAutoFit/>
            </a:bodyPr>
            <a:lstStyle/>
            <a:p>
              <a:pPr algn="ctr"/>
              <a:endParaRPr lang="hu-HU" sz="600" dirty="0"/>
            </a:p>
          </p:txBody>
        </p:sp>
        <p:sp>
          <p:nvSpPr>
            <p:cNvPr id="212" name="Rectangle 211"/>
            <p:cNvSpPr/>
            <p:nvPr/>
          </p:nvSpPr>
          <p:spPr>
            <a:xfrm>
              <a:off x="6081410" y="1060123"/>
              <a:ext cx="30489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hu-HU" sz="800" dirty="0"/>
                <a:t>HR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6251648" y="1067651"/>
              <a:ext cx="9428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800" dirty="0" smtClean="0"/>
                <a:t>Homology regions</a:t>
              </a:r>
            </a:p>
          </p:txBody>
        </p:sp>
      </p:grpSp>
      <p:grpSp>
        <p:nvGrpSpPr>
          <p:cNvPr id="215" name="Group 214"/>
          <p:cNvGrpSpPr/>
          <p:nvPr/>
        </p:nvGrpSpPr>
        <p:grpSpPr>
          <a:xfrm>
            <a:off x="839077" y="1465003"/>
            <a:ext cx="4969008" cy="585038"/>
            <a:chOff x="698202" y="1757665"/>
            <a:chExt cx="4955236" cy="585038"/>
          </a:xfrm>
        </p:grpSpPr>
        <p:sp>
          <p:nvSpPr>
            <p:cNvPr id="216" name="Oval 215"/>
            <p:cNvSpPr/>
            <p:nvPr/>
          </p:nvSpPr>
          <p:spPr>
            <a:xfrm>
              <a:off x="698202" y="1920836"/>
              <a:ext cx="4955236" cy="3429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dirty="0" smtClean="0"/>
                <a:t>~</a:t>
              </a:r>
              <a:endParaRPr lang="hu-HU" sz="1100" dirty="0" smtClean="0">
                <a:solidFill>
                  <a:schemeClr val="tx1"/>
                </a:solidFill>
              </a:endParaRPr>
            </a:p>
          </p:txBody>
        </p:sp>
        <p:sp>
          <p:nvSpPr>
            <p:cNvPr id="217" name="Rounded Rectangle 216"/>
            <p:cNvSpPr/>
            <p:nvPr/>
          </p:nvSpPr>
          <p:spPr>
            <a:xfrm>
              <a:off x="2310896" y="1822400"/>
              <a:ext cx="413766" cy="247430"/>
            </a:xfrm>
            <a:prstGeom prst="round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GOI</a:t>
              </a:r>
            </a:p>
          </p:txBody>
        </p:sp>
        <p:sp>
          <p:nvSpPr>
            <p:cNvPr id="218" name="Right Arrow 217"/>
            <p:cNvSpPr/>
            <p:nvPr/>
          </p:nvSpPr>
          <p:spPr>
            <a:xfrm>
              <a:off x="1653100" y="1757665"/>
              <a:ext cx="607568" cy="359709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CAG</a:t>
              </a:r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19" name="Diamond 218"/>
            <p:cNvSpPr/>
            <p:nvPr/>
          </p:nvSpPr>
          <p:spPr>
            <a:xfrm>
              <a:off x="2767968" y="187517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220" name="Right Arrow 219"/>
            <p:cNvSpPr/>
            <p:nvPr/>
          </p:nvSpPr>
          <p:spPr>
            <a:xfrm>
              <a:off x="2917930" y="1764015"/>
              <a:ext cx="520934" cy="359709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PGK</a:t>
              </a:r>
            </a:p>
          </p:txBody>
        </p:sp>
        <p:grpSp>
          <p:nvGrpSpPr>
            <p:cNvPr id="221" name="Group 220"/>
            <p:cNvGrpSpPr/>
            <p:nvPr/>
          </p:nvGrpSpPr>
          <p:grpSpPr>
            <a:xfrm>
              <a:off x="3501606" y="1808388"/>
              <a:ext cx="419783" cy="247430"/>
              <a:chOff x="4777643" y="251557"/>
              <a:chExt cx="419783" cy="247430"/>
            </a:xfrm>
          </p:grpSpPr>
          <p:sp>
            <p:nvSpPr>
              <p:cNvPr id="232" name="Oval 231"/>
              <p:cNvSpPr/>
              <p:nvPr/>
            </p:nvSpPr>
            <p:spPr>
              <a:xfrm>
                <a:off x="4777643" y="251557"/>
                <a:ext cx="419783" cy="24743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/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4777643" y="255738"/>
                <a:ext cx="4197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800" dirty="0" smtClean="0"/>
                  <a:t>Neo</a:t>
                </a:r>
                <a:r>
                  <a:rPr lang="hu-HU" sz="800" baseline="30000" dirty="0" smtClean="0"/>
                  <a:t>R</a:t>
                </a:r>
                <a:endParaRPr lang="hu-HU" sz="800" baseline="30000" dirty="0"/>
              </a:p>
            </p:txBody>
          </p:sp>
        </p:grpSp>
        <p:sp>
          <p:nvSpPr>
            <p:cNvPr id="222" name="Diamond 221"/>
            <p:cNvSpPr/>
            <p:nvPr/>
          </p:nvSpPr>
          <p:spPr>
            <a:xfrm>
              <a:off x="3967668" y="1876613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grpSp>
          <p:nvGrpSpPr>
            <p:cNvPr id="223" name="Group 222"/>
            <p:cNvGrpSpPr/>
            <p:nvPr/>
          </p:nvGrpSpPr>
          <p:grpSpPr>
            <a:xfrm>
              <a:off x="884918" y="2092043"/>
              <a:ext cx="304892" cy="215444"/>
              <a:chOff x="158135" y="699532"/>
              <a:chExt cx="304892" cy="215444"/>
            </a:xfrm>
          </p:grpSpPr>
          <p:sp>
            <p:nvSpPr>
              <p:cNvPr id="230" name="TextBox 229"/>
              <p:cNvSpPr txBox="1"/>
              <p:nvPr/>
            </p:nvSpPr>
            <p:spPr>
              <a:xfrm>
                <a:off x="225143" y="741557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231" name="Rectangle 230"/>
              <p:cNvSpPr/>
              <p:nvPr/>
            </p:nvSpPr>
            <p:spPr>
              <a:xfrm>
                <a:off x="158135" y="699532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  <p:grpSp>
          <p:nvGrpSpPr>
            <p:cNvPr id="224" name="Group 223"/>
            <p:cNvGrpSpPr/>
            <p:nvPr/>
          </p:nvGrpSpPr>
          <p:grpSpPr>
            <a:xfrm>
              <a:off x="2001579" y="2127259"/>
              <a:ext cx="304892" cy="215444"/>
              <a:chOff x="-92034" y="425385"/>
              <a:chExt cx="304892" cy="215444"/>
            </a:xfrm>
          </p:grpSpPr>
          <p:sp>
            <p:nvSpPr>
              <p:cNvPr id="228" name="TextBox 227"/>
              <p:cNvSpPr txBox="1"/>
              <p:nvPr/>
            </p:nvSpPr>
            <p:spPr>
              <a:xfrm>
                <a:off x="-23615" y="467410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229" name="Rectangle 228"/>
              <p:cNvSpPr/>
              <p:nvPr/>
            </p:nvSpPr>
            <p:spPr>
              <a:xfrm>
                <a:off x="-92034" y="425385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</p:grpSp>
      <p:sp>
        <p:nvSpPr>
          <p:cNvPr id="234" name="Regular Pentagon 233"/>
          <p:cNvSpPr/>
          <p:nvPr/>
        </p:nvSpPr>
        <p:spPr>
          <a:xfrm>
            <a:off x="1316391" y="1865856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235" name="Regular Pentagon 234"/>
          <p:cNvSpPr/>
          <p:nvPr/>
        </p:nvSpPr>
        <p:spPr>
          <a:xfrm>
            <a:off x="2040852" y="1896037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236" name="Right Arrow 235"/>
          <p:cNvSpPr/>
          <p:nvPr/>
        </p:nvSpPr>
        <p:spPr>
          <a:xfrm>
            <a:off x="1490279" y="1854765"/>
            <a:ext cx="164178" cy="141195"/>
          </a:xfrm>
          <a:prstGeom prst="rightArrow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 sz="800" dirty="0" smtClean="0">
              <a:solidFill>
                <a:schemeClr val="tx1"/>
              </a:solidFill>
            </a:endParaRPr>
          </a:p>
        </p:txBody>
      </p:sp>
      <p:grpSp>
        <p:nvGrpSpPr>
          <p:cNvPr id="237" name="Group 236"/>
          <p:cNvGrpSpPr/>
          <p:nvPr/>
        </p:nvGrpSpPr>
        <p:grpSpPr>
          <a:xfrm>
            <a:off x="1669727" y="1816965"/>
            <a:ext cx="404976" cy="215444"/>
            <a:chOff x="4718910" y="218700"/>
            <a:chExt cx="600901" cy="298468"/>
          </a:xfrm>
        </p:grpSpPr>
        <p:sp>
          <p:nvSpPr>
            <p:cNvPr id="238" name="Oval 237"/>
            <p:cNvSpPr/>
            <p:nvPr/>
          </p:nvSpPr>
          <p:spPr>
            <a:xfrm>
              <a:off x="4777643" y="251557"/>
              <a:ext cx="419783" cy="247430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/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4718910" y="218700"/>
              <a:ext cx="600901" cy="2984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800" dirty="0" smtClean="0"/>
                <a:t>Kan</a:t>
              </a:r>
              <a:r>
                <a:rPr lang="hu-HU" sz="800" baseline="30000" dirty="0" smtClean="0"/>
                <a:t>R</a:t>
              </a:r>
              <a:endParaRPr lang="hu-HU" sz="800" baseline="30000" dirty="0"/>
            </a:p>
          </p:txBody>
        </p:sp>
      </p:grpSp>
      <p:grpSp>
        <p:nvGrpSpPr>
          <p:cNvPr id="250" name="Group 249"/>
          <p:cNvGrpSpPr/>
          <p:nvPr/>
        </p:nvGrpSpPr>
        <p:grpSpPr>
          <a:xfrm>
            <a:off x="1292229" y="2334995"/>
            <a:ext cx="4529753" cy="628057"/>
            <a:chOff x="1136239" y="1757665"/>
            <a:chExt cx="4517198" cy="628057"/>
          </a:xfrm>
        </p:grpSpPr>
        <p:sp>
          <p:nvSpPr>
            <p:cNvPr id="251" name="Oval 250"/>
            <p:cNvSpPr/>
            <p:nvPr/>
          </p:nvSpPr>
          <p:spPr>
            <a:xfrm>
              <a:off x="1136239" y="1920836"/>
              <a:ext cx="4517198" cy="3429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dirty="0" smtClean="0"/>
                <a:t>~</a:t>
              </a:r>
              <a:endParaRPr lang="hu-HU" sz="1100" dirty="0" smtClean="0">
                <a:solidFill>
                  <a:schemeClr val="tx1"/>
                </a:solidFill>
              </a:endParaRPr>
            </a:p>
          </p:txBody>
        </p:sp>
        <p:sp>
          <p:nvSpPr>
            <p:cNvPr id="252" name="Rounded Rectangle 251"/>
            <p:cNvSpPr/>
            <p:nvPr/>
          </p:nvSpPr>
          <p:spPr>
            <a:xfrm>
              <a:off x="2310896" y="1822400"/>
              <a:ext cx="413766" cy="247430"/>
            </a:xfrm>
            <a:prstGeom prst="round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GOI</a:t>
              </a:r>
            </a:p>
          </p:txBody>
        </p:sp>
        <p:sp>
          <p:nvSpPr>
            <p:cNvPr id="253" name="Right Arrow 252"/>
            <p:cNvSpPr/>
            <p:nvPr/>
          </p:nvSpPr>
          <p:spPr>
            <a:xfrm>
              <a:off x="1653100" y="1757665"/>
              <a:ext cx="607568" cy="359709"/>
            </a:xfrm>
            <a:prstGeom prst="rightArrow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CAG</a:t>
              </a:r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54" name="Diamond 253"/>
            <p:cNvSpPr/>
            <p:nvPr/>
          </p:nvSpPr>
          <p:spPr>
            <a:xfrm>
              <a:off x="2767968" y="1875175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sp>
          <p:nvSpPr>
            <p:cNvPr id="255" name="Right Arrow 254"/>
            <p:cNvSpPr/>
            <p:nvPr/>
          </p:nvSpPr>
          <p:spPr>
            <a:xfrm>
              <a:off x="2917930" y="1764015"/>
              <a:ext cx="520934" cy="359709"/>
            </a:xfrm>
            <a:prstGeom prst="rightArrow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hu-HU" sz="800" dirty="0" smtClean="0">
                  <a:solidFill>
                    <a:schemeClr val="tx1"/>
                  </a:solidFill>
                </a:rPr>
                <a:t>PGK</a:t>
              </a:r>
            </a:p>
          </p:txBody>
        </p:sp>
        <p:grpSp>
          <p:nvGrpSpPr>
            <p:cNvPr id="256" name="Group 255"/>
            <p:cNvGrpSpPr/>
            <p:nvPr/>
          </p:nvGrpSpPr>
          <p:grpSpPr>
            <a:xfrm>
              <a:off x="3501606" y="1808388"/>
              <a:ext cx="419783" cy="247430"/>
              <a:chOff x="4777643" y="251557"/>
              <a:chExt cx="419783" cy="247430"/>
            </a:xfrm>
          </p:grpSpPr>
          <p:sp>
            <p:nvSpPr>
              <p:cNvPr id="267" name="Oval 266"/>
              <p:cNvSpPr/>
              <p:nvPr/>
            </p:nvSpPr>
            <p:spPr>
              <a:xfrm>
                <a:off x="4777643" y="251557"/>
                <a:ext cx="419783" cy="247430"/>
              </a:xfrm>
              <a:prstGeom prst="ellipse">
                <a:avLst/>
              </a:prstGeom>
              <a:solidFill>
                <a:schemeClr val="bg2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hu-HU" sz="800" dirty="0"/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4777643" y="255738"/>
                <a:ext cx="4197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hu-HU" sz="800" dirty="0" smtClean="0"/>
                  <a:t>Neo</a:t>
                </a:r>
                <a:r>
                  <a:rPr lang="hu-HU" sz="800" baseline="30000" dirty="0" smtClean="0"/>
                  <a:t>R</a:t>
                </a:r>
                <a:endParaRPr lang="hu-HU" sz="800" baseline="30000" dirty="0"/>
              </a:p>
            </p:txBody>
          </p:sp>
        </p:grpSp>
        <p:sp>
          <p:nvSpPr>
            <p:cNvPr id="257" name="Diamond 256"/>
            <p:cNvSpPr/>
            <p:nvPr/>
          </p:nvSpPr>
          <p:spPr>
            <a:xfrm>
              <a:off x="3967668" y="1876613"/>
              <a:ext cx="88900" cy="123715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/>
            </a:p>
          </p:txBody>
        </p:sp>
        <p:grpSp>
          <p:nvGrpSpPr>
            <p:cNvPr id="259" name="Group 258"/>
            <p:cNvGrpSpPr/>
            <p:nvPr/>
          </p:nvGrpSpPr>
          <p:grpSpPr>
            <a:xfrm>
              <a:off x="3315434" y="2170278"/>
              <a:ext cx="304892" cy="215444"/>
              <a:chOff x="1221821" y="468404"/>
              <a:chExt cx="304892" cy="215444"/>
            </a:xfrm>
          </p:grpSpPr>
          <p:sp>
            <p:nvSpPr>
              <p:cNvPr id="263" name="TextBox 262"/>
              <p:cNvSpPr txBox="1"/>
              <p:nvPr/>
            </p:nvSpPr>
            <p:spPr>
              <a:xfrm>
                <a:off x="1288716" y="517724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264" name="Rectangle 263"/>
              <p:cNvSpPr/>
              <p:nvPr/>
            </p:nvSpPr>
            <p:spPr>
              <a:xfrm>
                <a:off x="1221821" y="468404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  <p:grpSp>
          <p:nvGrpSpPr>
            <p:cNvPr id="260" name="Group 259"/>
            <p:cNvGrpSpPr/>
            <p:nvPr/>
          </p:nvGrpSpPr>
          <p:grpSpPr>
            <a:xfrm>
              <a:off x="4795738" y="1859573"/>
              <a:ext cx="304892" cy="215444"/>
              <a:chOff x="332579" y="441981"/>
              <a:chExt cx="304892" cy="215444"/>
            </a:xfrm>
          </p:grpSpPr>
          <p:sp>
            <p:nvSpPr>
              <p:cNvPr id="261" name="TextBox 260"/>
              <p:cNvSpPr txBox="1"/>
              <p:nvPr/>
            </p:nvSpPr>
            <p:spPr>
              <a:xfrm>
                <a:off x="397271" y="484769"/>
                <a:ext cx="175509" cy="131394"/>
              </a:xfrm>
              <a:prstGeom prst="rect">
                <a:avLst/>
              </a:prstGeom>
              <a:solidFill>
                <a:srgbClr val="92D050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endParaRPr lang="hu-HU" sz="600" dirty="0"/>
              </a:p>
            </p:txBody>
          </p:sp>
          <p:sp>
            <p:nvSpPr>
              <p:cNvPr id="262" name="Rectangle 261"/>
              <p:cNvSpPr/>
              <p:nvPr/>
            </p:nvSpPr>
            <p:spPr>
              <a:xfrm>
                <a:off x="332579" y="441981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hu-HU" sz="800" dirty="0"/>
                  <a:t>HR</a:t>
                </a:r>
              </a:p>
            </p:txBody>
          </p:sp>
        </p:grpSp>
      </p:grpSp>
      <p:sp>
        <p:nvSpPr>
          <p:cNvPr id="270" name="Regular Pentagon 269"/>
          <p:cNvSpPr/>
          <p:nvPr/>
        </p:nvSpPr>
        <p:spPr>
          <a:xfrm>
            <a:off x="2427097" y="2760431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271" name="Rectangle 270"/>
          <p:cNvSpPr/>
          <p:nvPr/>
        </p:nvSpPr>
        <p:spPr>
          <a:xfrm>
            <a:off x="3018805" y="2067351"/>
            <a:ext cx="28264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000" dirty="0" smtClean="0">
                <a:ea typeface="Times New Roman" panose="02020603050405020304" pitchFamily="18" charset="0"/>
              </a:rPr>
              <a:t>FLP mediated excision of the </a:t>
            </a:r>
            <a:r>
              <a:rPr lang="hu-HU" altLang="hu-HU" sz="1000" dirty="0">
                <a:ea typeface="Times New Roman" panose="02020603050405020304" pitchFamily="18" charset="0"/>
              </a:rPr>
              <a:t>5’ targeting construct</a:t>
            </a:r>
            <a:endParaRPr lang="hu-HU" sz="1000" dirty="0"/>
          </a:p>
        </p:txBody>
      </p:sp>
      <p:grpSp>
        <p:nvGrpSpPr>
          <p:cNvPr id="275" name="Group 274"/>
          <p:cNvGrpSpPr/>
          <p:nvPr/>
        </p:nvGrpSpPr>
        <p:grpSpPr>
          <a:xfrm>
            <a:off x="1071179" y="2074950"/>
            <a:ext cx="750383" cy="359971"/>
            <a:chOff x="1443285" y="2205361"/>
            <a:chExt cx="750383" cy="359971"/>
          </a:xfrm>
        </p:grpSpPr>
        <p:sp>
          <p:nvSpPr>
            <p:cNvPr id="272" name="TextBox 271"/>
            <p:cNvSpPr txBox="1"/>
            <p:nvPr/>
          </p:nvSpPr>
          <p:spPr>
            <a:xfrm>
              <a:off x="1443285" y="2205361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600" dirty="0"/>
                <a:t>+</a:t>
              </a:r>
            </a:p>
          </p:txBody>
        </p:sp>
        <p:sp>
          <p:nvSpPr>
            <p:cNvPr id="273" name="Oval 272"/>
            <p:cNvSpPr/>
            <p:nvPr/>
          </p:nvSpPr>
          <p:spPr>
            <a:xfrm>
              <a:off x="1668679" y="2225406"/>
              <a:ext cx="385007" cy="339926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684000"/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74" name="Rectangle 273"/>
            <p:cNvSpPr/>
            <p:nvPr/>
          </p:nvSpPr>
          <p:spPr>
            <a:xfrm>
              <a:off x="1558585" y="2235190"/>
              <a:ext cx="63508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hu-HU" altLang="hu-HU" sz="7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FLP plasmid</a:t>
              </a:r>
              <a:endParaRPr lang="hu-HU" sz="700" dirty="0"/>
            </a:p>
          </p:txBody>
        </p:sp>
      </p:grpSp>
      <p:cxnSp>
        <p:nvCxnSpPr>
          <p:cNvPr id="276" name="Straight Arrow Connector 275"/>
          <p:cNvCxnSpPr/>
          <p:nvPr/>
        </p:nvCxnSpPr>
        <p:spPr>
          <a:xfrm>
            <a:off x="2959168" y="2928322"/>
            <a:ext cx="0" cy="2681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0" name="Group 279"/>
          <p:cNvGrpSpPr/>
          <p:nvPr/>
        </p:nvGrpSpPr>
        <p:grpSpPr>
          <a:xfrm>
            <a:off x="1400608" y="2820800"/>
            <a:ext cx="756148" cy="415185"/>
            <a:chOff x="1379591" y="2857283"/>
            <a:chExt cx="756148" cy="415185"/>
          </a:xfrm>
        </p:grpSpPr>
        <p:sp>
          <p:nvSpPr>
            <p:cNvPr id="277" name="TextBox 276"/>
            <p:cNvSpPr txBox="1"/>
            <p:nvPr/>
          </p:nvSpPr>
          <p:spPr>
            <a:xfrm>
              <a:off x="1379591" y="2912497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600" dirty="0"/>
                <a:t>+</a:t>
              </a:r>
            </a:p>
          </p:txBody>
        </p:sp>
        <p:sp>
          <p:nvSpPr>
            <p:cNvPr id="278" name="Oval 277"/>
            <p:cNvSpPr/>
            <p:nvPr/>
          </p:nvSpPr>
          <p:spPr>
            <a:xfrm>
              <a:off x="1604985" y="2857283"/>
              <a:ext cx="421567" cy="41518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1500656" y="2914726"/>
              <a:ext cx="63508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hu-HU" altLang="hu-HU" sz="7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pRed/ET plasmid</a:t>
              </a:r>
              <a:endParaRPr lang="hu-HU" sz="700" dirty="0"/>
            </a:p>
          </p:txBody>
        </p:sp>
      </p:grpSp>
      <p:sp>
        <p:nvSpPr>
          <p:cNvPr id="281" name="Rectangle 280"/>
          <p:cNvSpPr/>
          <p:nvPr/>
        </p:nvSpPr>
        <p:spPr>
          <a:xfrm>
            <a:off x="3049840" y="3857134"/>
            <a:ext cx="282641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hu-HU" altLang="hu-HU" sz="1000" dirty="0" smtClean="0">
                <a:ea typeface="Times New Roman" panose="02020603050405020304" pitchFamily="18" charset="0"/>
              </a:rPr>
              <a:t>FLP mediated excision of the 3’ </a:t>
            </a:r>
            <a:r>
              <a:rPr lang="hu-HU" altLang="hu-HU" sz="1000" dirty="0">
                <a:ea typeface="Times New Roman" panose="02020603050405020304" pitchFamily="18" charset="0"/>
              </a:rPr>
              <a:t>targeting construct</a:t>
            </a:r>
            <a:endParaRPr lang="hu-HU" sz="1000" dirty="0"/>
          </a:p>
        </p:txBody>
      </p:sp>
      <p:sp>
        <p:nvSpPr>
          <p:cNvPr id="282" name="Regular Pentagon 281"/>
          <p:cNvSpPr/>
          <p:nvPr/>
        </p:nvSpPr>
        <p:spPr>
          <a:xfrm>
            <a:off x="3155893" y="4544266"/>
            <a:ext cx="120650" cy="99546"/>
          </a:xfrm>
          <a:prstGeom prst="pen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sz="600" dirty="0" smtClean="0"/>
              <a:t>3</a:t>
            </a:r>
            <a:endParaRPr lang="hu-HU" sz="600" dirty="0"/>
          </a:p>
        </p:txBody>
      </p:sp>
      <p:grpSp>
        <p:nvGrpSpPr>
          <p:cNvPr id="283" name="Group 282"/>
          <p:cNvGrpSpPr/>
          <p:nvPr/>
        </p:nvGrpSpPr>
        <p:grpSpPr>
          <a:xfrm>
            <a:off x="1094469" y="3758324"/>
            <a:ext cx="750383" cy="359971"/>
            <a:chOff x="1443285" y="2205361"/>
            <a:chExt cx="750383" cy="359971"/>
          </a:xfrm>
        </p:grpSpPr>
        <p:sp>
          <p:nvSpPr>
            <p:cNvPr id="284" name="TextBox 283"/>
            <p:cNvSpPr txBox="1"/>
            <p:nvPr/>
          </p:nvSpPr>
          <p:spPr>
            <a:xfrm>
              <a:off x="1443285" y="2205361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hu-HU" sz="1600" dirty="0"/>
                <a:t>+</a:t>
              </a:r>
            </a:p>
          </p:txBody>
        </p:sp>
        <p:sp>
          <p:nvSpPr>
            <p:cNvPr id="285" name="Oval 284"/>
            <p:cNvSpPr/>
            <p:nvPr/>
          </p:nvSpPr>
          <p:spPr>
            <a:xfrm>
              <a:off x="1668679" y="2225406"/>
              <a:ext cx="385007" cy="339926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defTabSz="684000"/>
              <a:endParaRPr lang="hu-HU" sz="800" dirty="0">
                <a:solidFill>
                  <a:schemeClr val="tx1"/>
                </a:solidFill>
              </a:endParaRPr>
            </a:p>
          </p:txBody>
        </p:sp>
        <p:sp>
          <p:nvSpPr>
            <p:cNvPr id="286" name="Rectangle 285"/>
            <p:cNvSpPr/>
            <p:nvPr/>
          </p:nvSpPr>
          <p:spPr>
            <a:xfrm>
              <a:off x="1558585" y="2235190"/>
              <a:ext cx="63508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hu-HU" altLang="hu-HU" sz="700" dirty="0" smtClean="0">
                  <a:latin typeface="Arial" panose="020B0604020202020204" pitchFamily="34" charset="0"/>
                  <a:ea typeface="Times New Roman" panose="02020603050405020304" pitchFamily="18" charset="0"/>
                </a:rPr>
                <a:t>FLP plasmid</a:t>
              </a:r>
              <a:endParaRPr lang="hu-HU" sz="700" dirty="0"/>
            </a:p>
          </p:txBody>
        </p:sp>
      </p:grpSp>
      <p:sp>
        <p:nvSpPr>
          <p:cNvPr id="287" name="TextBox 286"/>
          <p:cNvSpPr txBox="1"/>
          <p:nvPr/>
        </p:nvSpPr>
        <p:spPr>
          <a:xfrm>
            <a:off x="49066" y="24101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/>
              <a:t>A</a:t>
            </a:r>
            <a:endParaRPr lang="hu-HU" dirty="0"/>
          </a:p>
        </p:txBody>
      </p:sp>
      <p:sp>
        <p:nvSpPr>
          <p:cNvPr id="290" name="TextBox 289"/>
          <p:cNvSpPr txBox="1"/>
          <p:nvPr/>
        </p:nvSpPr>
        <p:spPr>
          <a:xfrm>
            <a:off x="53074" y="499734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B</a:t>
            </a:r>
          </a:p>
        </p:txBody>
      </p:sp>
      <p:sp>
        <p:nvSpPr>
          <p:cNvPr id="291" name="TextBox 290"/>
          <p:cNvSpPr txBox="1"/>
          <p:nvPr/>
        </p:nvSpPr>
        <p:spPr>
          <a:xfrm>
            <a:off x="3152669" y="499191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/>
              <a:t>C</a:t>
            </a:r>
            <a:endParaRPr lang="hu-HU" dirty="0"/>
          </a:p>
        </p:txBody>
      </p:sp>
      <p:pic>
        <p:nvPicPr>
          <p:cNvPr id="173" name="Picture 17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481" y="5017283"/>
            <a:ext cx="1645920" cy="1645920"/>
          </a:xfrm>
          <a:prstGeom prst="rect">
            <a:avLst/>
          </a:prstGeom>
        </p:spPr>
      </p:pic>
      <p:sp>
        <p:nvSpPr>
          <p:cNvPr id="177" name="TextBox 176"/>
          <p:cNvSpPr txBox="1"/>
          <p:nvPr/>
        </p:nvSpPr>
        <p:spPr>
          <a:xfrm>
            <a:off x="4375453" y="5017283"/>
            <a:ext cx="6709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0.0% GFP positive</a:t>
            </a:r>
            <a:endParaRPr lang="hu-HU" sz="1200" dirty="0"/>
          </a:p>
        </p:txBody>
      </p:sp>
      <p:grpSp>
        <p:nvGrpSpPr>
          <p:cNvPr id="178" name="Group 177"/>
          <p:cNvGrpSpPr/>
          <p:nvPr/>
        </p:nvGrpSpPr>
        <p:grpSpPr>
          <a:xfrm>
            <a:off x="5067289" y="6887847"/>
            <a:ext cx="1774606" cy="1645920"/>
            <a:chOff x="1971675" y="0"/>
            <a:chExt cx="1774606" cy="1645920"/>
          </a:xfrm>
        </p:grpSpPr>
        <p:pic>
          <p:nvPicPr>
            <p:cNvPr id="179" name="Picture 17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71675" y="0"/>
              <a:ext cx="1645920" cy="1645920"/>
            </a:xfrm>
            <a:prstGeom prst="rect">
              <a:avLst/>
            </a:prstGeom>
          </p:spPr>
        </p:pic>
        <p:sp>
          <p:nvSpPr>
            <p:cNvPr id="180" name="TextBox 179"/>
            <p:cNvSpPr txBox="1"/>
            <p:nvPr/>
          </p:nvSpPr>
          <p:spPr>
            <a:xfrm>
              <a:off x="2956240" y="20587"/>
              <a:ext cx="79004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200" dirty="0" smtClean="0"/>
                <a:t>99.3% GFP positive</a:t>
              </a:r>
              <a:endParaRPr lang="hu-HU" sz="1200" dirty="0"/>
            </a:p>
          </p:txBody>
        </p:sp>
      </p:grpSp>
      <p:grpSp>
        <p:nvGrpSpPr>
          <p:cNvPr id="181" name="Group 180"/>
          <p:cNvGrpSpPr/>
          <p:nvPr/>
        </p:nvGrpSpPr>
        <p:grpSpPr>
          <a:xfrm>
            <a:off x="3408967" y="6874329"/>
            <a:ext cx="1645920" cy="1645920"/>
            <a:chOff x="3590807" y="5082"/>
            <a:chExt cx="1645920" cy="1645920"/>
          </a:xfrm>
        </p:grpSpPr>
        <p:pic>
          <p:nvPicPr>
            <p:cNvPr id="182" name="Picture 18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90807" y="5082"/>
              <a:ext cx="1645920" cy="1645920"/>
            </a:xfrm>
            <a:prstGeom prst="rect">
              <a:avLst/>
            </a:prstGeom>
          </p:spPr>
        </p:pic>
        <p:sp>
          <p:nvSpPr>
            <p:cNvPr id="183" name="TextBox 182"/>
            <p:cNvSpPr txBox="1"/>
            <p:nvPr/>
          </p:nvSpPr>
          <p:spPr>
            <a:xfrm>
              <a:off x="4500425" y="42811"/>
              <a:ext cx="6709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200" dirty="0" smtClean="0"/>
                <a:t>88.3% GFP positive</a:t>
              </a:r>
              <a:endParaRPr lang="hu-HU" sz="1200" dirty="0"/>
            </a:p>
          </p:txBody>
        </p:sp>
      </p:grpSp>
      <p:grpSp>
        <p:nvGrpSpPr>
          <p:cNvPr id="184" name="Group 183"/>
          <p:cNvGrpSpPr/>
          <p:nvPr/>
        </p:nvGrpSpPr>
        <p:grpSpPr>
          <a:xfrm>
            <a:off x="5071762" y="5015994"/>
            <a:ext cx="1645920" cy="1645920"/>
            <a:chOff x="5188876" y="32816"/>
            <a:chExt cx="1645920" cy="1645920"/>
          </a:xfrm>
        </p:grpSpPr>
        <p:pic>
          <p:nvPicPr>
            <p:cNvPr id="185" name="Picture 18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88876" y="32816"/>
              <a:ext cx="1645920" cy="1645920"/>
            </a:xfrm>
            <a:prstGeom prst="rect">
              <a:avLst/>
            </a:prstGeom>
          </p:spPr>
        </p:pic>
        <p:sp>
          <p:nvSpPr>
            <p:cNvPr id="186" name="TextBox 185"/>
            <p:cNvSpPr txBox="1"/>
            <p:nvPr/>
          </p:nvSpPr>
          <p:spPr>
            <a:xfrm>
              <a:off x="6071706" y="70994"/>
              <a:ext cx="6709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200" dirty="0" smtClean="0"/>
                <a:t>42.7% GFP positive</a:t>
              </a:r>
              <a:endParaRPr lang="hu-HU" sz="1200" dirty="0"/>
            </a:p>
          </p:txBody>
        </p:sp>
      </p:grpSp>
      <p:sp>
        <p:nvSpPr>
          <p:cNvPr id="187" name="TextBox 186"/>
          <p:cNvSpPr txBox="1"/>
          <p:nvPr/>
        </p:nvSpPr>
        <p:spPr>
          <a:xfrm>
            <a:off x="4029441" y="4815746"/>
            <a:ext cx="67096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CHO wt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5619110" y="4828239"/>
            <a:ext cx="67096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plasmid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3955098" y="6720629"/>
            <a:ext cx="87313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210kb BAC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5573740" y="6711169"/>
            <a:ext cx="87313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hu-HU" sz="1200" dirty="0" smtClean="0"/>
              <a:t>70kb BAC</a:t>
            </a:r>
          </a:p>
        </p:txBody>
      </p:sp>
      <p:graphicFrame>
        <p:nvGraphicFramePr>
          <p:cNvPr id="191" name="Chart 190"/>
          <p:cNvGraphicFramePr>
            <a:graphicFrameLocks noChangeAspect="1"/>
          </p:cNvGraphicFramePr>
          <p:nvPr>
            <p:extLst/>
          </p:nvPr>
        </p:nvGraphicFramePr>
        <p:xfrm>
          <a:off x="-22225" y="5066966"/>
          <a:ext cx="3238443" cy="21996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405744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61</TotalTime>
  <Words>719</Words>
  <Application>Microsoft Office PowerPoint</Application>
  <PresentationFormat>A4 Paper (210x297 mm)</PresentationFormat>
  <Paragraphs>13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boray Katalin</dc:creator>
  <cp:lastModifiedBy>Lukács Péter</cp:lastModifiedBy>
  <cp:revision>61</cp:revision>
  <cp:lastPrinted>2021-10-14T11:47:21Z</cp:lastPrinted>
  <dcterms:created xsi:type="dcterms:W3CDTF">2021-10-05T11:47:49Z</dcterms:created>
  <dcterms:modified xsi:type="dcterms:W3CDTF">2023-11-30T16:42:28Z</dcterms:modified>
</cp:coreProperties>
</file>